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9906000" cy="6858000" type="A4"/>
  <p:notesSz cx="6858000" cy="9144000"/>
  <p:defaultTextStyle>
    <a:defPPr>
      <a:defRPr lang="ja-JP"/>
    </a:defPPr>
    <a:lvl1pPr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12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39966"/>
    <a:srgbClr val="00CC99"/>
    <a:srgbClr val="43682B"/>
    <a:srgbClr val="00CC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627" autoAdjust="0"/>
    <p:restoredTop sz="74734" autoAdjust="0"/>
  </p:normalViewPr>
  <p:slideViewPr>
    <p:cSldViewPr>
      <p:cViewPr varScale="1">
        <p:scale>
          <a:sx n="84" d="100"/>
          <a:sy n="84" d="100"/>
        </p:scale>
        <p:origin x="2538" y="114"/>
      </p:cViewPr>
      <p:guideLst>
        <p:guide orient="horz" pos="2160"/>
        <p:guide pos="312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>
            <a:extLst>
              <a:ext uri="{FF2B5EF4-FFF2-40B4-BE49-F238E27FC236}">
                <a16:creationId xmlns:a16="http://schemas.microsoft.com/office/drawing/2014/main" id="{51EDD8A6-2D61-DA7B-480E-360B4A7E0116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 2">
            <a:extLst>
              <a:ext uri="{FF2B5EF4-FFF2-40B4-BE49-F238E27FC236}">
                <a16:creationId xmlns:a16="http://schemas.microsoft.com/office/drawing/2014/main" id="{1578BD57-2502-DC6E-604B-2747116F7733}"/>
              </a:ext>
            </a:extLst>
          </p:cNvPr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fld id="{18A09575-56D9-43DA-94B9-9C8B494CCE79}" type="datetimeFigureOut">
              <a:rPr lang="ja-JP" altLang="en-US"/>
              <a:pPr>
                <a:defRPr/>
              </a:pPr>
              <a:t>2024/4/17</a:t>
            </a:fld>
            <a:endParaRPr lang="ja-JP" altLang="en-US"/>
          </a:p>
        </p:txBody>
      </p:sp>
      <p:sp>
        <p:nvSpPr>
          <p:cNvPr id="4" name="スライド イメージ プレースホルダ 3">
            <a:extLst>
              <a:ext uri="{FF2B5EF4-FFF2-40B4-BE49-F238E27FC236}">
                <a16:creationId xmlns:a16="http://schemas.microsoft.com/office/drawing/2014/main" id="{3DB356AF-3573-60A8-FE74-605ACBB87C70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952500" y="685800"/>
            <a:ext cx="4953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ja-JP" altLang="en-US" noProof="0"/>
          </a:p>
        </p:txBody>
      </p:sp>
      <p:sp>
        <p:nvSpPr>
          <p:cNvPr id="5" name="ノート プレースホルダ 4">
            <a:extLst>
              <a:ext uri="{FF2B5EF4-FFF2-40B4-BE49-F238E27FC236}">
                <a16:creationId xmlns:a16="http://schemas.microsoft.com/office/drawing/2014/main" id="{8E640535-4CA1-3333-AD5C-A2D85A09CC9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noProof="0"/>
              <a:t>マスタ テキストの書式設定</a:t>
            </a:r>
          </a:p>
          <a:p>
            <a:pPr lvl="1"/>
            <a:r>
              <a:rPr lang="ja-JP" altLang="en-US" noProof="0"/>
              <a:t>第 </a:t>
            </a:r>
            <a:r>
              <a:rPr lang="en-US" altLang="ja-JP" noProof="0"/>
              <a:t>2 </a:t>
            </a:r>
            <a:r>
              <a:rPr lang="ja-JP" altLang="en-US" noProof="0"/>
              <a:t>レベル</a:t>
            </a:r>
          </a:p>
          <a:p>
            <a:pPr lvl="2"/>
            <a:r>
              <a:rPr lang="ja-JP" altLang="en-US" noProof="0"/>
              <a:t>第 </a:t>
            </a:r>
            <a:r>
              <a:rPr lang="en-US" altLang="ja-JP" noProof="0"/>
              <a:t>3 </a:t>
            </a:r>
            <a:r>
              <a:rPr lang="ja-JP" altLang="en-US" noProof="0"/>
              <a:t>レベル</a:t>
            </a:r>
          </a:p>
          <a:p>
            <a:pPr lvl="3"/>
            <a:r>
              <a:rPr lang="ja-JP" altLang="en-US" noProof="0"/>
              <a:t>第 </a:t>
            </a:r>
            <a:r>
              <a:rPr lang="en-US" altLang="ja-JP" noProof="0"/>
              <a:t>4 </a:t>
            </a:r>
            <a:r>
              <a:rPr lang="ja-JP" altLang="en-US" noProof="0"/>
              <a:t>レベル</a:t>
            </a:r>
          </a:p>
          <a:p>
            <a:pPr lvl="4"/>
            <a:r>
              <a:rPr lang="ja-JP" altLang="en-US" noProof="0"/>
              <a:t>第 </a:t>
            </a:r>
            <a:r>
              <a:rPr lang="en-US" altLang="ja-JP" noProof="0"/>
              <a:t>5 </a:t>
            </a:r>
            <a:r>
              <a:rPr lang="ja-JP" altLang="en-US" noProof="0"/>
              <a:t>レベル</a:t>
            </a:r>
          </a:p>
        </p:txBody>
      </p:sp>
      <p:sp>
        <p:nvSpPr>
          <p:cNvPr id="6" name="フッター プレースホルダ 5">
            <a:extLst>
              <a:ext uri="{FF2B5EF4-FFF2-40B4-BE49-F238E27FC236}">
                <a16:creationId xmlns:a16="http://schemas.microsoft.com/office/drawing/2014/main" id="{C7A99031-D187-BBE6-7B2C-2B4A8F30507C}"/>
              </a:ext>
            </a:extLst>
          </p:cNvPr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6">
            <a:extLst>
              <a:ext uri="{FF2B5EF4-FFF2-40B4-BE49-F238E27FC236}">
                <a16:creationId xmlns:a16="http://schemas.microsoft.com/office/drawing/2014/main" id="{AA58E585-5601-2F3F-F51E-37A713E4C90D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Calibri" panose="020F0502020204030204" pitchFamily="34" charset="0"/>
              </a:defRPr>
            </a:lvl1pPr>
          </a:lstStyle>
          <a:p>
            <a:pPr>
              <a:defRPr/>
            </a:pPr>
            <a:fld id="{F47032DB-CCB4-470D-A171-3CE61F305026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>
            <a:normAutofit fontScale="40000" lnSpcReduction="20000"/>
          </a:bodyPr>
          <a:lstStyle/>
          <a:p>
            <a:r>
              <a:rPr kumimoji="1" lang="en-US" altLang="ja-JP" dirty="0"/>
              <a:t>$ head -1 ?OJ/*x2reads.report</a:t>
            </a:r>
          </a:p>
          <a:p>
            <a:r>
              <a:rPr kumimoji="1" lang="en-US" altLang="ja-JP" dirty="0"/>
              <a:t>==&gt; BOJ/NGSC1_kraken2_27478389x2reads.report &lt;==</a:t>
            </a:r>
          </a:p>
          <a:p>
            <a:r>
              <a:rPr kumimoji="1" lang="en-US" altLang="ja-JP" dirty="0"/>
              <a:t> 52.04  28598798        28598798        U       0       unclassified</a:t>
            </a:r>
          </a:p>
          <a:p>
            <a:endParaRPr kumimoji="1" lang="en-US" altLang="ja-JP" dirty="0"/>
          </a:p>
          <a:p>
            <a:r>
              <a:rPr kumimoji="1" lang="en-US" altLang="ja-JP" dirty="0"/>
              <a:t>==&gt; BOJ/NGSC2_kraken2_27478389x2reads.report &lt;==</a:t>
            </a:r>
          </a:p>
          <a:p>
            <a:r>
              <a:rPr kumimoji="1" lang="en-US" altLang="ja-JP" dirty="0"/>
              <a:t> 53.95  29649730        29649730        U       0       unclassified</a:t>
            </a:r>
          </a:p>
          <a:p>
            <a:endParaRPr kumimoji="1" lang="en-US" altLang="ja-JP" dirty="0"/>
          </a:p>
          <a:p>
            <a:r>
              <a:rPr kumimoji="1" lang="en-US" altLang="ja-JP" dirty="0"/>
              <a:t>==&gt; BOJ/TOK91_kraken2_27478389x2reads.report &lt;==</a:t>
            </a:r>
          </a:p>
          <a:p>
            <a:r>
              <a:rPr kumimoji="1" lang="en-US" altLang="ja-JP" dirty="0"/>
              <a:t> 32.71  17977449        17977449        U       0       unclassified</a:t>
            </a:r>
          </a:p>
          <a:p>
            <a:endParaRPr kumimoji="1" lang="en-US" altLang="ja-JP" dirty="0"/>
          </a:p>
          <a:p>
            <a:r>
              <a:rPr kumimoji="1" lang="en-US" altLang="ja-JP" dirty="0"/>
              <a:t>==&gt; BOJ/TOK93_kraken2_27478389x2reads.report &lt;==</a:t>
            </a:r>
          </a:p>
          <a:p>
            <a:r>
              <a:rPr kumimoji="1" lang="en-US" altLang="ja-JP" dirty="0"/>
              <a:t> 27.54  15135947        15135947        U       0       unclassified</a:t>
            </a:r>
          </a:p>
          <a:p>
            <a:endParaRPr kumimoji="1" lang="en-US" altLang="ja-JP" dirty="0"/>
          </a:p>
          <a:p>
            <a:r>
              <a:rPr kumimoji="1" lang="en-US" altLang="ja-JP" dirty="0"/>
              <a:t>==&gt; BOJ/TOK94_kraken2_27478389x2reads.report &lt;==</a:t>
            </a:r>
          </a:p>
          <a:p>
            <a:r>
              <a:rPr kumimoji="1" lang="en-US" altLang="ja-JP" dirty="0"/>
              <a:t> 29.32  16114795        16114795        U       0       unclassified</a:t>
            </a:r>
          </a:p>
          <a:p>
            <a:endParaRPr kumimoji="1" lang="en-US" altLang="ja-JP" dirty="0"/>
          </a:p>
          <a:p>
            <a:r>
              <a:rPr kumimoji="1" lang="en-US" altLang="ja-JP" dirty="0"/>
              <a:t>==&gt; IOJ/hoku2_kraken2_27478389x2reads.report &lt;==</a:t>
            </a:r>
          </a:p>
          <a:p>
            <a:r>
              <a:rPr kumimoji="1" lang="en-US" altLang="ja-JP" dirty="0"/>
              <a:t> 37.96  20860973        20860973        U       0       unclassified</a:t>
            </a:r>
          </a:p>
          <a:p>
            <a:endParaRPr kumimoji="1" lang="en-US" altLang="ja-JP" dirty="0"/>
          </a:p>
          <a:p>
            <a:r>
              <a:rPr kumimoji="1" lang="en-US" altLang="ja-JP" dirty="0"/>
              <a:t>==&gt; IOJ/hoku3_kraken2_27478389x2reads.report &lt;==</a:t>
            </a:r>
          </a:p>
          <a:p>
            <a:r>
              <a:rPr kumimoji="1" lang="en-US" altLang="ja-JP" dirty="0"/>
              <a:t> 38.79  21316443        21316443        U       0       unclassified</a:t>
            </a:r>
          </a:p>
          <a:p>
            <a:endParaRPr kumimoji="1" lang="en-US" altLang="ja-JP" dirty="0"/>
          </a:p>
          <a:p>
            <a:r>
              <a:rPr kumimoji="1" lang="en-US" altLang="ja-JP" dirty="0"/>
              <a:t>==&gt; IOJ/hoku4_kraken2_27478389x2reads.report &lt;==</a:t>
            </a:r>
          </a:p>
          <a:p>
            <a:r>
              <a:rPr kumimoji="1" lang="en-US" altLang="ja-JP" dirty="0"/>
              <a:t> 50.47  27734695        27734695        U       0       unclassified</a:t>
            </a:r>
          </a:p>
          <a:p>
            <a:endParaRPr kumimoji="1" lang="en-US" altLang="ja-JP" dirty="0"/>
          </a:p>
          <a:p>
            <a:r>
              <a:rPr kumimoji="1" lang="en-US" altLang="ja-JP" dirty="0"/>
              <a:t>==&gt; IOJ/HYO03_kraken2_27478389x2reads.report &lt;==</a:t>
            </a:r>
          </a:p>
          <a:p>
            <a:r>
              <a:rPr kumimoji="1" lang="en-US" altLang="ja-JP" dirty="0"/>
              <a:t> 22.57  12403916        12403916        U       0       unclassified</a:t>
            </a:r>
          </a:p>
          <a:p>
            <a:endParaRPr kumimoji="1" lang="en-US" altLang="ja-JP" dirty="0"/>
          </a:p>
          <a:p>
            <a:r>
              <a:rPr kumimoji="1" lang="en-US" altLang="ja-JP" dirty="0"/>
              <a:t>==&gt; IOJ/HYOG01_kraken2_27478389x2reads.report &lt;==</a:t>
            </a:r>
          </a:p>
          <a:p>
            <a:r>
              <a:rPr kumimoji="1" lang="en-US" altLang="ja-JP" dirty="0"/>
              <a:t> 27.02  14849311        14849311        U       0       unclassified</a:t>
            </a:r>
          </a:p>
          <a:p>
            <a:endParaRPr kumimoji="1" lang="en-US" altLang="ja-JP" dirty="0"/>
          </a:p>
          <a:p>
            <a:r>
              <a:rPr kumimoji="1" lang="en-US" altLang="ja-JP" dirty="0"/>
              <a:t>==&gt; IOJ/HYOG02_kraken2_27478389x2reads.report &lt;==</a:t>
            </a:r>
          </a:p>
          <a:p>
            <a:r>
              <a:rPr kumimoji="1" lang="en-US" altLang="ja-JP" dirty="0"/>
              <a:t> 30.07  16524405        16524405        U       0       unclassified</a:t>
            </a:r>
          </a:p>
          <a:p>
            <a:endParaRPr kumimoji="1" lang="en-US" altLang="ja-JP" dirty="0"/>
          </a:p>
          <a:p>
            <a:r>
              <a:rPr kumimoji="1" lang="en-US" altLang="ja-JP" dirty="0"/>
              <a:t>==&gt; IOJ/NGSP1_kraken2_27478389x2reads.report &lt;==</a:t>
            </a:r>
          </a:p>
          <a:p>
            <a:r>
              <a:rPr kumimoji="1" lang="en-US" altLang="ja-JP" dirty="0"/>
              <a:t> 27.09  14885864        14885864        U       0       unclassified</a:t>
            </a:r>
          </a:p>
          <a:p>
            <a:endParaRPr kumimoji="1" lang="en-US" altLang="ja-JP" dirty="0"/>
          </a:p>
          <a:p>
            <a:r>
              <a:rPr kumimoji="1" lang="en-US" altLang="ja-JP" dirty="0"/>
              <a:t>==&gt; IOJ/NGSP2_kraken2_27478389x2reads.report &lt;==</a:t>
            </a:r>
          </a:p>
          <a:p>
            <a:r>
              <a:rPr kumimoji="1" lang="en-US" altLang="ja-JP" dirty="0"/>
              <a:t> 67.70  37206646        37206646        U       0       unclassified</a:t>
            </a:r>
          </a:p>
          <a:p>
            <a:endParaRPr kumimoji="1" lang="en-US" altLang="ja-JP" dirty="0"/>
          </a:p>
          <a:p>
            <a:r>
              <a:rPr kumimoji="1" lang="en-US" altLang="ja-JP" dirty="0"/>
              <a:t>==&gt; IOJ/TOKA65_kraken2_27478389x2reads.report &lt;==</a:t>
            </a:r>
          </a:p>
          <a:p>
            <a:r>
              <a:rPr kumimoji="1" lang="en-US" altLang="ja-JP" dirty="0"/>
              <a:t> 32.34  17774053        17774053        U       0       unclassified</a:t>
            </a:r>
          </a:p>
          <a:p>
            <a:endParaRPr kumimoji="1" lang="en-US" altLang="ja-JP" dirty="0"/>
          </a:p>
          <a:p>
            <a:r>
              <a:rPr kumimoji="1" lang="en-US" altLang="ja-JP" dirty="0"/>
              <a:t>==&gt; IOJ/TOKA87_kraken2_27478389x2reads.report &lt;==</a:t>
            </a:r>
          </a:p>
          <a:p>
            <a:r>
              <a:rPr kumimoji="1" lang="en-US" altLang="ja-JP" dirty="0"/>
              <a:t>  8.17  4491313 4491313 U       0       unclassified</a:t>
            </a:r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>
              <a:defRPr/>
            </a:pPr>
            <a:fld id="{F47032DB-CCB4-470D-A171-3CE61F305026}" type="slidenum">
              <a:rPr lang="ja-JP" altLang="en-US" smtClean="0"/>
              <a:pPr>
                <a:defRPr/>
              </a:pPr>
              <a:t>1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59260238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742951" y="2130432"/>
            <a:ext cx="8420100" cy="1470025"/>
          </a:xfr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485901" y="3886201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/>
              <a:t>マスタ サブタイトルの書式設定</a:t>
            </a:r>
          </a:p>
        </p:txBody>
      </p:sp>
      <p:sp>
        <p:nvSpPr>
          <p:cNvPr id="4" name="日付プレースホルダ 3">
            <a:extLst>
              <a:ext uri="{FF2B5EF4-FFF2-40B4-BE49-F238E27FC236}">
                <a16:creationId xmlns:a16="http://schemas.microsoft.com/office/drawing/2014/main" id="{F02B1CE8-71C6-5499-575C-234B398C40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5691FDF-C82B-4606-AC55-596B30A26F06}" type="datetimeFigureOut">
              <a:rPr lang="ja-JP" altLang="en-US"/>
              <a:pPr>
                <a:defRPr/>
              </a:pPr>
              <a:t>2024/4/17</a:t>
            </a:fld>
            <a:endParaRPr lang="ja-JP" altLang="en-US"/>
          </a:p>
        </p:txBody>
      </p:sp>
      <p:sp>
        <p:nvSpPr>
          <p:cNvPr id="5" name="フッター プレースホルダ 4">
            <a:extLst>
              <a:ext uri="{FF2B5EF4-FFF2-40B4-BE49-F238E27FC236}">
                <a16:creationId xmlns:a16="http://schemas.microsoft.com/office/drawing/2014/main" id="{76ADC7E2-93A5-7AC3-E634-5929A9060A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>
            <a:extLst>
              <a:ext uri="{FF2B5EF4-FFF2-40B4-BE49-F238E27FC236}">
                <a16:creationId xmlns:a16="http://schemas.microsoft.com/office/drawing/2014/main" id="{EE46CA08-F18B-543D-B1A6-68B273B95C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8EEB660-BF90-47C4-9268-08E27C7D3B26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5515297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>
            <a:extLst>
              <a:ext uri="{FF2B5EF4-FFF2-40B4-BE49-F238E27FC236}">
                <a16:creationId xmlns:a16="http://schemas.microsoft.com/office/drawing/2014/main" id="{CD9A33BC-765F-76D1-4293-6D78D56D08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83E9EEB-EB38-481D-A143-B96371E24FC8}" type="datetimeFigureOut">
              <a:rPr lang="ja-JP" altLang="en-US"/>
              <a:pPr>
                <a:defRPr/>
              </a:pPr>
              <a:t>2024/4/17</a:t>
            </a:fld>
            <a:endParaRPr lang="ja-JP" altLang="en-US"/>
          </a:p>
        </p:txBody>
      </p:sp>
      <p:sp>
        <p:nvSpPr>
          <p:cNvPr id="5" name="フッター プレースホルダ 4">
            <a:extLst>
              <a:ext uri="{FF2B5EF4-FFF2-40B4-BE49-F238E27FC236}">
                <a16:creationId xmlns:a16="http://schemas.microsoft.com/office/drawing/2014/main" id="{42934436-2BC9-F0F2-1EAA-36E9D8604B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>
            <a:extLst>
              <a:ext uri="{FF2B5EF4-FFF2-40B4-BE49-F238E27FC236}">
                <a16:creationId xmlns:a16="http://schemas.microsoft.com/office/drawing/2014/main" id="{7F5FA445-E9FF-5162-1C35-A5C69E08DD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29A44CA-22D9-439D-821E-71F1B644C163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4845665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5386388" y="366715"/>
            <a:ext cx="1671638" cy="7800975"/>
          </a:xfrm>
        </p:spPr>
        <p:txBody>
          <a:bodyPr vert="eaVert"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371476" y="366715"/>
            <a:ext cx="4849815" cy="7800975"/>
          </a:xfrm>
        </p:spPr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>
            <a:extLst>
              <a:ext uri="{FF2B5EF4-FFF2-40B4-BE49-F238E27FC236}">
                <a16:creationId xmlns:a16="http://schemas.microsoft.com/office/drawing/2014/main" id="{2F19F3BB-341B-BC59-823B-86A899DBC3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721A301-32CD-4D86-875B-50F6D970502B}" type="datetimeFigureOut">
              <a:rPr lang="ja-JP" altLang="en-US"/>
              <a:pPr>
                <a:defRPr/>
              </a:pPr>
              <a:t>2024/4/17</a:t>
            </a:fld>
            <a:endParaRPr lang="ja-JP" altLang="en-US"/>
          </a:p>
        </p:txBody>
      </p:sp>
      <p:sp>
        <p:nvSpPr>
          <p:cNvPr id="5" name="フッター プレースホルダ 4">
            <a:extLst>
              <a:ext uri="{FF2B5EF4-FFF2-40B4-BE49-F238E27FC236}">
                <a16:creationId xmlns:a16="http://schemas.microsoft.com/office/drawing/2014/main" id="{F61DDA03-70E6-56E9-4FC4-C51B8F9DF9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>
            <a:extLst>
              <a:ext uri="{FF2B5EF4-FFF2-40B4-BE49-F238E27FC236}">
                <a16:creationId xmlns:a16="http://schemas.microsoft.com/office/drawing/2014/main" id="{32DA9336-D8E9-9D89-DF69-8A88608FB3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4D24F26-A9DC-47BD-A0DD-3FF07C6C6F9A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4013494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>
            <a:extLst>
              <a:ext uri="{FF2B5EF4-FFF2-40B4-BE49-F238E27FC236}">
                <a16:creationId xmlns:a16="http://schemas.microsoft.com/office/drawing/2014/main" id="{0345D15A-318A-B1C5-DD0A-7A10794473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041724C-1EFE-4463-99E1-964218C5EF68}" type="datetimeFigureOut">
              <a:rPr lang="ja-JP" altLang="en-US"/>
              <a:pPr>
                <a:defRPr/>
              </a:pPr>
              <a:t>2024/4/17</a:t>
            </a:fld>
            <a:endParaRPr lang="ja-JP" altLang="en-US"/>
          </a:p>
        </p:txBody>
      </p:sp>
      <p:sp>
        <p:nvSpPr>
          <p:cNvPr id="5" name="フッター プレースホルダ 4">
            <a:extLst>
              <a:ext uri="{FF2B5EF4-FFF2-40B4-BE49-F238E27FC236}">
                <a16:creationId xmlns:a16="http://schemas.microsoft.com/office/drawing/2014/main" id="{5193CA79-07E2-5037-EA92-A8BB4ED96A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>
            <a:extLst>
              <a:ext uri="{FF2B5EF4-FFF2-40B4-BE49-F238E27FC236}">
                <a16:creationId xmlns:a16="http://schemas.microsoft.com/office/drawing/2014/main" id="{DADE69FF-B8CB-68AB-670E-F54628B26F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D9CA95C-3ABC-452E-B79D-681978D7A86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9011290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82506" y="4406902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82506" y="2906715"/>
            <a:ext cx="8420100" cy="1500188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日付プレースホルダ 3">
            <a:extLst>
              <a:ext uri="{FF2B5EF4-FFF2-40B4-BE49-F238E27FC236}">
                <a16:creationId xmlns:a16="http://schemas.microsoft.com/office/drawing/2014/main" id="{99FA4CEA-4C2B-F83A-8AB8-4A2494B9F4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813C3DD-497A-48C9-9992-B2D4862C01F4}" type="datetimeFigureOut">
              <a:rPr lang="ja-JP" altLang="en-US"/>
              <a:pPr>
                <a:defRPr/>
              </a:pPr>
              <a:t>2024/4/17</a:t>
            </a:fld>
            <a:endParaRPr lang="ja-JP" altLang="en-US"/>
          </a:p>
        </p:txBody>
      </p:sp>
      <p:sp>
        <p:nvSpPr>
          <p:cNvPr id="5" name="フッター プレースホルダ 4">
            <a:extLst>
              <a:ext uri="{FF2B5EF4-FFF2-40B4-BE49-F238E27FC236}">
                <a16:creationId xmlns:a16="http://schemas.microsoft.com/office/drawing/2014/main" id="{524C3C7D-7FA0-BF06-553F-48CBCBE7E5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>
            <a:extLst>
              <a:ext uri="{FF2B5EF4-FFF2-40B4-BE49-F238E27FC236}">
                <a16:creationId xmlns:a16="http://schemas.microsoft.com/office/drawing/2014/main" id="{2D2B327A-0C6D-4EE9-7A3B-8C637AA56C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398220C-9059-4595-8B75-70C2A2AEDE4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3624887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371489" y="2133605"/>
            <a:ext cx="3260725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797312" y="2133605"/>
            <a:ext cx="3260725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日付プレースホルダ 3">
            <a:extLst>
              <a:ext uri="{FF2B5EF4-FFF2-40B4-BE49-F238E27FC236}">
                <a16:creationId xmlns:a16="http://schemas.microsoft.com/office/drawing/2014/main" id="{D457BDB8-EE3F-59F4-87FC-22FCB97FFF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3D842F2-B17B-4880-BD59-1321640D24A8}" type="datetimeFigureOut">
              <a:rPr lang="ja-JP" altLang="en-US"/>
              <a:pPr>
                <a:defRPr/>
              </a:pPr>
              <a:t>2024/4/17</a:t>
            </a:fld>
            <a:endParaRPr lang="ja-JP" altLang="en-US"/>
          </a:p>
        </p:txBody>
      </p:sp>
      <p:sp>
        <p:nvSpPr>
          <p:cNvPr id="6" name="フッター プレースホルダ 4">
            <a:extLst>
              <a:ext uri="{FF2B5EF4-FFF2-40B4-BE49-F238E27FC236}">
                <a16:creationId xmlns:a16="http://schemas.microsoft.com/office/drawing/2014/main" id="{FCCD553E-9CBD-0DD9-05EB-AE6B811F47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>
            <a:extLst>
              <a:ext uri="{FF2B5EF4-FFF2-40B4-BE49-F238E27FC236}">
                <a16:creationId xmlns:a16="http://schemas.microsoft.com/office/drawing/2014/main" id="{19CB5C37-5639-FA3F-2B92-71DE5B057E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AED773D-3E46-4FC4-84F5-4EAC4C1457C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8591490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95301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95304" y="1535113"/>
            <a:ext cx="4376872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95304" y="2174877"/>
            <a:ext cx="4376872" cy="395128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5032125" y="1535113"/>
            <a:ext cx="4378589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5032125" y="2174877"/>
            <a:ext cx="4378589" cy="395128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日付プレースホルダ 3">
            <a:extLst>
              <a:ext uri="{FF2B5EF4-FFF2-40B4-BE49-F238E27FC236}">
                <a16:creationId xmlns:a16="http://schemas.microsoft.com/office/drawing/2014/main" id="{0AA74436-7B68-5504-F04C-DD0DFB11C3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81BB3E-49FF-461E-9272-52468AD268DE}" type="datetimeFigureOut">
              <a:rPr lang="ja-JP" altLang="en-US"/>
              <a:pPr>
                <a:defRPr/>
              </a:pPr>
              <a:t>2024/4/17</a:t>
            </a:fld>
            <a:endParaRPr lang="ja-JP" altLang="en-US"/>
          </a:p>
        </p:txBody>
      </p:sp>
      <p:sp>
        <p:nvSpPr>
          <p:cNvPr id="8" name="フッター プレースホルダ 4">
            <a:extLst>
              <a:ext uri="{FF2B5EF4-FFF2-40B4-BE49-F238E27FC236}">
                <a16:creationId xmlns:a16="http://schemas.microsoft.com/office/drawing/2014/main" id="{E4886915-426E-98E4-9568-82F5CD7B6C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スライド番号プレースホルダ 5">
            <a:extLst>
              <a:ext uri="{FF2B5EF4-FFF2-40B4-BE49-F238E27FC236}">
                <a16:creationId xmlns:a16="http://schemas.microsoft.com/office/drawing/2014/main" id="{7DFAC2CF-B233-567A-4741-73E02B17C4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FB3F653-D7A3-41CA-AA04-A89DD4D6679F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8002371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日付プレースホルダ 3">
            <a:extLst>
              <a:ext uri="{FF2B5EF4-FFF2-40B4-BE49-F238E27FC236}">
                <a16:creationId xmlns:a16="http://schemas.microsoft.com/office/drawing/2014/main" id="{D5A5222F-DDCE-60BC-26EC-FF0C9D8840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1B5A6E-8EE8-4334-85BD-55A732AD9916}" type="datetimeFigureOut">
              <a:rPr lang="ja-JP" altLang="en-US"/>
              <a:pPr>
                <a:defRPr/>
              </a:pPr>
              <a:t>2024/4/17</a:t>
            </a:fld>
            <a:endParaRPr lang="ja-JP" altLang="en-US"/>
          </a:p>
        </p:txBody>
      </p:sp>
      <p:sp>
        <p:nvSpPr>
          <p:cNvPr id="4" name="フッター プレースホルダ 4">
            <a:extLst>
              <a:ext uri="{FF2B5EF4-FFF2-40B4-BE49-F238E27FC236}">
                <a16:creationId xmlns:a16="http://schemas.microsoft.com/office/drawing/2014/main" id="{76BBE926-A119-1020-4A5E-635328F3AE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 5">
            <a:extLst>
              <a:ext uri="{FF2B5EF4-FFF2-40B4-BE49-F238E27FC236}">
                <a16:creationId xmlns:a16="http://schemas.microsoft.com/office/drawing/2014/main" id="{4EB6A5E6-5BCE-D574-8676-FB62B29BCF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094EA79-F075-4219-923F-F12DD2AFC8AA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8134791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3">
            <a:extLst>
              <a:ext uri="{FF2B5EF4-FFF2-40B4-BE49-F238E27FC236}">
                <a16:creationId xmlns:a16="http://schemas.microsoft.com/office/drawing/2014/main" id="{B629097C-C0E6-5D5A-3379-F9C0617FC2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FCBE190-F716-4468-B752-6D07EFFF56F6}" type="datetimeFigureOut">
              <a:rPr lang="ja-JP" altLang="en-US"/>
              <a:pPr>
                <a:defRPr/>
              </a:pPr>
              <a:t>2024/4/17</a:t>
            </a:fld>
            <a:endParaRPr lang="ja-JP" altLang="en-US"/>
          </a:p>
        </p:txBody>
      </p:sp>
      <p:sp>
        <p:nvSpPr>
          <p:cNvPr id="3" name="フッター プレースホルダ 4">
            <a:extLst>
              <a:ext uri="{FF2B5EF4-FFF2-40B4-BE49-F238E27FC236}">
                <a16:creationId xmlns:a16="http://schemas.microsoft.com/office/drawing/2014/main" id="{9847D2D7-1270-BA08-F526-9CC4DE355D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スライド番号プレースホルダ 5">
            <a:extLst>
              <a:ext uri="{FF2B5EF4-FFF2-40B4-BE49-F238E27FC236}">
                <a16:creationId xmlns:a16="http://schemas.microsoft.com/office/drawing/2014/main" id="{1FA19BF8-BF44-CE94-5381-ECEFC3ED1A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3FC01E7-5FCE-435B-9D85-B747C8250A65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9746297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95304" y="273051"/>
            <a:ext cx="3259005" cy="11620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872985" y="273056"/>
            <a:ext cx="553773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95304" y="1435103"/>
            <a:ext cx="3259005" cy="46910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日付プレースホルダ 3">
            <a:extLst>
              <a:ext uri="{FF2B5EF4-FFF2-40B4-BE49-F238E27FC236}">
                <a16:creationId xmlns:a16="http://schemas.microsoft.com/office/drawing/2014/main" id="{5E863413-A8F4-089C-B9C8-564CE1CAC7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3CC2949-DEA7-4BFF-9F6F-D3449F3AB066}" type="datetimeFigureOut">
              <a:rPr lang="ja-JP" altLang="en-US"/>
              <a:pPr>
                <a:defRPr/>
              </a:pPr>
              <a:t>2024/4/17</a:t>
            </a:fld>
            <a:endParaRPr lang="ja-JP" altLang="en-US"/>
          </a:p>
        </p:txBody>
      </p:sp>
      <p:sp>
        <p:nvSpPr>
          <p:cNvPr id="6" name="フッター プレースホルダ 4">
            <a:extLst>
              <a:ext uri="{FF2B5EF4-FFF2-40B4-BE49-F238E27FC236}">
                <a16:creationId xmlns:a16="http://schemas.microsoft.com/office/drawing/2014/main" id="{ACCCC6F8-126F-A8CC-1044-2C7C0E64A8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>
            <a:extLst>
              <a:ext uri="{FF2B5EF4-FFF2-40B4-BE49-F238E27FC236}">
                <a16:creationId xmlns:a16="http://schemas.microsoft.com/office/drawing/2014/main" id="{162C85A2-C762-E02C-4EF7-CEF06EBFA8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266003F-3FFE-4E4D-A2E9-C15CF7496F3A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2073810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941647" y="4800606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941647" y="612774"/>
            <a:ext cx="59436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941647" y="5367344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日付プレースホルダ 3">
            <a:extLst>
              <a:ext uri="{FF2B5EF4-FFF2-40B4-BE49-F238E27FC236}">
                <a16:creationId xmlns:a16="http://schemas.microsoft.com/office/drawing/2014/main" id="{C70C5CDD-DC76-09BB-08A9-BAE61DE541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1EA1F-7DAA-48E7-9382-131E89D9051E}" type="datetimeFigureOut">
              <a:rPr lang="ja-JP" altLang="en-US"/>
              <a:pPr>
                <a:defRPr/>
              </a:pPr>
              <a:t>2024/4/17</a:t>
            </a:fld>
            <a:endParaRPr lang="ja-JP" altLang="en-US"/>
          </a:p>
        </p:txBody>
      </p:sp>
      <p:sp>
        <p:nvSpPr>
          <p:cNvPr id="6" name="フッター プレースホルダ 4">
            <a:extLst>
              <a:ext uri="{FF2B5EF4-FFF2-40B4-BE49-F238E27FC236}">
                <a16:creationId xmlns:a16="http://schemas.microsoft.com/office/drawing/2014/main" id="{1F77C0AE-5DBA-F08D-7428-41EF5F6D18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>
            <a:extLst>
              <a:ext uri="{FF2B5EF4-FFF2-40B4-BE49-F238E27FC236}">
                <a16:creationId xmlns:a16="http://schemas.microsoft.com/office/drawing/2014/main" id="{2548225D-1DFE-DD63-D4F3-B3B63740FF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81AD247-D09C-4E89-9AA8-997DBD149A4F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2705952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 1">
            <a:extLst>
              <a:ext uri="{FF2B5EF4-FFF2-40B4-BE49-F238E27FC236}">
                <a16:creationId xmlns:a16="http://schemas.microsoft.com/office/drawing/2014/main" id="{533075B1-EE86-E8C3-1C25-FF17A48D1CA3}"/>
              </a:ext>
            </a:extLst>
          </p:cNvPr>
          <p:cNvSpPr>
            <a:spLocks noGrp="1"/>
          </p:cNvSpPr>
          <p:nvPr>
            <p:ph type="title"/>
          </p:nvPr>
        </p:nvSpPr>
        <p:spPr bwMode="auto">
          <a:xfrm>
            <a:off x="495300" y="274638"/>
            <a:ext cx="89154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タイトルの書式設定</a:t>
            </a:r>
          </a:p>
        </p:txBody>
      </p:sp>
      <p:sp>
        <p:nvSpPr>
          <p:cNvPr id="1027" name="テキスト プレースホルダ 2">
            <a:extLst>
              <a:ext uri="{FF2B5EF4-FFF2-40B4-BE49-F238E27FC236}">
                <a16:creationId xmlns:a16="http://schemas.microsoft.com/office/drawing/2014/main" id="{A3629C55-2F6C-2B72-7109-DCD30914F66E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495300" y="1600200"/>
            <a:ext cx="89154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>
            <a:extLst>
              <a:ext uri="{FF2B5EF4-FFF2-40B4-BE49-F238E27FC236}">
                <a16:creationId xmlns:a16="http://schemas.microsoft.com/office/drawing/2014/main" id="{7581D9B9-5D69-F9D3-09D5-5784543853C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95300" y="6356350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DB5BB42B-8DD5-4EC7-8D3C-FF117677DE0B}" type="datetimeFigureOut">
              <a:rPr lang="ja-JP" altLang="en-US"/>
              <a:pPr>
                <a:defRPr/>
              </a:pPr>
              <a:t>2024/4/17</a:t>
            </a:fld>
            <a:endParaRPr lang="ja-JP" altLang="en-US"/>
          </a:p>
        </p:txBody>
      </p:sp>
      <p:sp>
        <p:nvSpPr>
          <p:cNvPr id="5" name="フッター プレースホルダ 4">
            <a:extLst>
              <a:ext uri="{FF2B5EF4-FFF2-40B4-BE49-F238E27FC236}">
                <a16:creationId xmlns:a16="http://schemas.microsoft.com/office/drawing/2014/main" id="{DF192E07-96B2-8099-6768-103C8BA8A7A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384550" y="6356350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>
            <a:extLst>
              <a:ext uri="{FF2B5EF4-FFF2-40B4-BE49-F238E27FC236}">
                <a16:creationId xmlns:a16="http://schemas.microsoft.com/office/drawing/2014/main" id="{C4E35DD7-B695-2203-64C1-F17050075F3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7099300" y="6356350"/>
            <a:ext cx="23114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solidFill>
                  <a:srgbClr val="898989"/>
                </a:solidFill>
                <a:latin typeface="Calibri" panose="020F0502020204030204" pitchFamily="34" charset="0"/>
              </a:defRPr>
            </a:lvl1pPr>
          </a:lstStyle>
          <a:p>
            <a:pPr>
              <a:defRPr/>
            </a:pPr>
            <a:fld id="{DA8B8152-FF06-419F-B893-903ACFC87688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" name="図 32">
            <a:extLst>
              <a:ext uri="{FF2B5EF4-FFF2-40B4-BE49-F238E27FC236}">
                <a16:creationId xmlns:a16="http://schemas.microsoft.com/office/drawing/2014/main" id="{0BA69AB5-3F43-1C00-1073-D57EE188661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49696" y="-145112"/>
            <a:ext cx="8107760" cy="5335642"/>
          </a:xfrm>
          <a:prstGeom prst="rect">
            <a:avLst/>
          </a:prstGeom>
        </p:spPr>
      </p:pic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86A8C300-4E78-229F-A6D3-BA5A11611D8F}"/>
              </a:ext>
            </a:extLst>
          </p:cNvPr>
          <p:cNvSpPr txBox="1"/>
          <p:nvPr/>
        </p:nvSpPr>
        <p:spPr bwMode="auto">
          <a:xfrm>
            <a:off x="2893204" y="5494698"/>
            <a:ext cx="4849404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rtlCol="0">
            <a:spAutoFit/>
          </a:bodyPr>
          <a:lstStyle/>
          <a:p>
            <a:r>
              <a:rPr kumimoji="1" lang="ja-JP" altLang="en-US" sz="700" baseline="30000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●</a:t>
            </a:r>
            <a:r>
              <a:rPr kumimoji="1" lang="ja-JP" altLang="en-US" sz="700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kumimoji="1" lang="en-US" altLang="ja-JP" sz="1400" dirty="0">
                <a:latin typeface="Arial" pitchFamily="34" charset="0"/>
                <a:cs typeface="Arial" pitchFamily="34" charset="0"/>
              </a:rPr>
              <a:t>CNO    </a:t>
            </a:r>
            <a:r>
              <a:rPr kumimoji="1" lang="en-US" altLang="ja-JP" sz="1400" baseline="30000" dirty="0">
                <a:latin typeface="Arial" pitchFamily="34" charset="0"/>
                <a:cs typeface="Arial" pitchFamily="34" charset="0"/>
              </a:rPr>
              <a:t> </a:t>
            </a:r>
            <a:r>
              <a:rPr kumimoji="1" lang="ja-JP" altLang="en-US" sz="800" baseline="30000" dirty="0">
                <a:solidFill>
                  <a:srgbClr val="0070C0"/>
                </a:solidFill>
                <a:latin typeface="Arial" pitchFamily="34" charset="0"/>
                <a:cs typeface="Arial" pitchFamily="34" charset="0"/>
              </a:rPr>
              <a:t>● </a:t>
            </a:r>
            <a:r>
              <a:rPr lang="en-US" altLang="ja-JP" sz="1400" dirty="0">
                <a:cs typeface="Arial" pitchFamily="34" charset="0"/>
              </a:rPr>
              <a:t>chronic bacterial osteomyelitis</a:t>
            </a:r>
            <a:r>
              <a:rPr kumimoji="1" lang="ja-JP" altLang="en-US" sz="700" baseline="30000" dirty="0">
                <a:latin typeface="Arial" pitchFamily="34" charset="0"/>
                <a:cs typeface="Arial" pitchFamily="34" charset="0"/>
              </a:rPr>
              <a:t>           ●</a:t>
            </a:r>
            <a:r>
              <a:rPr kumimoji="1" lang="ja-JP" altLang="en-US" sz="1600" baseline="30000" dirty="0">
                <a:latin typeface="Arial" pitchFamily="34" charset="0"/>
                <a:cs typeface="Arial" pitchFamily="34" charset="0"/>
              </a:rPr>
              <a:t> </a:t>
            </a:r>
            <a:r>
              <a:rPr kumimoji="1" lang="en-US" altLang="ja-JP" sz="1400" dirty="0">
                <a:latin typeface="Arial" pitchFamily="34" charset="0"/>
                <a:cs typeface="Arial" pitchFamily="34" charset="0"/>
              </a:rPr>
              <a:t>healthy control </a:t>
            </a:r>
            <a:endParaRPr kumimoji="1" lang="ja-JP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ACEC4DBE-18F4-8B8C-3FFA-962D686DBE38}"/>
              </a:ext>
            </a:extLst>
          </p:cNvPr>
          <p:cNvSpPr/>
          <p:nvPr/>
        </p:nvSpPr>
        <p:spPr>
          <a:xfrm>
            <a:off x="2720752" y="5327496"/>
            <a:ext cx="5184576" cy="576064"/>
          </a:xfrm>
          <a:prstGeom prst="rect">
            <a:avLst/>
          </a:prstGeom>
          <a:noFill/>
          <a:ln w="635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41629688-124A-B0ED-016C-B054465F8CEE}"/>
              </a:ext>
            </a:extLst>
          </p:cNvPr>
          <p:cNvCxnSpPr/>
          <p:nvPr/>
        </p:nvCxnSpPr>
        <p:spPr>
          <a:xfrm flipV="1">
            <a:off x="2000672" y="416426"/>
            <a:ext cx="6624736" cy="3931166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楕円 10">
            <a:extLst>
              <a:ext uri="{FF2B5EF4-FFF2-40B4-BE49-F238E27FC236}">
                <a16:creationId xmlns:a16="http://schemas.microsoft.com/office/drawing/2014/main" id="{2B2F9ED5-933B-0A29-1D6A-999C7CC63138}"/>
              </a:ext>
            </a:extLst>
          </p:cNvPr>
          <p:cNvSpPr/>
          <p:nvPr/>
        </p:nvSpPr>
        <p:spPr>
          <a:xfrm rot="21112340">
            <a:off x="3159339" y="3448481"/>
            <a:ext cx="5297105" cy="830533"/>
          </a:xfrm>
          <a:custGeom>
            <a:avLst/>
            <a:gdLst>
              <a:gd name="connsiteX0" fmla="*/ 0 w 1939142"/>
              <a:gd name="connsiteY0" fmla="*/ 183992 h 367983"/>
              <a:gd name="connsiteX1" fmla="*/ 969571 w 1939142"/>
              <a:gd name="connsiteY1" fmla="*/ 0 h 367983"/>
              <a:gd name="connsiteX2" fmla="*/ 1939142 w 1939142"/>
              <a:gd name="connsiteY2" fmla="*/ 183992 h 367983"/>
              <a:gd name="connsiteX3" fmla="*/ 969571 w 1939142"/>
              <a:gd name="connsiteY3" fmla="*/ 367984 h 367983"/>
              <a:gd name="connsiteX4" fmla="*/ 0 w 1939142"/>
              <a:gd name="connsiteY4" fmla="*/ 183992 h 367983"/>
              <a:gd name="connsiteX0" fmla="*/ 4 w 1939146"/>
              <a:gd name="connsiteY0" fmla="*/ 117987 h 301979"/>
              <a:gd name="connsiteX1" fmla="*/ 960149 w 1939146"/>
              <a:gd name="connsiteY1" fmla="*/ 0 h 301979"/>
              <a:gd name="connsiteX2" fmla="*/ 1939146 w 1939146"/>
              <a:gd name="connsiteY2" fmla="*/ 117987 h 301979"/>
              <a:gd name="connsiteX3" fmla="*/ 969575 w 1939146"/>
              <a:gd name="connsiteY3" fmla="*/ 301979 h 301979"/>
              <a:gd name="connsiteX4" fmla="*/ 4 w 1939146"/>
              <a:gd name="connsiteY4" fmla="*/ 117987 h 301979"/>
              <a:gd name="connsiteX0" fmla="*/ 6 w 1939148"/>
              <a:gd name="connsiteY0" fmla="*/ 267230 h 451222"/>
              <a:gd name="connsiteX1" fmla="*/ 960151 w 1939148"/>
              <a:gd name="connsiteY1" fmla="*/ 149243 h 451222"/>
              <a:gd name="connsiteX2" fmla="*/ 1939148 w 1939148"/>
              <a:gd name="connsiteY2" fmla="*/ 267230 h 451222"/>
              <a:gd name="connsiteX3" fmla="*/ 969577 w 1939148"/>
              <a:gd name="connsiteY3" fmla="*/ 451222 h 451222"/>
              <a:gd name="connsiteX4" fmla="*/ 6 w 1939148"/>
              <a:gd name="connsiteY4" fmla="*/ 267230 h 451222"/>
              <a:gd name="connsiteX0" fmla="*/ 6 w 1939215"/>
              <a:gd name="connsiteY0" fmla="*/ 267230 h 451222"/>
              <a:gd name="connsiteX1" fmla="*/ 960151 w 1939215"/>
              <a:gd name="connsiteY1" fmla="*/ 149243 h 451222"/>
              <a:gd name="connsiteX2" fmla="*/ 931599 w 1939215"/>
              <a:gd name="connsiteY2" fmla="*/ 154885 h 451222"/>
              <a:gd name="connsiteX3" fmla="*/ 1939148 w 1939215"/>
              <a:gd name="connsiteY3" fmla="*/ 267230 h 451222"/>
              <a:gd name="connsiteX4" fmla="*/ 969577 w 1939215"/>
              <a:gd name="connsiteY4" fmla="*/ 451222 h 451222"/>
              <a:gd name="connsiteX5" fmla="*/ 6 w 1939215"/>
              <a:gd name="connsiteY5" fmla="*/ 267230 h 451222"/>
              <a:gd name="connsiteX0" fmla="*/ 3 w 1939212"/>
              <a:gd name="connsiteY0" fmla="*/ 236228 h 420220"/>
              <a:gd name="connsiteX1" fmla="*/ 960148 w 1939212"/>
              <a:gd name="connsiteY1" fmla="*/ 118241 h 420220"/>
              <a:gd name="connsiteX2" fmla="*/ 1699403 w 1939212"/>
              <a:gd name="connsiteY2" fmla="*/ 2617 h 420220"/>
              <a:gd name="connsiteX3" fmla="*/ 1939145 w 1939212"/>
              <a:gd name="connsiteY3" fmla="*/ 236228 h 420220"/>
              <a:gd name="connsiteX4" fmla="*/ 969574 w 1939212"/>
              <a:gd name="connsiteY4" fmla="*/ 420220 h 420220"/>
              <a:gd name="connsiteX5" fmla="*/ 3 w 1939212"/>
              <a:gd name="connsiteY5" fmla="*/ 236228 h 420220"/>
              <a:gd name="connsiteX0" fmla="*/ 3 w 1971035"/>
              <a:gd name="connsiteY0" fmla="*/ 236228 h 420220"/>
              <a:gd name="connsiteX1" fmla="*/ 960148 w 1971035"/>
              <a:gd name="connsiteY1" fmla="*/ 118241 h 420220"/>
              <a:gd name="connsiteX2" fmla="*/ 1699403 w 1971035"/>
              <a:gd name="connsiteY2" fmla="*/ 2617 h 420220"/>
              <a:gd name="connsiteX3" fmla="*/ 1939145 w 1971035"/>
              <a:gd name="connsiteY3" fmla="*/ 236228 h 420220"/>
              <a:gd name="connsiteX4" fmla="*/ 1861051 w 1971035"/>
              <a:gd name="connsiteY4" fmla="*/ 83432 h 420220"/>
              <a:gd name="connsiteX5" fmla="*/ 969574 w 1971035"/>
              <a:gd name="connsiteY5" fmla="*/ 420220 h 420220"/>
              <a:gd name="connsiteX6" fmla="*/ 3 w 1971035"/>
              <a:gd name="connsiteY6" fmla="*/ 236228 h 420220"/>
              <a:gd name="connsiteX0" fmla="*/ 3 w 1949483"/>
              <a:gd name="connsiteY0" fmla="*/ 236228 h 422501"/>
              <a:gd name="connsiteX1" fmla="*/ 960148 w 1949483"/>
              <a:gd name="connsiteY1" fmla="*/ 118241 h 422501"/>
              <a:gd name="connsiteX2" fmla="*/ 1699403 w 1949483"/>
              <a:gd name="connsiteY2" fmla="*/ 2617 h 422501"/>
              <a:gd name="connsiteX3" fmla="*/ 1939145 w 1949483"/>
              <a:gd name="connsiteY3" fmla="*/ 236228 h 422501"/>
              <a:gd name="connsiteX4" fmla="*/ 1786975 w 1949483"/>
              <a:gd name="connsiteY4" fmla="*/ 332638 h 422501"/>
              <a:gd name="connsiteX5" fmla="*/ 969574 w 1949483"/>
              <a:gd name="connsiteY5" fmla="*/ 420220 h 422501"/>
              <a:gd name="connsiteX6" fmla="*/ 3 w 1949483"/>
              <a:gd name="connsiteY6" fmla="*/ 236228 h 422501"/>
              <a:gd name="connsiteX0" fmla="*/ 3 w 1922643"/>
              <a:gd name="connsiteY0" fmla="*/ 236228 h 422501"/>
              <a:gd name="connsiteX1" fmla="*/ 960148 w 1922643"/>
              <a:gd name="connsiteY1" fmla="*/ 118241 h 422501"/>
              <a:gd name="connsiteX2" fmla="*/ 1699403 w 1922643"/>
              <a:gd name="connsiteY2" fmla="*/ 2617 h 422501"/>
              <a:gd name="connsiteX3" fmla="*/ 1905462 w 1922643"/>
              <a:gd name="connsiteY3" fmla="*/ 67850 h 422501"/>
              <a:gd name="connsiteX4" fmla="*/ 1786975 w 1922643"/>
              <a:gd name="connsiteY4" fmla="*/ 332638 h 422501"/>
              <a:gd name="connsiteX5" fmla="*/ 969574 w 1922643"/>
              <a:gd name="connsiteY5" fmla="*/ 420220 h 422501"/>
              <a:gd name="connsiteX6" fmla="*/ 3 w 1922643"/>
              <a:gd name="connsiteY6" fmla="*/ 236228 h 422501"/>
              <a:gd name="connsiteX0" fmla="*/ 1585 w 1924225"/>
              <a:gd name="connsiteY0" fmla="*/ 235897 h 422170"/>
              <a:gd name="connsiteX1" fmla="*/ 748635 w 1924225"/>
              <a:gd name="connsiteY1" fmla="*/ 135684 h 422170"/>
              <a:gd name="connsiteX2" fmla="*/ 961730 w 1924225"/>
              <a:gd name="connsiteY2" fmla="*/ 117910 h 422170"/>
              <a:gd name="connsiteX3" fmla="*/ 1700985 w 1924225"/>
              <a:gd name="connsiteY3" fmla="*/ 2286 h 422170"/>
              <a:gd name="connsiteX4" fmla="*/ 1907044 w 1924225"/>
              <a:gd name="connsiteY4" fmla="*/ 67519 h 422170"/>
              <a:gd name="connsiteX5" fmla="*/ 1788557 w 1924225"/>
              <a:gd name="connsiteY5" fmla="*/ 332307 h 422170"/>
              <a:gd name="connsiteX6" fmla="*/ 971156 w 1924225"/>
              <a:gd name="connsiteY6" fmla="*/ 419889 h 422170"/>
              <a:gd name="connsiteX7" fmla="*/ 1585 w 1924225"/>
              <a:gd name="connsiteY7" fmla="*/ 235897 h 422170"/>
              <a:gd name="connsiteX0" fmla="*/ 15228 w 1937868"/>
              <a:gd name="connsiteY0" fmla="*/ 283583 h 469856"/>
              <a:gd name="connsiteX1" fmla="*/ 432246 w 1937868"/>
              <a:gd name="connsiteY1" fmla="*/ 1534 h 469856"/>
              <a:gd name="connsiteX2" fmla="*/ 975373 w 1937868"/>
              <a:gd name="connsiteY2" fmla="*/ 165596 h 469856"/>
              <a:gd name="connsiteX3" fmla="*/ 1714628 w 1937868"/>
              <a:gd name="connsiteY3" fmla="*/ 49972 h 469856"/>
              <a:gd name="connsiteX4" fmla="*/ 1920687 w 1937868"/>
              <a:gd name="connsiteY4" fmla="*/ 115205 h 469856"/>
              <a:gd name="connsiteX5" fmla="*/ 1802200 w 1937868"/>
              <a:gd name="connsiteY5" fmla="*/ 379993 h 469856"/>
              <a:gd name="connsiteX6" fmla="*/ 984799 w 1937868"/>
              <a:gd name="connsiteY6" fmla="*/ 467575 h 469856"/>
              <a:gd name="connsiteX7" fmla="*/ 15228 w 1937868"/>
              <a:gd name="connsiteY7" fmla="*/ 283583 h 469856"/>
              <a:gd name="connsiteX0" fmla="*/ 25156 w 1777368"/>
              <a:gd name="connsiteY0" fmla="*/ 221612 h 472667"/>
              <a:gd name="connsiteX1" fmla="*/ 271746 w 1777368"/>
              <a:gd name="connsiteY1" fmla="*/ 1534 h 472667"/>
              <a:gd name="connsiteX2" fmla="*/ 814873 w 1777368"/>
              <a:gd name="connsiteY2" fmla="*/ 165596 h 472667"/>
              <a:gd name="connsiteX3" fmla="*/ 1554128 w 1777368"/>
              <a:gd name="connsiteY3" fmla="*/ 49972 h 472667"/>
              <a:gd name="connsiteX4" fmla="*/ 1760187 w 1777368"/>
              <a:gd name="connsiteY4" fmla="*/ 115205 h 472667"/>
              <a:gd name="connsiteX5" fmla="*/ 1641700 w 1777368"/>
              <a:gd name="connsiteY5" fmla="*/ 379993 h 472667"/>
              <a:gd name="connsiteX6" fmla="*/ 824299 w 1777368"/>
              <a:gd name="connsiteY6" fmla="*/ 467575 h 472667"/>
              <a:gd name="connsiteX7" fmla="*/ 25156 w 1777368"/>
              <a:gd name="connsiteY7" fmla="*/ 221612 h 472667"/>
              <a:gd name="connsiteX0" fmla="*/ 25156 w 1770879"/>
              <a:gd name="connsiteY0" fmla="*/ 221612 h 474627"/>
              <a:gd name="connsiteX1" fmla="*/ 271746 w 1770879"/>
              <a:gd name="connsiteY1" fmla="*/ 1534 h 474627"/>
              <a:gd name="connsiteX2" fmla="*/ 814873 w 1770879"/>
              <a:gd name="connsiteY2" fmla="*/ 165596 h 474627"/>
              <a:gd name="connsiteX3" fmla="*/ 1554128 w 1770879"/>
              <a:gd name="connsiteY3" fmla="*/ 49972 h 474627"/>
              <a:gd name="connsiteX4" fmla="*/ 1760187 w 1770879"/>
              <a:gd name="connsiteY4" fmla="*/ 115205 h 474627"/>
              <a:gd name="connsiteX5" fmla="*/ 1731131 w 1770879"/>
              <a:gd name="connsiteY5" fmla="*/ 94417 h 474627"/>
              <a:gd name="connsiteX6" fmla="*/ 1641700 w 1770879"/>
              <a:gd name="connsiteY6" fmla="*/ 379993 h 474627"/>
              <a:gd name="connsiteX7" fmla="*/ 824299 w 1770879"/>
              <a:gd name="connsiteY7" fmla="*/ 467575 h 474627"/>
              <a:gd name="connsiteX8" fmla="*/ 25156 w 1770879"/>
              <a:gd name="connsiteY8" fmla="*/ 221612 h 474627"/>
              <a:gd name="connsiteX0" fmla="*/ 25156 w 1834845"/>
              <a:gd name="connsiteY0" fmla="*/ 235430 h 488445"/>
              <a:gd name="connsiteX1" fmla="*/ 271746 w 1834845"/>
              <a:gd name="connsiteY1" fmla="*/ 15352 h 488445"/>
              <a:gd name="connsiteX2" fmla="*/ 814873 w 1834845"/>
              <a:gd name="connsiteY2" fmla="*/ 179414 h 488445"/>
              <a:gd name="connsiteX3" fmla="*/ 1554128 w 1834845"/>
              <a:gd name="connsiteY3" fmla="*/ 63790 h 488445"/>
              <a:gd name="connsiteX4" fmla="*/ 1760187 w 1834845"/>
              <a:gd name="connsiteY4" fmla="*/ 129023 h 488445"/>
              <a:gd name="connsiteX5" fmla="*/ 1830989 w 1834845"/>
              <a:gd name="connsiteY5" fmla="*/ 7203 h 488445"/>
              <a:gd name="connsiteX6" fmla="*/ 1641700 w 1834845"/>
              <a:gd name="connsiteY6" fmla="*/ 393811 h 488445"/>
              <a:gd name="connsiteX7" fmla="*/ 824299 w 1834845"/>
              <a:gd name="connsiteY7" fmla="*/ 481393 h 488445"/>
              <a:gd name="connsiteX8" fmla="*/ 25156 w 1834845"/>
              <a:gd name="connsiteY8" fmla="*/ 235430 h 488445"/>
              <a:gd name="connsiteX0" fmla="*/ 25156 w 1840515"/>
              <a:gd name="connsiteY0" fmla="*/ 250313 h 504648"/>
              <a:gd name="connsiteX1" fmla="*/ 271746 w 1840515"/>
              <a:gd name="connsiteY1" fmla="*/ 30235 h 504648"/>
              <a:gd name="connsiteX2" fmla="*/ 814873 w 1840515"/>
              <a:gd name="connsiteY2" fmla="*/ 194297 h 504648"/>
              <a:gd name="connsiteX3" fmla="*/ 1554128 w 1840515"/>
              <a:gd name="connsiteY3" fmla="*/ 78673 h 504648"/>
              <a:gd name="connsiteX4" fmla="*/ 1760187 w 1840515"/>
              <a:gd name="connsiteY4" fmla="*/ 143906 h 504648"/>
              <a:gd name="connsiteX5" fmla="*/ 1830989 w 1840515"/>
              <a:gd name="connsiteY5" fmla="*/ 22086 h 504648"/>
              <a:gd name="connsiteX6" fmla="*/ 1819006 w 1840515"/>
              <a:gd name="connsiteY6" fmla="*/ 39599 h 504648"/>
              <a:gd name="connsiteX7" fmla="*/ 1641700 w 1840515"/>
              <a:gd name="connsiteY7" fmla="*/ 408694 h 504648"/>
              <a:gd name="connsiteX8" fmla="*/ 824299 w 1840515"/>
              <a:gd name="connsiteY8" fmla="*/ 496276 h 504648"/>
              <a:gd name="connsiteX9" fmla="*/ 25156 w 1840515"/>
              <a:gd name="connsiteY9" fmla="*/ 250313 h 504648"/>
              <a:gd name="connsiteX0" fmla="*/ 25156 w 2899165"/>
              <a:gd name="connsiteY0" fmla="*/ 692492 h 946827"/>
              <a:gd name="connsiteX1" fmla="*/ 271746 w 2899165"/>
              <a:gd name="connsiteY1" fmla="*/ 472414 h 946827"/>
              <a:gd name="connsiteX2" fmla="*/ 814873 w 2899165"/>
              <a:gd name="connsiteY2" fmla="*/ 636476 h 946827"/>
              <a:gd name="connsiteX3" fmla="*/ 1554128 w 2899165"/>
              <a:gd name="connsiteY3" fmla="*/ 520852 h 946827"/>
              <a:gd name="connsiteX4" fmla="*/ 2898586 w 2899165"/>
              <a:gd name="connsiteY4" fmla="*/ 74 h 946827"/>
              <a:gd name="connsiteX5" fmla="*/ 1830989 w 2899165"/>
              <a:gd name="connsiteY5" fmla="*/ 464265 h 946827"/>
              <a:gd name="connsiteX6" fmla="*/ 1819006 w 2899165"/>
              <a:gd name="connsiteY6" fmla="*/ 481778 h 946827"/>
              <a:gd name="connsiteX7" fmla="*/ 1641700 w 2899165"/>
              <a:gd name="connsiteY7" fmla="*/ 850873 h 946827"/>
              <a:gd name="connsiteX8" fmla="*/ 824299 w 2899165"/>
              <a:gd name="connsiteY8" fmla="*/ 938455 h 946827"/>
              <a:gd name="connsiteX9" fmla="*/ 25156 w 2899165"/>
              <a:gd name="connsiteY9" fmla="*/ 692492 h 946827"/>
              <a:gd name="connsiteX0" fmla="*/ 25156 w 2899165"/>
              <a:gd name="connsiteY0" fmla="*/ 692492 h 946827"/>
              <a:gd name="connsiteX1" fmla="*/ 271746 w 2899165"/>
              <a:gd name="connsiteY1" fmla="*/ 472414 h 946827"/>
              <a:gd name="connsiteX2" fmla="*/ 814873 w 2899165"/>
              <a:gd name="connsiteY2" fmla="*/ 636476 h 946827"/>
              <a:gd name="connsiteX3" fmla="*/ 1554128 w 2899165"/>
              <a:gd name="connsiteY3" fmla="*/ 520852 h 946827"/>
              <a:gd name="connsiteX4" fmla="*/ 2898586 w 2899165"/>
              <a:gd name="connsiteY4" fmla="*/ 74 h 946827"/>
              <a:gd name="connsiteX5" fmla="*/ 1830989 w 2899165"/>
              <a:gd name="connsiteY5" fmla="*/ 464265 h 946827"/>
              <a:gd name="connsiteX6" fmla="*/ 2157206 w 2899165"/>
              <a:gd name="connsiteY6" fmla="*/ 511399 h 946827"/>
              <a:gd name="connsiteX7" fmla="*/ 1641700 w 2899165"/>
              <a:gd name="connsiteY7" fmla="*/ 850873 h 946827"/>
              <a:gd name="connsiteX8" fmla="*/ 824299 w 2899165"/>
              <a:gd name="connsiteY8" fmla="*/ 938455 h 946827"/>
              <a:gd name="connsiteX9" fmla="*/ 25156 w 2899165"/>
              <a:gd name="connsiteY9" fmla="*/ 692492 h 946827"/>
              <a:gd name="connsiteX0" fmla="*/ 25156 w 2899532"/>
              <a:gd name="connsiteY0" fmla="*/ 692492 h 1076008"/>
              <a:gd name="connsiteX1" fmla="*/ 271746 w 2899532"/>
              <a:gd name="connsiteY1" fmla="*/ 472414 h 1076008"/>
              <a:gd name="connsiteX2" fmla="*/ 814873 w 2899532"/>
              <a:gd name="connsiteY2" fmla="*/ 636476 h 1076008"/>
              <a:gd name="connsiteX3" fmla="*/ 1554128 w 2899532"/>
              <a:gd name="connsiteY3" fmla="*/ 520852 h 1076008"/>
              <a:gd name="connsiteX4" fmla="*/ 2898586 w 2899532"/>
              <a:gd name="connsiteY4" fmla="*/ 74 h 1076008"/>
              <a:gd name="connsiteX5" fmla="*/ 2267744 w 2899532"/>
              <a:gd name="connsiteY5" fmla="*/ 1075802 h 1076008"/>
              <a:gd name="connsiteX6" fmla="*/ 2157206 w 2899532"/>
              <a:gd name="connsiteY6" fmla="*/ 511399 h 1076008"/>
              <a:gd name="connsiteX7" fmla="*/ 1641700 w 2899532"/>
              <a:gd name="connsiteY7" fmla="*/ 850873 h 1076008"/>
              <a:gd name="connsiteX8" fmla="*/ 824299 w 2899532"/>
              <a:gd name="connsiteY8" fmla="*/ 938455 h 1076008"/>
              <a:gd name="connsiteX9" fmla="*/ 25156 w 2899532"/>
              <a:gd name="connsiteY9" fmla="*/ 692492 h 1076008"/>
              <a:gd name="connsiteX0" fmla="*/ 25156 w 2899532"/>
              <a:gd name="connsiteY0" fmla="*/ 692492 h 1076008"/>
              <a:gd name="connsiteX1" fmla="*/ 271746 w 2899532"/>
              <a:gd name="connsiteY1" fmla="*/ 472414 h 1076008"/>
              <a:gd name="connsiteX2" fmla="*/ 814873 w 2899532"/>
              <a:gd name="connsiteY2" fmla="*/ 636476 h 1076008"/>
              <a:gd name="connsiteX3" fmla="*/ 1554128 w 2899532"/>
              <a:gd name="connsiteY3" fmla="*/ 520852 h 1076008"/>
              <a:gd name="connsiteX4" fmla="*/ 2898586 w 2899532"/>
              <a:gd name="connsiteY4" fmla="*/ 74 h 1076008"/>
              <a:gd name="connsiteX5" fmla="*/ 2267744 w 2899532"/>
              <a:gd name="connsiteY5" fmla="*/ 1075802 h 1076008"/>
              <a:gd name="connsiteX6" fmla="*/ 2127922 w 2899532"/>
              <a:gd name="connsiteY6" fmla="*/ 718844 h 1076008"/>
              <a:gd name="connsiteX7" fmla="*/ 1641700 w 2899532"/>
              <a:gd name="connsiteY7" fmla="*/ 850873 h 1076008"/>
              <a:gd name="connsiteX8" fmla="*/ 824299 w 2899532"/>
              <a:gd name="connsiteY8" fmla="*/ 938455 h 1076008"/>
              <a:gd name="connsiteX9" fmla="*/ 25156 w 2899532"/>
              <a:gd name="connsiteY9" fmla="*/ 692492 h 1076008"/>
              <a:gd name="connsiteX0" fmla="*/ 25156 w 2899719"/>
              <a:gd name="connsiteY0" fmla="*/ 692492 h 1166610"/>
              <a:gd name="connsiteX1" fmla="*/ 271746 w 2899719"/>
              <a:gd name="connsiteY1" fmla="*/ 472414 h 1166610"/>
              <a:gd name="connsiteX2" fmla="*/ 814873 w 2899719"/>
              <a:gd name="connsiteY2" fmla="*/ 636476 h 1166610"/>
              <a:gd name="connsiteX3" fmla="*/ 1554128 w 2899719"/>
              <a:gd name="connsiteY3" fmla="*/ 520852 h 1166610"/>
              <a:gd name="connsiteX4" fmla="*/ 2898586 w 2899719"/>
              <a:gd name="connsiteY4" fmla="*/ 74 h 1166610"/>
              <a:gd name="connsiteX5" fmla="*/ 2267744 w 2899719"/>
              <a:gd name="connsiteY5" fmla="*/ 1075802 h 1166610"/>
              <a:gd name="connsiteX6" fmla="*/ 2269074 w 2899719"/>
              <a:gd name="connsiteY6" fmla="*/ 1066374 h 1166610"/>
              <a:gd name="connsiteX7" fmla="*/ 2127922 w 2899719"/>
              <a:gd name="connsiteY7" fmla="*/ 718844 h 1166610"/>
              <a:gd name="connsiteX8" fmla="*/ 1641700 w 2899719"/>
              <a:gd name="connsiteY8" fmla="*/ 850873 h 1166610"/>
              <a:gd name="connsiteX9" fmla="*/ 824299 w 2899719"/>
              <a:gd name="connsiteY9" fmla="*/ 938455 h 1166610"/>
              <a:gd name="connsiteX10" fmla="*/ 25156 w 2899719"/>
              <a:gd name="connsiteY10" fmla="*/ 692492 h 1166610"/>
              <a:gd name="connsiteX0" fmla="*/ 25156 w 2899719"/>
              <a:gd name="connsiteY0" fmla="*/ 692492 h 1269777"/>
              <a:gd name="connsiteX1" fmla="*/ 271746 w 2899719"/>
              <a:gd name="connsiteY1" fmla="*/ 472414 h 1269777"/>
              <a:gd name="connsiteX2" fmla="*/ 814873 w 2899719"/>
              <a:gd name="connsiteY2" fmla="*/ 636476 h 1269777"/>
              <a:gd name="connsiteX3" fmla="*/ 1554128 w 2899719"/>
              <a:gd name="connsiteY3" fmla="*/ 520852 h 1269777"/>
              <a:gd name="connsiteX4" fmla="*/ 2898586 w 2899719"/>
              <a:gd name="connsiteY4" fmla="*/ 74 h 1269777"/>
              <a:gd name="connsiteX5" fmla="*/ 2267744 w 2899719"/>
              <a:gd name="connsiteY5" fmla="*/ 1075802 h 1269777"/>
              <a:gd name="connsiteX6" fmla="*/ 2269074 w 2899719"/>
              <a:gd name="connsiteY6" fmla="*/ 1066374 h 1269777"/>
              <a:gd name="connsiteX7" fmla="*/ 2127922 w 2899719"/>
              <a:gd name="connsiteY7" fmla="*/ 718844 h 1269777"/>
              <a:gd name="connsiteX8" fmla="*/ 1641700 w 2899719"/>
              <a:gd name="connsiteY8" fmla="*/ 850873 h 1269777"/>
              <a:gd name="connsiteX9" fmla="*/ 824299 w 2899719"/>
              <a:gd name="connsiteY9" fmla="*/ 938455 h 1269777"/>
              <a:gd name="connsiteX10" fmla="*/ 25156 w 2899719"/>
              <a:gd name="connsiteY10" fmla="*/ 692492 h 1269777"/>
              <a:gd name="connsiteX0" fmla="*/ 25156 w 3499257"/>
              <a:gd name="connsiteY0" fmla="*/ 692492 h 1523659"/>
              <a:gd name="connsiteX1" fmla="*/ 271746 w 3499257"/>
              <a:gd name="connsiteY1" fmla="*/ 472414 h 1523659"/>
              <a:gd name="connsiteX2" fmla="*/ 814873 w 3499257"/>
              <a:gd name="connsiteY2" fmla="*/ 636476 h 1523659"/>
              <a:gd name="connsiteX3" fmla="*/ 1554128 w 3499257"/>
              <a:gd name="connsiteY3" fmla="*/ 520852 h 1523659"/>
              <a:gd name="connsiteX4" fmla="*/ 2898586 w 3499257"/>
              <a:gd name="connsiteY4" fmla="*/ 74 h 1523659"/>
              <a:gd name="connsiteX5" fmla="*/ 2267744 w 3499257"/>
              <a:gd name="connsiteY5" fmla="*/ 1075802 h 1523659"/>
              <a:gd name="connsiteX6" fmla="*/ 3020048 w 3499257"/>
              <a:gd name="connsiteY6" fmla="*/ 1405795 h 1523659"/>
              <a:gd name="connsiteX7" fmla="*/ 2127922 w 3499257"/>
              <a:gd name="connsiteY7" fmla="*/ 718844 h 1523659"/>
              <a:gd name="connsiteX8" fmla="*/ 1641700 w 3499257"/>
              <a:gd name="connsiteY8" fmla="*/ 850873 h 1523659"/>
              <a:gd name="connsiteX9" fmla="*/ 824299 w 3499257"/>
              <a:gd name="connsiteY9" fmla="*/ 938455 h 1523659"/>
              <a:gd name="connsiteX10" fmla="*/ 25156 w 3499257"/>
              <a:gd name="connsiteY10" fmla="*/ 692492 h 1523659"/>
              <a:gd name="connsiteX0" fmla="*/ 25156 w 3549506"/>
              <a:gd name="connsiteY0" fmla="*/ 692492 h 1523659"/>
              <a:gd name="connsiteX1" fmla="*/ 271746 w 3549506"/>
              <a:gd name="connsiteY1" fmla="*/ 472414 h 1523659"/>
              <a:gd name="connsiteX2" fmla="*/ 814873 w 3549506"/>
              <a:gd name="connsiteY2" fmla="*/ 636476 h 1523659"/>
              <a:gd name="connsiteX3" fmla="*/ 1554128 w 3549506"/>
              <a:gd name="connsiteY3" fmla="*/ 520852 h 1523659"/>
              <a:gd name="connsiteX4" fmla="*/ 2898586 w 3549506"/>
              <a:gd name="connsiteY4" fmla="*/ 74 h 1523659"/>
              <a:gd name="connsiteX5" fmla="*/ 2267744 w 3549506"/>
              <a:gd name="connsiteY5" fmla="*/ 1075802 h 1523659"/>
              <a:gd name="connsiteX6" fmla="*/ 3020048 w 3549506"/>
              <a:gd name="connsiteY6" fmla="*/ 1405795 h 1523659"/>
              <a:gd name="connsiteX7" fmla="*/ 2127922 w 3549506"/>
              <a:gd name="connsiteY7" fmla="*/ 718844 h 1523659"/>
              <a:gd name="connsiteX8" fmla="*/ 1641700 w 3549506"/>
              <a:gd name="connsiteY8" fmla="*/ 850873 h 1523659"/>
              <a:gd name="connsiteX9" fmla="*/ 824299 w 3549506"/>
              <a:gd name="connsiteY9" fmla="*/ 938455 h 1523659"/>
              <a:gd name="connsiteX10" fmla="*/ 25156 w 3549506"/>
              <a:gd name="connsiteY10" fmla="*/ 692492 h 1523659"/>
              <a:gd name="connsiteX0" fmla="*/ 25156 w 5725789"/>
              <a:gd name="connsiteY0" fmla="*/ 692492 h 1376161"/>
              <a:gd name="connsiteX1" fmla="*/ 271746 w 5725789"/>
              <a:gd name="connsiteY1" fmla="*/ 472414 h 1376161"/>
              <a:gd name="connsiteX2" fmla="*/ 814873 w 5725789"/>
              <a:gd name="connsiteY2" fmla="*/ 636476 h 1376161"/>
              <a:gd name="connsiteX3" fmla="*/ 1554128 w 5725789"/>
              <a:gd name="connsiteY3" fmla="*/ 520852 h 1376161"/>
              <a:gd name="connsiteX4" fmla="*/ 2898586 w 5725789"/>
              <a:gd name="connsiteY4" fmla="*/ 74 h 1376161"/>
              <a:gd name="connsiteX5" fmla="*/ 2267744 w 5725789"/>
              <a:gd name="connsiteY5" fmla="*/ 1075802 h 1376161"/>
              <a:gd name="connsiteX6" fmla="*/ 5414059 w 5725789"/>
              <a:gd name="connsiteY6" fmla="*/ 1222495 h 1376161"/>
              <a:gd name="connsiteX7" fmla="*/ 2127922 w 5725789"/>
              <a:gd name="connsiteY7" fmla="*/ 718844 h 1376161"/>
              <a:gd name="connsiteX8" fmla="*/ 1641700 w 5725789"/>
              <a:gd name="connsiteY8" fmla="*/ 850873 h 1376161"/>
              <a:gd name="connsiteX9" fmla="*/ 824299 w 5725789"/>
              <a:gd name="connsiteY9" fmla="*/ 938455 h 1376161"/>
              <a:gd name="connsiteX10" fmla="*/ 25156 w 5725789"/>
              <a:gd name="connsiteY10" fmla="*/ 692492 h 1376161"/>
              <a:gd name="connsiteX0" fmla="*/ 25156 w 5725789"/>
              <a:gd name="connsiteY0" fmla="*/ 692492 h 1583892"/>
              <a:gd name="connsiteX1" fmla="*/ 271746 w 5725789"/>
              <a:gd name="connsiteY1" fmla="*/ 472414 h 1583892"/>
              <a:gd name="connsiteX2" fmla="*/ 814873 w 5725789"/>
              <a:gd name="connsiteY2" fmla="*/ 636476 h 1583892"/>
              <a:gd name="connsiteX3" fmla="*/ 1554128 w 5725789"/>
              <a:gd name="connsiteY3" fmla="*/ 520852 h 1583892"/>
              <a:gd name="connsiteX4" fmla="*/ 2898586 w 5725789"/>
              <a:gd name="connsiteY4" fmla="*/ 74 h 1583892"/>
              <a:gd name="connsiteX5" fmla="*/ 2267744 w 5725789"/>
              <a:gd name="connsiteY5" fmla="*/ 1075802 h 1583892"/>
              <a:gd name="connsiteX6" fmla="*/ 5414059 w 5725789"/>
              <a:gd name="connsiteY6" fmla="*/ 1222495 h 1583892"/>
              <a:gd name="connsiteX7" fmla="*/ 2127922 w 5725789"/>
              <a:gd name="connsiteY7" fmla="*/ 718844 h 1583892"/>
              <a:gd name="connsiteX8" fmla="*/ 1641700 w 5725789"/>
              <a:gd name="connsiteY8" fmla="*/ 850873 h 1583892"/>
              <a:gd name="connsiteX9" fmla="*/ 824299 w 5725789"/>
              <a:gd name="connsiteY9" fmla="*/ 938455 h 1583892"/>
              <a:gd name="connsiteX10" fmla="*/ 25156 w 5725789"/>
              <a:gd name="connsiteY10" fmla="*/ 692492 h 1583892"/>
              <a:gd name="connsiteX0" fmla="*/ 25156 w 6071585"/>
              <a:gd name="connsiteY0" fmla="*/ 865121 h 1589494"/>
              <a:gd name="connsiteX1" fmla="*/ 271746 w 6071585"/>
              <a:gd name="connsiteY1" fmla="*/ 645043 h 1589494"/>
              <a:gd name="connsiteX2" fmla="*/ 814873 w 6071585"/>
              <a:gd name="connsiteY2" fmla="*/ 809105 h 1589494"/>
              <a:gd name="connsiteX3" fmla="*/ 1554128 w 6071585"/>
              <a:gd name="connsiteY3" fmla="*/ 693481 h 1589494"/>
              <a:gd name="connsiteX4" fmla="*/ 2898586 w 6071585"/>
              <a:gd name="connsiteY4" fmla="*/ 172703 h 1589494"/>
              <a:gd name="connsiteX5" fmla="*/ 6069096 w 6071585"/>
              <a:gd name="connsiteY5" fmla="*/ 56139 h 1589494"/>
              <a:gd name="connsiteX6" fmla="*/ 5414059 w 6071585"/>
              <a:gd name="connsiteY6" fmla="*/ 1395124 h 1589494"/>
              <a:gd name="connsiteX7" fmla="*/ 2127922 w 6071585"/>
              <a:gd name="connsiteY7" fmla="*/ 891473 h 1589494"/>
              <a:gd name="connsiteX8" fmla="*/ 1641700 w 6071585"/>
              <a:gd name="connsiteY8" fmla="*/ 1023502 h 1589494"/>
              <a:gd name="connsiteX9" fmla="*/ 824299 w 6071585"/>
              <a:gd name="connsiteY9" fmla="*/ 1111084 h 1589494"/>
              <a:gd name="connsiteX10" fmla="*/ 25156 w 6071585"/>
              <a:gd name="connsiteY10" fmla="*/ 865121 h 1589494"/>
              <a:gd name="connsiteX0" fmla="*/ 25156 w 6071585"/>
              <a:gd name="connsiteY0" fmla="*/ 865121 h 1688123"/>
              <a:gd name="connsiteX1" fmla="*/ 271746 w 6071585"/>
              <a:gd name="connsiteY1" fmla="*/ 645043 h 1688123"/>
              <a:gd name="connsiteX2" fmla="*/ 814873 w 6071585"/>
              <a:gd name="connsiteY2" fmla="*/ 809105 h 1688123"/>
              <a:gd name="connsiteX3" fmla="*/ 1554128 w 6071585"/>
              <a:gd name="connsiteY3" fmla="*/ 693481 h 1688123"/>
              <a:gd name="connsiteX4" fmla="*/ 2898586 w 6071585"/>
              <a:gd name="connsiteY4" fmla="*/ 172703 h 1688123"/>
              <a:gd name="connsiteX5" fmla="*/ 6069096 w 6071585"/>
              <a:gd name="connsiteY5" fmla="*/ 56139 h 1688123"/>
              <a:gd name="connsiteX6" fmla="*/ 5551208 w 6071585"/>
              <a:gd name="connsiteY6" fmla="*/ 1501534 h 1688123"/>
              <a:gd name="connsiteX7" fmla="*/ 2127922 w 6071585"/>
              <a:gd name="connsiteY7" fmla="*/ 891473 h 1688123"/>
              <a:gd name="connsiteX8" fmla="*/ 1641700 w 6071585"/>
              <a:gd name="connsiteY8" fmla="*/ 1023502 h 1688123"/>
              <a:gd name="connsiteX9" fmla="*/ 824299 w 6071585"/>
              <a:gd name="connsiteY9" fmla="*/ 1111084 h 1688123"/>
              <a:gd name="connsiteX10" fmla="*/ 25156 w 6071585"/>
              <a:gd name="connsiteY10" fmla="*/ 865121 h 1688123"/>
              <a:gd name="connsiteX0" fmla="*/ 25156 w 6071585"/>
              <a:gd name="connsiteY0" fmla="*/ 865121 h 1688123"/>
              <a:gd name="connsiteX1" fmla="*/ 271746 w 6071585"/>
              <a:gd name="connsiteY1" fmla="*/ 645043 h 1688123"/>
              <a:gd name="connsiteX2" fmla="*/ 814873 w 6071585"/>
              <a:gd name="connsiteY2" fmla="*/ 809105 h 1688123"/>
              <a:gd name="connsiteX3" fmla="*/ 1554128 w 6071585"/>
              <a:gd name="connsiteY3" fmla="*/ 693481 h 1688123"/>
              <a:gd name="connsiteX4" fmla="*/ 2898586 w 6071585"/>
              <a:gd name="connsiteY4" fmla="*/ 172703 h 1688123"/>
              <a:gd name="connsiteX5" fmla="*/ 6069096 w 6071585"/>
              <a:gd name="connsiteY5" fmla="*/ 56139 h 1688123"/>
              <a:gd name="connsiteX6" fmla="*/ 5551208 w 6071585"/>
              <a:gd name="connsiteY6" fmla="*/ 1501534 h 1688123"/>
              <a:gd name="connsiteX7" fmla="*/ 2127922 w 6071585"/>
              <a:gd name="connsiteY7" fmla="*/ 891473 h 1688123"/>
              <a:gd name="connsiteX8" fmla="*/ 1641700 w 6071585"/>
              <a:gd name="connsiteY8" fmla="*/ 1023502 h 1688123"/>
              <a:gd name="connsiteX9" fmla="*/ 824299 w 6071585"/>
              <a:gd name="connsiteY9" fmla="*/ 1111084 h 1688123"/>
              <a:gd name="connsiteX10" fmla="*/ 25156 w 6071585"/>
              <a:gd name="connsiteY10" fmla="*/ 865121 h 1688123"/>
              <a:gd name="connsiteX0" fmla="*/ 25156 w 6178410"/>
              <a:gd name="connsiteY0" fmla="*/ 898339 h 1724780"/>
              <a:gd name="connsiteX1" fmla="*/ 271746 w 6178410"/>
              <a:gd name="connsiteY1" fmla="*/ 678261 h 1724780"/>
              <a:gd name="connsiteX2" fmla="*/ 814873 w 6178410"/>
              <a:gd name="connsiteY2" fmla="*/ 842323 h 1724780"/>
              <a:gd name="connsiteX3" fmla="*/ 1554128 w 6178410"/>
              <a:gd name="connsiteY3" fmla="*/ 726699 h 1724780"/>
              <a:gd name="connsiteX4" fmla="*/ 2898586 w 6178410"/>
              <a:gd name="connsiteY4" fmla="*/ 205921 h 1724780"/>
              <a:gd name="connsiteX5" fmla="*/ 3234357 w 6178410"/>
              <a:gd name="connsiteY5" fmla="*/ 160874 h 1724780"/>
              <a:gd name="connsiteX6" fmla="*/ 6069096 w 6178410"/>
              <a:gd name="connsiteY6" fmla="*/ 89357 h 1724780"/>
              <a:gd name="connsiteX7" fmla="*/ 5551208 w 6178410"/>
              <a:gd name="connsiteY7" fmla="*/ 1534752 h 1724780"/>
              <a:gd name="connsiteX8" fmla="*/ 2127922 w 6178410"/>
              <a:gd name="connsiteY8" fmla="*/ 924691 h 1724780"/>
              <a:gd name="connsiteX9" fmla="*/ 1641700 w 6178410"/>
              <a:gd name="connsiteY9" fmla="*/ 1056720 h 1724780"/>
              <a:gd name="connsiteX10" fmla="*/ 824299 w 6178410"/>
              <a:gd name="connsiteY10" fmla="*/ 1144302 h 1724780"/>
              <a:gd name="connsiteX11" fmla="*/ 25156 w 6178410"/>
              <a:gd name="connsiteY11" fmla="*/ 898339 h 1724780"/>
              <a:gd name="connsiteX0" fmla="*/ 25156 w 6178410"/>
              <a:gd name="connsiteY0" fmla="*/ 890047 h 1716488"/>
              <a:gd name="connsiteX1" fmla="*/ 271746 w 6178410"/>
              <a:gd name="connsiteY1" fmla="*/ 669969 h 1716488"/>
              <a:gd name="connsiteX2" fmla="*/ 814873 w 6178410"/>
              <a:gd name="connsiteY2" fmla="*/ 834031 h 1716488"/>
              <a:gd name="connsiteX3" fmla="*/ 1554128 w 6178410"/>
              <a:gd name="connsiteY3" fmla="*/ 718407 h 1716488"/>
              <a:gd name="connsiteX4" fmla="*/ 2898586 w 6178410"/>
              <a:gd name="connsiteY4" fmla="*/ 197629 h 1716488"/>
              <a:gd name="connsiteX5" fmla="*/ 4150424 w 6178410"/>
              <a:gd name="connsiteY5" fmla="*/ 198342 h 1716488"/>
              <a:gd name="connsiteX6" fmla="*/ 6069096 w 6178410"/>
              <a:gd name="connsiteY6" fmla="*/ 81065 h 1716488"/>
              <a:gd name="connsiteX7" fmla="*/ 5551208 w 6178410"/>
              <a:gd name="connsiteY7" fmla="*/ 1526460 h 1716488"/>
              <a:gd name="connsiteX8" fmla="*/ 2127922 w 6178410"/>
              <a:gd name="connsiteY8" fmla="*/ 916399 h 1716488"/>
              <a:gd name="connsiteX9" fmla="*/ 1641700 w 6178410"/>
              <a:gd name="connsiteY9" fmla="*/ 1048428 h 1716488"/>
              <a:gd name="connsiteX10" fmla="*/ 824299 w 6178410"/>
              <a:gd name="connsiteY10" fmla="*/ 1136010 h 1716488"/>
              <a:gd name="connsiteX11" fmla="*/ 25156 w 6178410"/>
              <a:gd name="connsiteY11" fmla="*/ 890047 h 1716488"/>
              <a:gd name="connsiteX0" fmla="*/ 25156 w 6186008"/>
              <a:gd name="connsiteY0" fmla="*/ 890047 h 1896060"/>
              <a:gd name="connsiteX1" fmla="*/ 271746 w 6186008"/>
              <a:gd name="connsiteY1" fmla="*/ 669969 h 1896060"/>
              <a:gd name="connsiteX2" fmla="*/ 814873 w 6186008"/>
              <a:gd name="connsiteY2" fmla="*/ 834031 h 1896060"/>
              <a:gd name="connsiteX3" fmla="*/ 1554128 w 6186008"/>
              <a:gd name="connsiteY3" fmla="*/ 718407 h 1896060"/>
              <a:gd name="connsiteX4" fmla="*/ 2898586 w 6186008"/>
              <a:gd name="connsiteY4" fmla="*/ 197629 h 1896060"/>
              <a:gd name="connsiteX5" fmla="*/ 4150424 w 6186008"/>
              <a:gd name="connsiteY5" fmla="*/ 198342 h 1896060"/>
              <a:gd name="connsiteX6" fmla="*/ 6069096 w 6186008"/>
              <a:gd name="connsiteY6" fmla="*/ 81065 h 1896060"/>
              <a:gd name="connsiteX7" fmla="*/ 5619122 w 6186008"/>
              <a:gd name="connsiteY7" fmla="*/ 1719084 h 1896060"/>
              <a:gd name="connsiteX8" fmla="*/ 2127922 w 6186008"/>
              <a:gd name="connsiteY8" fmla="*/ 916399 h 1896060"/>
              <a:gd name="connsiteX9" fmla="*/ 1641700 w 6186008"/>
              <a:gd name="connsiteY9" fmla="*/ 1048428 h 1896060"/>
              <a:gd name="connsiteX10" fmla="*/ 824299 w 6186008"/>
              <a:gd name="connsiteY10" fmla="*/ 1136010 h 1896060"/>
              <a:gd name="connsiteX11" fmla="*/ 25156 w 6186008"/>
              <a:gd name="connsiteY11" fmla="*/ 890047 h 1896060"/>
              <a:gd name="connsiteX0" fmla="*/ 25156 w 6403793"/>
              <a:gd name="connsiteY0" fmla="*/ 890047 h 1731341"/>
              <a:gd name="connsiteX1" fmla="*/ 271746 w 6403793"/>
              <a:gd name="connsiteY1" fmla="*/ 669969 h 1731341"/>
              <a:gd name="connsiteX2" fmla="*/ 814873 w 6403793"/>
              <a:gd name="connsiteY2" fmla="*/ 834031 h 1731341"/>
              <a:gd name="connsiteX3" fmla="*/ 1554128 w 6403793"/>
              <a:gd name="connsiteY3" fmla="*/ 718407 h 1731341"/>
              <a:gd name="connsiteX4" fmla="*/ 2898586 w 6403793"/>
              <a:gd name="connsiteY4" fmla="*/ 197629 h 1731341"/>
              <a:gd name="connsiteX5" fmla="*/ 4150424 w 6403793"/>
              <a:gd name="connsiteY5" fmla="*/ 198342 h 1731341"/>
              <a:gd name="connsiteX6" fmla="*/ 6069096 w 6403793"/>
              <a:gd name="connsiteY6" fmla="*/ 81065 h 1731341"/>
              <a:gd name="connsiteX7" fmla="*/ 5619122 w 6403793"/>
              <a:gd name="connsiteY7" fmla="*/ 1719084 h 1731341"/>
              <a:gd name="connsiteX8" fmla="*/ 2127922 w 6403793"/>
              <a:gd name="connsiteY8" fmla="*/ 916399 h 1731341"/>
              <a:gd name="connsiteX9" fmla="*/ 1641700 w 6403793"/>
              <a:gd name="connsiteY9" fmla="*/ 1048428 h 1731341"/>
              <a:gd name="connsiteX10" fmla="*/ 824299 w 6403793"/>
              <a:gd name="connsiteY10" fmla="*/ 1136010 h 1731341"/>
              <a:gd name="connsiteX11" fmla="*/ 25156 w 6403793"/>
              <a:gd name="connsiteY11" fmla="*/ 890047 h 1731341"/>
              <a:gd name="connsiteX0" fmla="*/ 25156 w 6403793"/>
              <a:gd name="connsiteY0" fmla="*/ 890047 h 1721264"/>
              <a:gd name="connsiteX1" fmla="*/ 271746 w 6403793"/>
              <a:gd name="connsiteY1" fmla="*/ 669969 h 1721264"/>
              <a:gd name="connsiteX2" fmla="*/ 814873 w 6403793"/>
              <a:gd name="connsiteY2" fmla="*/ 834031 h 1721264"/>
              <a:gd name="connsiteX3" fmla="*/ 1554128 w 6403793"/>
              <a:gd name="connsiteY3" fmla="*/ 718407 h 1721264"/>
              <a:gd name="connsiteX4" fmla="*/ 2898586 w 6403793"/>
              <a:gd name="connsiteY4" fmla="*/ 197629 h 1721264"/>
              <a:gd name="connsiteX5" fmla="*/ 4150424 w 6403793"/>
              <a:gd name="connsiteY5" fmla="*/ 198342 h 1721264"/>
              <a:gd name="connsiteX6" fmla="*/ 6069096 w 6403793"/>
              <a:gd name="connsiteY6" fmla="*/ 81065 h 1721264"/>
              <a:gd name="connsiteX7" fmla="*/ 5619122 w 6403793"/>
              <a:gd name="connsiteY7" fmla="*/ 1719084 h 1721264"/>
              <a:gd name="connsiteX8" fmla="*/ 2127922 w 6403793"/>
              <a:gd name="connsiteY8" fmla="*/ 916399 h 1721264"/>
              <a:gd name="connsiteX9" fmla="*/ 1641700 w 6403793"/>
              <a:gd name="connsiteY9" fmla="*/ 1048428 h 1721264"/>
              <a:gd name="connsiteX10" fmla="*/ 824299 w 6403793"/>
              <a:gd name="connsiteY10" fmla="*/ 1136010 h 1721264"/>
              <a:gd name="connsiteX11" fmla="*/ 25156 w 6403793"/>
              <a:gd name="connsiteY11" fmla="*/ 890047 h 1721264"/>
              <a:gd name="connsiteX0" fmla="*/ 25156 w 6178616"/>
              <a:gd name="connsiteY0" fmla="*/ 890047 h 1890558"/>
              <a:gd name="connsiteX1" fmla="*/ 271746 w 6178616"/>
              <a:gd name="connsiteY1" fmla="*/ 669969 h 1890558"/>
              <a:gd name="connsiteX2" fmla="*/ 814873 w 6178616"/>
              <a:gd name="connsiteY2" fmla="*/ 834031 h 1890558"/>
              <a:gd name="connsiteX3" fmla="*/ 1554128 w 6178616"/>
              <a:gd name="connsiteY3" fmla="*/ 718407 h 1890558"/>
              <a:gd name="connsiteX4" fmla="*/ 2898586 w 6178616"/>
              <a:gd name="connsiteY4" fmla="*/ 197629 h 1890558"/>
              <a:gd name="connsiteX5" fmla="*/ 4150424 w 6178616"/>
              <a:gd name="connsiteY5" fmla="*/ 198342 h 1890558"/>
              <a:gd name="connsiteX6" fmla="*/ 6069096 w 6178616"/>
              <a:gd name="connsiteY6" fmla="*/ 81065 h 1890558"/>
              <a:gd name="connsiteX7" fmla="*/ 5619122 w 6178616"/>
              <a:gd name="connsiteY7" fmla="*/ 1719084 h 1890558"/>
              <a:gd name="connsiteX8" fmla="*/ 5567192 w 6178616"/>
              <a:gd name="connsiteY8" fmla="*/ 1750068 h 1890558"/>
              <a:gd name="connsiteX9" fmla="*/ 2127922 w 6178616"/>
              <a:gd name="connsiteY9" fmla="*/ 916399 h 1890558"/>
              <a:gd name="connsiteX10" fmla="*/ 1641700 w 6178616"/>
              <a:gd name="connsiteY10" fmla="*/ 1048428 h 1890558"/>
              <a:gd name="connsiteX11" fmla="*/ 824299 w 6178616"/>
              <a:gd name="connsiteY11" fmla="*/ 1136010 h 1890558"/>
              <a:gd name="connsiteX12" fmla="*/ 25156 w 6178616"/>
              <a:gd name="connsiteY12" fmla="*/ 890047 h 1890558"/>
              <a:gd name="connsiteX0" fmla="*/ 25156 w 6178616"/>
              <a:gd name="connsiteY0" fmla="*/ 890047 h 1826036"/>
              <a:gd name="connsiteX1" fmla="*/ 271746 w 6178616"/>
              <a:gd name="connsiteY1" fmla="*/ 669969 h 1826036"/>
              <a:gd name="connsiteX2" fmla="*/ 814873 w 6178616"/>
              <a:gd name="connsiteY2" fmla="*/ 834031 h 1826036"/>
              <a:gd name="connsiteX3" fmla="*/ 1554128 w 6178616"/>
              <a:gd name="connsiteY3" fmla="*/ 718407 h 1826036"/>
              <a:gd name="connsiteX4" fmla="*/ 2898586 w 6178616"/>
              <a:gd name="connsiteY4" fmla="*/ 197629 h 1826036"/>
              <a:gd name="connsiteX5" fmla="*/ 4150424 w 6178616"/>
              <a:gd name="connsiteY5" fmla="*/ 198342 h 1826036"/>
              <a:gd name="connsiteX6" fmla="*/ 6069096 w 6178616"/>
              <a:gd name="connsiteY6" fmla="*/ 81065 h 1826036"/>
              <a:gd name="connsiteX7" fmla="*/ 5619122 w 6178616"/>
              <a:gd name="connsiteY7" fmla="*/ 1719084 h 1826036"/>
              <a:gd name="connsiteX8" fmla="*/ 4619165 w 6178616"/>
              <a:gd name="connsiteY8" fmla="*/ 1526500 h 1826036"/>
              <a:gd name="connsiteX9" fmla="*/ 2127922 w 6178616"/>
              <a:gd name="connsiteY9" fmla="*/ 916399 h 1826036"/>
              <a:gd name="connsiteX10" fmla="*/ 1641700 w 6178616"/>
              <a:gd name="connsiteY10" fmla="*/ 1048428 h 1826036"/>
              <a:gd name="connsiteX11" fmla="*/ 824299 w 6178616"/>
              <a:gd name="connsiteY11" fmla="*/ 1136010 h 1826036"/>
              <a:gd name="connsiteX12" fmla="*/ 25156 w 6178616"/>
              <a:gd name="connsiteY12" fmla="*/ 890047 h 1826036"/>
              <a:gd name="connsiteX0" fmla="*/ 25156 w 6192037"/>
              <a:gd name="connsiteY0" fmla="*/ 890047 h 1645937"/>
              <a:gd name="connsiteX1" fmla="*/ 271746 w 6192037"/>
              <a:gd name="connsiteY1" fmla="*/ 669969 h 1645937"/>
              <a:gd name="connsiteX2" fmla="*/ 814873 w 6192037"/>
              <a:gd name="connsiteY2" fmla="*/ 834031 h 1645937"/>
              <a:gd name="connsiteX3" fmla="*/ 1554128 w 6192037"/>
              <a:gd name="connsiteY3" fmla="*/ 718407 h 1645937"/>
              <a:gd name="connsiteX4" fmla="*/ 2898586 w 6192037"/>
              <a:gd name="connsiteY4" fmla="*/ 197629 h 1645937"/>
              <a:gd name="connsiteX5" fmla="*/ 4150424 w 6192037"/>
              <a:gd name="connsiteY5" fmla="*/ 198342 h 1645937"/>
              <a:gd name="connsiteX6" fmla="*/ 6069096 w 6192037"/>
              <a:gd name="connsiteY6" fmla="*/ 81065 h 1645937"/>
              <a:gd name="connsiteX7" fmla="*/ 5732287 w 6192037"/>
              <a:gd name="connsiteY7" fmla="*/ 1456406 h 1645937"/>
              <a:gd name="connsiteX8" fmla="*/ 4619165 w 6192037"/>
              <a:gd name="connsiteY8" fmla="*/ 1526500 h 1645937"/>
              <a:gd name="connsiteX9" fmla="*/ 2127922 w 6192037"/>
              <a:gd name="connsiteY9" fmla="*/ 916399 h 1645937"/>
              <a:gd name="connsiteX10" fmla="*/ 1641700 w 6192037"/>
              <a:gd name="connsiteY10" fmla="*/ 1048428 h 1645937"/>
              <a:gd name="connsiteX11" fmla="*/ 824299 w 6192037"/>
              <a:gd name="connsiteY11" fmla="*/ 1136010 h 1645937"/>
              <a:gd name="connsiteX12" fmla="*/ 25156 w 6192037"/>
              <a:gd name="connsiteY12" fmla="*/ 890047 h 1645937"/>
              <a:gd name="connsiteX0" fmla="*/ 25156 w 6192037"/>
              <a:gd name="connsiteY0" fmla="*/ 890047 h 1645937"/>
              <a:gd name="connsiteX1" fmla="*/ 271746 w 6192037"/>
              <a:gd name="connsiteY1" fmla="*/ 669969 h 1645937"/>
              <a:gd name="connsiteX2" fmla="*/ 814873 w 6192037"/>
              <a:gd name="connsiteY2" fmla="*/ 834031 h 1645937"/>
              <a:gd name="connsiteX3" fmla="*/ 1554128 w 6192037"/>
              <a:gd name="connsiteY3" fmla="*/ 718407 h 1645937"/>
              <a:gd name="connsiteX4" fmla="*/ 2898586 w 6192037"/>
              <a:gd name="connsiteY4" fmla="*/ 197629 h 1645937"/>
              <a:gd name="connsiteX5" fmla="*/ 4150424 w 6192037"/>
              <a:gd name="connsiteY5" fmla="*/ 198342 h 1645937"/>
              <a:gd name="connsiteX6" fmla="*/ 6069096 w 6192037"/>
              <a:gd name="connsiteY6" fmla="*/ 81065 h 1645937"/>
              <a:gd name="connsiteX7" fmla="*/ 5732287 w 6192037"/>
              <a:gd name="connsiteY7" fmla="*/ 1456406 h 1645937"/>
              <a:gd name="connsiteX8" fmla="*/ 4619165 w 6192037"/>
              <a:gd name="connsiteY8" fmla="*/ 1526500 h 1645937"/>
              <a:gd name="connsiteX9" fmla="*/ 2342303 w 6192037"/>
              <a:gd name="connsiteY9" fmla="*/ 1149427 h 1645937"/>
              <a:gd name="connsiteX10" fmla="*/ 1641700 w 6192037"/>
              <a:gd name="connsiteY10" fmla="*/ 1048428 h 1645937"/>
              <a:gd name="connsiteX11" fmla="*/ 824299 w 6192037"/>
              <a:gd name="connsiteY11" fmla="*/ 1136010 h 1645937"/>
              <a:gd name="connsiteX12" fmla="*/ 25156 w 6192037"/>
              <a:gd name="connsiteY12" fmla="*/ 890047 h 1645937"/>
              <a:gd name="connsiteX0" fmla="*/ 25156 w 6192037"/>
              <a:gd name="connsiteY0" fmla="*/ 890047 h 1645937"/>
              <a:gd name="connsiteX1" fmla="*/ 271746 w 6192037"/>
              <a:gd name="connsiteY1" fmla="*/ 669969 h 1645937"/>
              <a:gd name="connsiteX2" fmla="*/ 814873 w 6192037"/>
              <a:gd name="connsiteY2" fmla="*/ 834031 h 1645937"/>
              <a:gd name="connsiteX3" fmla="*/ 1554128 w 6192037"/>
              <a:gd name="connsiteY3" fmla="*/ 718407 h 1645937"/>
              <a:gd name="connsiteX4" fmla="*/ 2898586 w 6192037"/>
              <a:gd name="connsiteY4" fmla="*/ 197629 h 1645937"/>
              <a:gd name="connsiteX5" fmla="*/ 4150424 w 6192037"/>
              <a:gd name="connsiteY5" fmla="*/ 198342 h 1645937"/>
              <a:gd name="connsiteX6" fmla="*/ 6069096 w 6192037"/>
              <a:gd name="connsiteY6" fmla="*/ 81065 h 1645937"/>
              <a:gd name="connsiteX7" fmla="*/ 5732287 w 6192037"/>
              <a:gd name="connsiteY7" fmla="*/ 1456406 h 1645937"/>
              <a:gd name="connsiteX8" fmla="*/ 4619165 w 6192037"/>
              <a:gd name="connsiteY8" fmla="*/ 1526500 h 1645937"/>
              <a:gd name="connsiteX9" fmla="*/ 2342303 w 6192037"/>
              <a:gd name="connsiteY9" fmla="*/ 1149427 h 1645937"/>
              <a:gd name="connsiteX10" fmla="*/ 1951938 w 6192037"/>
              <a:gd name="connsiteY10" fmla="*/ 1074008 h 1645937"/>
              <a:gd name="connsiteX11" fmla="*/ 824299 w 6192037"/>
              <a:gd name="connsiteY11" fmla="*/ 1136010 h 1645937"/>
              <a:gd name="connsiteX12" fmla="*/ 25156 w 6192037"/>
              <a:gd name="connsiteY12" fmla="*/ 890047 h 1645937"/>
              <a:gd name="connsiteX0" fmla="*/ 25156 w 6192037"/>
              <a:gd name="connsiteY0" fmla="*/ 890047 h 1645937"/>
              <a:gd name="connsiteX1" fmla="*/ 271746 w 6192037"/>
              <a:gd name="connsiteY1" fmla="*/ 669969 h 1645937"/>
              <a:gd name="connsiteX2" fmla="*/ 814873 w 6192037"/>
              <a:gd name="connsiteY2" fmla="*/ 834031 h 1645937"/>
              <a:gd name="connsiteX3" fmla="*/ 1554128 w 6192037"/>
              <a:gd name="connsiteY3" fmla="*/ 718407 h 1645937"/>
              <a:gd name="connsiteX4" fmla="*/ 2898586 w 6192037"/>
              <a:gd name="connsiteY4" fmla="*/ 197629 h 1645937"/>
              <a:gd name="connsiteX5" fmla="*/ 4150424 w 6192037"/>
              <a:gd name="connsiteY5" fmla="*/ 198342 h 1645937"/>
              <a:gd name="connsiteX6" fmla="*/ 6069096 w 6192037"/>
              <a:gd name="connsiteY6" fmla="*/ 81065 h 1645937"/>
              <a:gd name="connsiteX7" fmla="*/ 5732287 w 6192037"/>
              <a:gd name="connsiteY7" fmla="*/ 1456406 h 1645937"/>
              <a:gd name="connsiteX8" fmla="*/ 4619165 w 6192037"/>
              <a:gd name="connsiteY8" fmla="*/ 1526500 h 1645937"/>
              <a:gd name="connsiteX9" fmla="*/ 2342303 w 6192037"/>
              <a:gd name="connsiteY9" fmla="*/ 1149427 h 1645937"/>
              <a:gd name="connsiteX10" fmla="*/ 1951938 w 6192037"/>
              <a:gd name="connsiteY10" fmla="*/ 1074008 h 1645937"/>
              <a:gd name="connsiteX11" fmla="*/ 824299 w 6192037"/>
              <a:gd name="connsiteY11" fmla="*/ 1136010 h 1645937"/>
              <a:gd name="connsiteX12" fmla="*/ 25156 w 6192037"/>
              <a:gd name="connsiteY12" fmla="*/ 890047 h 1645937"/>
              <a:gd name="connsiteX0" fmla="*/ 25156 w 6192037"/>
              <a:gd name="connsiteY0" fmla="*/ 890047 h 1645937"/>
              <a:gd name="connsiteX1" fmla="*/ 271746 w 6192037"/>
              <a:gd name="connsiteY1" fmla="*/ 669969 h 1645937"/>
              <a:gd name="connsiteX2" fmla="*/ 814873 w 6192037"/>
              <a:gd name="connsiteY2" fmla="*/ 834031 h 1645937"/>
              <a:gd name="connsiteX3" fmla="*/ 1554128 w 6192037"/>
              <a:gd name="connsiteY3" fmla="*/ 718407 h 1645937"/>
              <a:gd name="connsiteX4" fmla="*/ 2898586 w 6192037"/>
              <a:gd name="connsiteY4" fmla="*/ 197629 h 1645937"/>
              <a:gd name="connsiteX5" fmla="*/ 4150424 w 6192037"/>
              <a:gd name="connsiteY5" fmla="*/ 198342 h 1645937"/>
              <a:gd name="connsiteX6" fmla="*/ 6069096 w 6192037"/>
              <a:gd name="connsiteY6" fmla="*/ 81065 h 1645937"/>
              <a:gd name="connsiteX7" fmla="*/ 5732287 w 6192037"/>
              <a:gd name="connsiteY7" fmla="*/ 1456406 h 1645937"/>
              <a:gd name="connsiteX8" fmla="*/ 4619165 w 6192037"/>
              <a:gd name="connsiteY8" fmla="*/ 1526500 h 1645937"/>
              <a:gd name="connsiteX9" fmla="*/ 2342303 w 6192037"/>
              <a:gd name="connsiteY9" fmla="*/ 1149427 h 1645937"/>
              <a:gd name="connsiteX10" fmla="*/ 1977237 w 6192037"/>
              <a:gd name="connsiteY10" fmla="*/ 1096906 h 1645937"/>
              <a:gd name="connsiteX11" fmla="*/ 824299 w 6192037"/>
              <a:gd name="connsiteY11" fmla="*/ 1136010 h 1645937"/>
              <a:gd name="connsiteX12" fmla="*/ 25156 w 6192037"/>
              <a:gd name="connsiteY12" fmla="*/ 890047 h 1645937"/>
              <a:gd name="connsiteX0" fmla="*/ 25156 w 6192037"/>
              <a:gd name="connsiteY0" fmla="*/ 890047 h 1645937"/>
              <a:gd name="connsiteX1" fmla="*/ 271746 w 6192037"/>
              <a:gd name="connsiteY1" fmla="*/ 669969 h 1645937"/>
              <a:gd name="connsiteX2" fmla="*/ 814873 w 6192037"/>
              <a:gd name="connsiteY2" fmla="*/ 834031 h 1645937"/>
              <a:gd name="connsiteX3" fmla="*/ 1554128 w 6192037"/>
              <a:gd name="connsiteY3" fmla="*/ 718407 h 1645937"/>
              <a:gd name="connsiteX4" fmla="*/ 2898586 w 6192037"/>
              <a:gd name="connsiteY4" fmla="*/ 197629 h 1645937"/>
              <a:gd name="connsiteX5" fmla="*/ 4150424 w 6192037"/>
              <a:gd name="connsiteY5" fmla="*/ 198342 h 1645937"/>
              <a:gd name="connsiteX6" fmla="*/ 6069096 w 6192037"/>
              <a:gd name="connsiteY6" fmla="*/ 81065 h 1645937"/>
              <a:gd name="connsiteX7" fmla="*/ 5732287 w 6192037"/>
              <a:gd name="connsiteY7" fmla="*/ 1456406 h 1645937"/>
              <a:gd name="connsiteX8" fmla="*/ 4619165 w 6192037"/>
              <a:gd name="connsiteY8" fmla="*/ 1526500 h 1645937"/>
              <a:gd name="connsiteX9" fmla="*/ 2342303 w 6192037"/>
              <a:gd name="connsiteY9" fmla="*/ 1149427 h 1645937"/>
              <a:gd name="connsiteX10" fmla="*/ 1977237 w 6192037"/>
              <a:gd name="connsiteY10" fmla="*/ 1096906 h 1645937"/>
              <a:gd name="connsiteX11" fmla="*/ 824299 w 6192037"/>
              <a:gd name="connsiteY11" fmla="*/ 1136010 h 1645937"/>
              <a:gd name="connsiteX12" fmla="*/ 25156 w 6192037"/>
              <a:gd name="connsiteY12" fmla="*/ 890047 h 1645937"/>
              <a:gd name="connsiteX0" fmla="*/ 26819 w 6193700"/>
              <a:gd name="connsiteY0" fmla="*/ 890047 h 1645937"/>
              <a:gd name="connsiteX1" fmla="*/ 273409 w 6193700"/>
              <a:gd name="connsiteY1" fmla="*/ 669969 h 1645937"/>
              <a:gd name="connsiteX2" fmla="*/ 816536 w 6193700"/>
              <a:gd name="connsiteY2" fmla="*/ 834031 h 1645937"/>
              <a:gd name="connsiteX3" fmla="*/ 1555791 w 6193700"/>
              <a:gd name="connsiteY3" fmla="*/ 718407 h 1645937"/>
              <a:gd name="connsiteX4" fmla="*/ 2900249 w 6193700"/>
              <a:gd name="connsiteY4" fmla="*/ 197629 h 1645937"/>
              <a:gd name="connsiteX5" fmla="*/ 4152087 w 6193700"/>
              <a:gd name="connsiteY5" fmla="*/ 198342 h 1645937"/>
              <a:gd name="connsiteX6" fmla="*/ 6070759 w 6193700"/>
              <a:gd name="connsiteY6" fmla="*/ 81065 h 1645937"/>
              <a:gd name="connsiteX7" fmla="*/ 5733950 w 6193700"/>
              <a:gd name="connsiteY7" fmla="*/ 1456406 h 1645937"/>
              <a:gd name="connsiteX8" fmla="*/ 4620828 w 6193700"/>
              <a:gd name="connsiteY8" fmla="*/ 1526500 h 1645937"/>
              <a:gd name="connsiteX9" fmla="*/ 2343966 w 6193700"/>
              <a:gd name="connsiteY9" fmla="*/ 1149427 h 1645937"/>
              <a:gd name="connsiteX10" fmla="*/ 1978900 w 6193700"/>
              <a:gd name="connsiteY10" fmla="*/ 1096906 h 1645937"/>
              <a:gd name="connsiteX11" fmla="*/ 852589 w 6193700"/>
              <a:gd name="connsiteY11" fmla="*/ 1082127 h 1645937"/>
              <a:gd name="connsiteX12" fmla="*/ 26819 w 6193700"/>
              <a:gd name="connsiteY12" fmla="*/ 890047 h 1645937"/>
              <a:gd name="connsiteX0" fmla="*/ 26819 w 6193700"/>
              <a:gd name="connsiteY0" fmla="*/ 890047 h 1645937"/>
              <a:gd name="connsiteX1" fmla="*/ 273409 w 6193700"/>
              <a:gd name="connsiteY1" fmla="*/ 669969 h 1645937"/>
              <a:gd name="connsiteX2" fmla="*/ 816536 w 6193700"/>
              <a:gd name="connsiteY2" fmla="*/ 834031 h 1645937"/>
              <a:gd name="connsiteX3" fmla="*/ 1555791 w 6193700"/>
              <a:gd name="connsiteY3" fmla="*/ 718407 h 1645937"/>
              <a:gd name="connsiteX4" fmla="*/ 2900249 w 6193700"/>
              <a:gd name="connsiteY4" fmla="*/ 197629 h 1645937"/>
              <a:gd name="connsiteX5" fmla="*/ 4152087 w 6193700"/>
              <a:gd name="connsiteY5" fmla="*/ 198342 h 1645937"/>
              <a:gd name="connsiteX6" fmla="*/ 6070759 w 6193700"/>
              <a:gd name="connsiteY6" fmla="*/ 81065 h 1645937"/>
              <a:gd name="connsiteX7" fmla="*/ 5733950 w 6193700"/>
              <a:gd name="connsiteY7" fmla="*/ 1456406 h 1645937"/>
              <a:gd name="connsiteX8" fmla="*/ 4620828 w 6193700"/>
              <a:gd name="connsiteY8" fmla="*/ 1526500 h 1645937"/>
              <a:gd name="connsiteX9" fmla="*/ 2343966 w 6193700"/>
              <a:gd name="connsiteY9" fmla="*/ 1149427 h 1645937"/>
              <a:gd name="connsiteX10" fmla="*/ 1978900 w 6193700"/>
              <a:gd name="connsiteY10" fmla="*/ 1096906 h 1645937"/>
              <a:gd name="connsiteX11" fmla="*/ 1122984 w 6193700"/>
              <a:gd name="connsiteY11" fmla="*/ 1107723 h 1645937"/>
              <a:gd name="connsiteX12" fmla="*/ 852589 w 6193700"/>
              <a:gd name="connsiteY12" fmla="*/ 1082127 h 1645937"/>
              <a:gd name="connsiteX13" fmla="*/ 26819 w 6193700"/>
              <a:gd name="connsiteY13" fmla="*/ 890047 h 1645937"/>
              <a:gd name="connsiteX0" fmla="*/ 26819 w 6193700"/>
              <a:gd name="connsiteY0" fmla="*/ 890047 h 1645937"/>
              <a:gd name="connsiteX1" fmla="*/ 273409 w 6193700"/>
              <a:gd name="connsiteY1" fmla="*/ 669969 h 1645937"/>
              <a:gd name="connsiteX2" fmla="*/ 816536 w 6193700"/>
              <a:gd name="connsiteY2" fmla="*/ 834031 h 1645937"/>
              <a:gd name="connsiteX3" fmla="*/ 1555791 w 6193700"/>
              <a:gd name="connsiteY3" fmla="*/ 718407 h 1645937"/>
              <a:gd name="connsiteX4" fmla="*/ 2900249 w 6193700"/>
              <a:gd name="connsiteY4" fmla="*/ 197629 h 1645937"/>
              <a:gd name="connsiteX5" fmla="*/ 4152087 w 6193700"/>
              <a:gd name="connsiteY5" fmla="*/ 198342 h 1645937"/>
              <a:gd name="connsiteX6" fmla="*/ 6070759 w 6193700"/>
              <a:gd name="connsiteY6" fmla="*/ 81065 h 1645937"/>
              <a:gd name="connsiteX7" fmla="*/ 5733950 w 6193700"/>
              <a:gd name="connsiteY7" fmla="*/ 1456406 h 1645937"/>
              <a:gd name="connsiteX8" fmla="*/ 4620828 w 6193700"/>
              <a:gd name="connsiteY8" fmla="*/ 1526500 h 1645937"/>
              <a:gd name="connsiteX9" fmla="*/ 2343966 w 6193700"/>
              <a:gd name="connsiteY9" fmla="*/ 1149427 h 1645937"/>
              <a:gd name="connsiteX10" fmla="*/ 1978900 w 6193700"/>
              <a:gd name="connsiteY10" fmla="*/ 1096906 h 1645937"/>
              <a:gd name="connsiteX11" fmla="*/ 1374634 w 6193700"/>
              <a:gd name="connsiteY11" fmla="*/ 1076730 h 1645937"/>
              <a:gd name="connsiteX12" fmla="*/ 852589 w 6193700"/>
              <a:gd name="connsiteY12" fmla="*/ 1082127 h 1645937"/>
              <a:gd name="connsiteX13" fmla="*/ 26819 w 6193700"/>
              <a:gd name="connsiteY13" fmla="*/ 890047 h 1645937"/>
              <a:gd name="connsiteX0" fmla="*/ 37705 w 6204586"/>
              <a:gd name="connsiteY0" fmla="*/ 890047 h 1645937"/>
              <a:gd name="connsiteX1" fmla="*/ 284295 w 6204586"/>
              <a:gd name="connsiteY1" fmla="*/ 669969 h 1645937"/>
              <a:gd name="connsiteX2" fmla="*/ 827422 w 6204586"/>
              <a:gd name="connsiteY2" fmla="*/ 834031 h 1645937"/>
              <a:gd name="connsiteX3" fmla="*/ 1566677 w 6204586"/>
              <a:gd name="connsiteY3" fmla="*/ 718407 h 1645937"/>
              <a:gd name="connsiteX4" fmla="*/ 2911135 w 6204586"/>
              <a:gd name="connsiteY4" fmla="*/ 197629 h 1645937"/>
              <a:gd name="connsiteX5" fmla="*/ 4162973 w 6204586"/>
              <a:gd name="connsiteY5" fmla="*/ 198342 h 1645937"/>
              <a:gd name="connsiteX6" fmla="*/ 6081645 w 6204586"/>
              <a:gd name="connsiteY6" fmla="*/ 81065 h 1645937"/>
              <a:gd name="connsiteX7" fmla="*/ 5744836 w 6204586"/>
              <a:gd name="connsiteY7" fmla="*/ 1456406 h 1645937"/>
              <a:gd name="connsiteX8" fmla="*/ 4631714 w 6204586"/>
              <a:gd name="connsiteY8" fmla="*/ 1526500 h 1645937"/>
              <a:gd name="connsiteX9" fmla="*/ 2354852 w 6204586"/>
              <a:gd name="connsiteY9" fmla="*/ 1149427 h 1645937"/>
              <a:gd name="connsiteX10" fmla="*/ 1989786 w 6204586"/>
              <a:gd name="connsiteY10" fmla="*/ 1096906 h 1645937"/>
              <a:gd name="connsiteX11" fmla="*/ 1385520 w 6204586"/>
              <a:gd name="connsiteY11" fmla="*/ 1076730 h 1645937"/>
              <a:gd name="connsiteX12" fmla="*/ 1032576 w 6204586"/>
              <a:gd name="connsiteY12" fmla="*/ 1096937 h 1645937"/>
              <a:gd name="connsiteX13" fmla="*/ 37705 w 6204586"/>
              <a:gd name="connsiteY13" fmla="*/ 890047 h 1645937"/>
              <a:gd name="connsiteX0" fmla="*/ 37705 w 6204586"/>
              <a:gd name="connsiteY0" fmla="*/ 890047 h 1645937"/>
              <a:gd name="connsiteX1" fmla="*/ 284295 w 6204586"/>
              <a:gd name="connsiteY1" fmla="*/ 669969 h 1645937"/>
              <a:gd name="connsiteX2" fmla="*/ 827422 w 6204586"/>
              <a:gd name="connsiteY2" fmla="*/ 834031 h 1645937"/>
              <a:gd name="connsiteX3" fmla="*/ 1566677 w 6204586"/>
              <a:gd name="connsiteY3" fmla="*/ 718407 h 1645937"/>
              <a:gd name="connsiteX4" fmla="*/ 2911135 w 6204586"/>
              <a:gd name="connsiteY4" fmla="*/ 197629 h 1645937"/>
              <a:gd name="connsiteX5" fmla="*/ 4162973 w 6204586"/>
              <a:gd name="connsiteY5" fmla="*/ 198342 h 1645937"/>
              <a:gd name="connsiteX6" fmla="*/ 6081645 w 6204586"/>
              <a:gd name="connsiteY6" fmla="*/ 81065 h 1645937"/>
              <a:gd name="connsiteX7" fmla="*/ 5744836 w 6204586"/>
              <a:gd name="connsiteY7" fmla="*/ 1456406 h 1645937"/>
              <a:gd name="connsiteX8" fmla="*/ 4631714 w 6204586"/>
              <a:gd name="connsiteY8" fmla="*/ 1526500 h 1645937"/>
              <a:gd name="connsiteX9" fmla="*/ 2354852 w 6204586"/>
              <a:gd name="connsiteY9" fmla="*/ 1149427 h 1645937"/>
              <a:gd name="connsiteX10" fmla="*/ 1989786 w 6204586"/>
              <a:gd name="connsiteY10" fmla="*/ 1096906 h 1645937"/>
              <a:gd name="connsiteX11" fmla="*/ 1454757 w 6204586"/>
              <a:gd name="connsiteY11" fmla="*/ 1057868 h 1645937"/>
              <a:gd name="connsiteX12" fmla="*/ 1032576 w 6204586"/>
              <a:gd name="connsiteY12" fmla="*/ 1096937 h 1645937"/>
              <a:gd name="connsiteX13" fmla="*/ 37705 w 6204586"/>
              <a:gd name="connsiteY13" fmla="*/ 890047 h 1645937"/>
              <a:gd name="connsiteX0" fmla="*/ 37705 w 6204586"/>
              <a:gd name="connsiteY0" fmla="*/ 890047 h 1645937"/>
              <a:gd name="connsiteX1" fmla="*/ 284295 w 6204586"/>
              <a:gd name="connsiteY1" fmla="*/ 669969 h 1645937"/>
              <a:gd name="connsiteX2" fmla="*/ 827422 w 6204586"/>
              <a:gd name="connsiteY2" fmla="*/ 834031 h 1645937"/>
              <a:gd name="connsiteX3" fmla="*/ 1566677 w 6204586"/>
              <a:gd name="connsiteY3" fmla="*/ 718407 h 1645937"/>
              <a:gd name="connsiteX4" fmla="*/ 2911135 w 6204586"/>
              <a:gd name="connsiteY4" fmla="*/ 197629 h 1645937"/>
              <a:gd name="connsiteX5" fmla="*/ 4162973 w 6204586"/>
              <a:gd name="connsiteY5" fmla="*/ 198342 h 1645937"/>
              <a:gd name="connsiteX6" fmla="*/ 6081645 w 6204586"/>
              <a:gd name="connsiteY6" fmla="*/ 81065 h 1645937"/>
              <a:gd name="connsiteX7" fmla="*/ 5744836 w 6204586"/>
              <a:gd name="connsiteY7" fmla="*/ 1456406 h 1645937"/>
              <a:gd name="connsiteX8" fmla="*/ 4631714 w 6204586"/>
              <a:gd name="connsiteY8" fmla="*/ 1526500 h 1645937"/>
              <a:gd name="connsiteX9" fmla="*/ 2354852 w 6204586"/>
              <a:gd name="connsiteY9" fmla="*/ 1149427 h 1645937"/>
              <a:gd name="connsiteX10" fmla="*/ 1992449 w 6204586"/>
              <a:gd name="connsiteY10" fmla="*/ 1078047 h 1645937"/>
              <a:gd name="connsiteX11" fmla="*/ 1454757 w 6204586"/>
              <a:gd name="connsiteY11" fmla="*/ 1057868 h 1645937"/>
              <a:gd name="connsiteX12" fmla="*/ 1032576 w 6204586"/>
              <a:gd name="connsiteY12" fmla="*/ 1096937 h 1645937"/>
              <a:gd name="connsiteX13" fmla="*/ 37705 w 6204586"/>
              <a:gd name="connsiteY13" fmla="*/ 890047 h 1645937"/>
              <a:gd name="connsiteX0" fmla="*/ 37705 w 6204586"/>
              <a:gd name="connsiteY0" fmla="*/ 890047 h 1645937"/>
              <a:gd name="connsiteX1" fmla="*/ 284295 w 6204586"/>
              <a:gd name="connsiteY1" fmla="*/ 669969 h 1645937"/>
              <a:gd name="connsiteX2" fmla="*/ 827422 w 6204586"/>
              <a:gd name="connsiteY2" fmla="*/ 834031 h 1645937"/>
              <a:gd name="connsiteX3" fmla="*/ 1566677 w 6204586"/>
              <a:gd name="connsiteY3" fmla="*/ 718407 h 1645937"/>
              <a:gd name="connsiteX4" fmla="*/ 2911135 w 6204586"/>
              <a:gd name="connsiteY4" fmla="*/ 197629 h 1645937"/>
              <a:gd name="connsiteX5" fmla="*/ 4162973 w 6204586"/>
              <a:gd name="connsiteY5" fmla="*/ 198342 h 1645937"/>
              <a:gd name="connsiteX6" fmla="*/ 6081645 w 6204586"/>
              <a:gd name="connsiteY6" fmla="*/ 81065 h 1645937"/>
              <a:gd name="connsiteX7" fmla="*/ 5744836 w 6204586"/>
              <a:gd name="connsiteY7" fmla="*/ 1456406 h 1645937"/>
              <a:gd name="connsiteX8" fmla="*/ 4631714 w 6204586"/>
              <a:gd name="connsiteY8" fmla="*/ 1526500 h 1645937"/>
              <a:gd name="connsiteX9" fmla="*/ 2514634 w 6204586"/>
              <a:gd name="connsiteY9" fmla="*/ 1230243 h 1645937"/>
              <a:gd name="connsiteX10" fmla="*/ 1992449 w 6204586"/>
              <a:gd name="connsiteY10" fmla="*/ 1078047 h 1645937"/>
              <a:gd name="connsiteX11" fmla="*/ 1454757 w 6204586"/>
              <a:gd name="connsiteY11" fmla="*/ 1057868 h 1645937"/>
              <a:gd name="connsiteX12" fmla="*/ 1032576 w 6204586"/>
              <a:gd name="connsiteY12" fmla="*/ 1096937 h 1645937"/>
              <a:gd name="connsiteX13" fmla="*/ 37705 w 6204586"/>
              <a:gd name="connsiteY13" fmla="*/ 890047 h 1645937"/>
              <a:gd name="connsiteX0" fmla="*/ 37705 w 6345492"/>
              <a:gd name="connsiteY0" fmla="*/ 890047 h 1571777"/>
              <a:gd name="connsiteX1" fmla="*/ 284295 w 6345492"/>
              <a:gd name="connsiteY1" fmla="*/ 669969 h 1571777"/>
              <a:gd name="connsiteX2" fmla="*/ 827422 w 6345492"/>
              <a:gd name="connsiteY2" fmla="*/ 834031 h 1571777"/>
              <a:gd name="connsiteX3" fmla="*/ 1566677 w 6345492"/>
              <a:gd name="connsiteY3" fmla="*/ 718407 h 1571777"/>
              <a:gd name="connsiteX4" fmla="*/ 2911135 w 6345492"/>
              <a:gd name="connsiteY4" fmla="*/ 197629 h 1571777"/>
              <a:gd name="connsiteX5" fmla="*/ 4162973 w 6345492"/>
              <a:gd name="connsiteY5" fmla="*/ 198342 h 1571777"/>
              <a:gd name="connsiteX6" fmla="*/ 6081645 w 6345492"/>
              <a:gd name="connsiteY6" fmla="*/ 81065 h 1571777"/>
              <a:gd name="connsiteX7" fmla="*/ 6256117 w 6345492"/>
              <a:gd name="connsiteY7" fmla="*/ 1203141 h 1571777"/>
              <a:gd name="connsiteX8" fmla="*/ 4631714 w 6345492"/>
              <a:gd name="connsiteY8" fmla="*/ 1526500 h 1571777"/>
              <a:gd name="connsiteX9" fmla="*/ 2514634 w 6345492"/>
              <a:gd name="connsiteY9" fmla="*/ 1230243 h 1571777"/>
              <a:gd name="connsiteX10" fmla="*/ 1992449 w 6345492"/>
              <a:gd name="connsiteY10" fmla="*/ 1078047 h 1571777"/>
              <a:gd name="connsiteX11" fmla="*/ 1454757 w 6345492"/>
              <a:gd name="connsiteY11" fmla="*/ 1057868 h 1571777"/>
              <a:gd name="connsiteX12" fmla="*/ 1032576 w 6345492"/>
              <a:gd name="connsiteY12" fmla="*/ 1096937 h 1571777"/>
              <a:gd name="connsiteX13" fmla="*/ 37705 w 6345492"/>
              <a:gd name="connsiteY13" fmla="*/ 890047 h 1571777"/>
              <a:gd name="connsiteX0" fmla="*/ 37705 w 6283005"/>
              <a:gd name="connsiteY0" fmla="*/ 730181 h 1411911"/>
              <a:gd name="connsiteX1" fmla="*/ 284295 w 6283005"/>
              <a:gd name="connsiteY1" fmla="*/ 510103 h 1411911"/>
              <a:gd name="connsiteX2" fmla="*/ 827422 w 6283005"/>
              <a:gd name="connsiteY2" fmla="*/ 674165 h 1411911"/>
              <a:gd name="connsiteX3" fmla="*/ 1566677 w 6283005"/>
              <a:gd name="connsiteY3" fmla="*/ 558541 h 1411911"/>
              <a:gd name="connsiteX4" fmla="*/ 2911135 w 6283005"/>
              <a:gd name="connsiteY4" fmla="*/ 37763 h 1411911"/>
              <a:gd name="connsiteX5" fmla="*/ 4162973 w 6283005"/>
              <a:gd name="connsiteY5" fmla="*/ 38476 h 1411911"/>
              <a:gd name="connsiteX6" fmla="*/ 5848653 w 6283005"/>
              <a:gd name="connsiteY6" fmla="*/ 358997 h 1411911"/>
              <a:gd name="connsiteX7" fmla="*/ 6256117 w 6283005"/>
              <a:gd name="connsiteY7" fmla="*/ 1043275 h 1411911"/>
              <a:gd name="connsiteX8" fmla="*/ 4631714 w 6283005"/>
              <a:gd name="connsiteY8" fmla="*/ 1366634 h 1411911"/>
              <a:gd name="connsiteX9" fmla="*/ 2514634 w 6283005"/>
              <a:gd name="connsiteY9" fmla="*/ 1070377 h 1411911"/>
              <a:gd name="connsiteX10" fmla="*/ 1992449 w 6283005"/>
              <a:gd name="connsiteY10" fmla="*/ 918181 h 1411911"/>
              <a:gd name="connsiteX11" fmla="*/ 1454757 w 6283005"/>
              <a:gd name="connsiteY11" fmla="*/ 898002 h 1411911"/>
              <a:gd name="connsiteX12" fmla="*/ 1032576 w 6283005"/>
              <a:gd name="connsiteY12" fmla="*/ 937071 h 1411911"/>
              <a:gd name="connsiteX13" fmla="*/ 37705 w 6283005"/>
              <a:gd name="connsiteY13" fmla="*/ 730181 h 1411911"/>
              <a:gd name="connsiteX0" fmla="*/ 37705 w 6283005"/>
              <a:gd name="connsiteY0" fmla="*/ 730181 h 1411911"/>
              <a:gd name="connsiteX1" fmla="*/ 284295 w 6283005"/>
              <a:gd name="connsiteY1" fmla="*/ 510103 h 1411911"/>
              <a:gd name="connsiteX2" fmla="*/ 827422 w 6283005"/>
              <a:gd name="connsiteY2" fmla="*/ 674165 h 1411911"/>
              <a:gd name="connsiteX3" fmla="*/ 1566677 w 6283005"/>
              <a:gd name="connsiteY3" fmla="*/ 558541 h 1411911"/>
              <a:gd name="connsiteX4" fmla="*/ 2911135 w 6283005"/>
              <a:gd name="connsiteY4" fmla="*/ 37763 h 1411911"/>
              <a:gd name="connsiteX5" fmla="*/ 4162973 w 6283005"/>
              <a:gd name="connsiteY5" fmla="*/ 38476 h 1411911"/>
              <a:gd name="connsiteX6" fmla="*/ 5848653 w 6283005"/>
              <a:gd name="connsiteY6" fmla="*/ 358997 h 1411911"/>
              <a:gd name="connsiteX7" fmla="*/ 6256117 w 6283005"/>
              <a:gd name="connsiteY7" fmla="*/ 1043275 h 1411911"/>
              <a:gd name="connsiteX8" fmla="*/ 4631714 w 6283005"/>
              <a:gd name="connsiteY8" fmla="*/ 1366634 h 1411911"/>
              <a:gd name="connsiteX9" fmla="*/ 2514634 w 6283005"/>
              <a:gd name="connsiteY9" fmla="*/ 1070377 h 1411911"/>
              <a:gd name="connsiteX10" fmla="*/ 1888593 w 6283005"/>
              <a:gd name="connsiteY10" fmla="*/ 912798 h 1411911"/>
              <a:gd name="connsiteX11" fmla="*/ 1454757 w 6283005"/>
              <a:gd name="connsiteY11" fmla="*/ 898002 h 1411911"/>
              <a:gd name="connsiteX12" fmla="*/ 1032576 w 6283005"/>
              <a:gd name="connsiteY12" fmla="*/ 937071 h 1411911"/>
              <a:gd name="connsiteX13" fmla="*/ 37705 w 6283005"/>
              <a:gd name="connsiteY13" fmla="*/ 730181 h 1411911"/>
              <a:gd name="connsiteX0" fmla="*/ 37705 w 6283005"/>
              <a:gd name="connsiteY0" fmla="*/ 730181 h 1411911"/>
              <a:gd name="connsiteX1" fmla="*/ 284295 w 6283005"/>
              <a:gd name="connsiteY1" fmla="*/ 510103 h 1411911"/>
              <a:gd name="connsiteX2" fmla="*/ 827422 w 6283005"/>
              <a:gd name="connsiteY2" fmla="*/ 674165 h 1411911"/>
              <a:gd name="connsiteX3" fmla="*/ 1566677 w 6283005"/>
              <a:gd name="connsiteY3" fmla="*/ 558541 h 1411911"/>
              <a:gd name="connsiteX4" fmla="*/ 2911135 w 6283005"/>
              <a:gd name="connsiteY4" fmla="*/ 37763 h 1411911"/>
              <a:gd name="connsiteX5" fmla="*/ 4162973 w 6283005"/>
              <a:gd name="connsiteY5" fmla="*/ 38476 h 1411911"/>
              <a:gd name="connsiteX6" fmla="*/ 5848653 w 6283005"/>
              <a:gd name="connsiteY6" fmla="*/ 358997 h 1411911"/>
              <a:gd name="connsiteX7" fmla="*/ 6256117 w 6283005"/>
              <a:gd name="connsiteY7" fmla="*/ 1043275 h 1411911"/>
              <a:gd name="connsiteX8" fmla="*/ 4631714 w 6283005"/>
              <a:gd name="connsiteY8" fmla="*/ 1366634 h 1411911"/>
              <a:gd name="connsiteX9" fmla="*/ 2514634 w 6283005"/>
              <a:gd name="connsiteY9" fmla="*/ 1070377 h 1411911"/>
              <a:gd name="connsiteX10" fmla="*/ 1888593 w 6283005"/>
              <a:gd name="connsiteY10" fmla="*/ 912798 h 1411911"/>
              <a:gd name="connsiteX11" fmla="*/ 1454757 w 6283005"/>
              <a:gd name="connsiteY11" fmla="*/ 898002 h 1411911"/>
              <a:gd name="connsiteX12" fmla="*/ 1032576 w 6283005"/>
              <a:gd name="connsiteY12" fmla="*/ 937071 h 1411911"/>
              <a:gd name="connsiteX13" fmla="*/ 37705 w 6283005"/>
              <a:gd name="connsiteY13" fmla="*/ 730181 h 1411911"/>
              <a:gd name="connsiteX0" fmla="*/ 37705 w 6283005"/>
              <a:gd name="connsiteY0" fmla="*/ 730181 h 1411911"/>
              <a:gd name="connsiteX1" fmla="*/ 284295 w 6283005"/>
              <a:gd name="connsiteY1" fmla="*/ 510103 h 1411911"/>
              <a:gd name="connsiteX2" fmla="*/ 827422 w 6283005"/>
              <a:gd name="connsiteY2" fmla="*/ 674165 h 1411911"/>
              <a:gd name="connsiteX3" fmla="*/ 1566677 w 6283005"/>
              <a:gd name="connsiteY3" fmla="*/ 558541 h 1411911"/>
              <a:gd name="connsiteX4" fmla="*/ 2911135 w 6283005"/>
              <a:gd name="connsiteY4" fmla="*/ 37763 h 1411911"/>
              <a:gd name="connsiteX5" fmla="*/ 4162973 w 6283005"/>
              <a:gd name="connsiteY5" fmla="*/ 38476 h 1411911"/>
              <a:gd name="connsiteX6" fmla="*/ 5848653 w 6283005"/>
              <a:gd name="connsiteY6" fmla="*/ 358997 h 1411911"/>
              <a:gd name="connsiteX7" fmla="*/ 6256117 w 6283005"/>
              <a:gd name="connsiteY7" fmla="*/ 1043275 h 1411911"/>
              <a:gd name="connsiteX8" fmla="*/ 4631714 w 6283005"/>
              <a:gd name="connsiteY8" fmla="*/ 1366634 h 1411911"/>
              <a:gd name="connsiteX9" fmla="*/ 2882129 w 6283005"/>
              <a:gd name="connsiteY9" fmla="*/ 1161960 h 1411911"/>
              <a:gd name="connsiteX10" fmla="*/ 1888593 w 6283005"/>
              <a:gd name="connsiteY10" fmla="*/ 912798 h 1411911"/>
              <a:gd name="connsiteX11" fmla="*/ 1454757 w 6283005"/>
              <a:gd name="connsiteY11" fmla="*/ 898002 h 1411911"/>
              <a:gd name="connsiteX12" fmla="*/ 1032576 w 6283005"/>
              <a:gd name="connsiteY12" fmla="*/ 937071 h 1411911"/>
              <a:gd name="connsiteX13" fmla="*/ 37705 w 6283005"/>
              <a:gd name="connsiteY13" fmla="*/ 730181 h 1411911"/>
              <a:gd name="connsiteX0" fmla="*/ 37705 w 6283005"/>
              <a:gd name="connsiteY0" fmla="*/ 730181 h 1421244"/>
              <a:gd name="connsiteX1" fmla="*/ 284295 w 6283005"/>
              <a:gd name="connsiteY1" fmla="*/ 510103 h 1421244"/>
              <a:gd name="connsiteX2" fmla="*/ 827422 w 6283005"/>
              <a:gd name="connsiteY2" fmla="*/ 674165 h 1421244"/>
              <a:gd name="connsiteX3" fmla="*/ 1566677 w 6283005"/>
              <a:gd name="connsiteY3" fmla="*/ 558541 h 1421244"/>
              <a:gd name="connsiteX4" fmla="*/ 2911135 w 6283005"/>
              <a:gd name="connsiteY4" fmla="*/ 37763 h 1421244"/>
              <a:gd name="connsiteX5" fmla="*/ 4162973 w 6283005"/>
              <a:gd name="connsiteY5" fmla="*/ 38476 h 1421244"/>
              <a:gd name="connsiteX6" fmla="*/ 5848653 w 6283005"/>
              <a:gd name="connsiteY6" fmla="*/ 358997 h 1421244"/>
              <a:gd name="connsiteX7" fmla="*/ 6256117 w 6283005"/>
              <a:gd name="connsiteY7" fmla="*/ 1043275 h 1421244"/>
              <a:gd name="connsiteX8" fmla="*/ 4906003 w 6283005"/>
              <a:gd name="connsiteY8" fmla="*/ 1377399 h 1421244"/>
              <a:gd name="connsiteX9" fmla="*/ 2882129 w 6283005"/>
              <a:gd name="connsiteY9" fmla="*/ 1161960 h 1421244"/>
              <a:gd name="connsiteX10" fmla="*/ 1888593 w 6283005"/>
              <a:gd name="connsiteY10" fmla="*/ 912798 h 1421244"/>
              <a:gd name="connsiteX11" fmla="*/ 1454757 w 6283005"/>
              <a:gd name="connsiteY11" fmla="*/ 898002 h 1421244"/>
              <a:gd name="connsiteX12" fmla="*/ 1032576 w 6283005"/>
              <a:gd name="connsiteY12" fmla="*/ 937071 h 1421244"/>
              <a:gd name="connsiteX13" fmla="*/ 37705 w 6283005"/>
              <a:gd name="connsiteY13" fmla="*/ 730181 h 1421244"/>
              <a:gd name="connsiteX0" fmla="*/ 37705 w 6283005"/>
              <a:gd name="connsiteY0" fmla="*/ 712189 h 1403252"/>
              <a:gd name="connsiteX1" fmla="*/ 284295 w 6283005"/>
              <a:gd name="connsiteY1" fmla="*/ 492111 h 1403252"/>
              <a:gd name="connsiteX2" fmla="*/ 827422 w 6283005"/>
              <a:gd name="connsiteY2" fmla="*/ 656173 h 1403252"/>
              <a:gd name="connsiteX3" fmla="*/ 1566677 w 6283005"/>
              <a:gd name="connsiteY3" fmla="*/ 540549 h 1403252"/>
              <a:gd name="connsiteX4" fmla="*/ 2911135 w 6283005"/>
              <a:gd name="connsiteY4" fmla="*/ 19771 h 1403252"/>
              <a:gd name="connsiteX5" fmla="*/ 4140345 w 6283005"/>
              <a:gd name="connsiteY5" fmla="*/ 180782 h 1403252"/>
              <a:gd name="connsiteX6" fmla="*/ 5848653 w 6283005"/>
              <a:gd name="connsiteY6" fmla="*/ 341005 h 1403252"/>
              <a:gd name="connsiteX7" fmla="*/ 6256117 w 6283005"/>
              <a:gd name="connsiteY7" fmla="*/ 1025283 h 1403252"/>
              <a:gd name="connsiteX8" fmla="*/ 4906003 w 6283005"/>
              <a:gd name="connsiteY8" fmla="*/ 1359407 h 1403252"/>
              <a:gd name="connsiteX9" fmla="*/ 2882129 w 6283005"/>
              <a:gd name="connsiteY9" fmla="*/ 1143968 h 1403252"/>
              <a:gd name="connsiteX10" fmla="*/ 1888593 w 6283005"/>
              <a:gd name="connsiteY10" fmla="*/ 894806 h 1403252"/>
              <a:gd name="connsiteX11" fmla="*/ 1454757 w 6283005"/>
              <a:gd name="connsiteY11" fmla="*/ 880010 h 1403252"/>
              <a:gd name="connsiteX12" fmla="*/ 1032576 w 6283005"/>
              <a:gd name="connsiteY12" fmla="*/ 919079 h 1403252"/>
              <a:gd name="connsiteX13" fmla="*/ 37705 w 6283005"/>
              <a:gd name="connsiteY13" fmla="*/ 712189 h 1403252"/>
              <a:gd name="connsiteX0" fmla="*/ 37705 w 6311723"/>
              <a:gd name="connsiteY0" fmla="*/ 712189 h 1403252"/>
              <a:gd name="connsiteX1" fmla="*/ 284295 w 6311723"/>
              <a:gd name="connsiteY1" fmla="*/ 492111 h 1403252"/>
              <a:gd name="connsiteX2" fmla="*/ 827422 w 6311723"/>
              <a:gd name="connsiteY2" fmla="*/ 656173 h 1403252"/>
              <a:gd name="connsiteX3" fmla="*/ 1566677 w 6311723"/>
              <a:gd name="connsiteY3" fmla="*/ 540549 h 1403252"/>
              <a:gd name="connsiteX4" fmla="*/ 2911135 w 6311723"/>
              <a:gd name="connsiteY4" fmla="*/ 19771 h 1403252"/>
              <a:gd name="connsiteX5" fmla="*/ 4140345 w 6311723"/>
              <a:gd name="connsiteY5" fmla="*/ 180782 h 1403252"/>
              <a:gd name="connsiteX6" fmla="*/ 5993793 w 6311723"/>
              <a:gd name="connsiteY6" fmla="*/ 525543 h 1403252"/>
              <a:gd name="connsiteX7" fmla="*/ 6256117 w 6311723"/>
              <a:gd name="connsiteY7" fmla="*/ 1025283 h 1403252"/>
              <a:gd name="connsiteX8" fmla="*/ 4906003 w 6311723"/>
              <a:gd name="connsiteY8" fmla="*/ 1359407 h 1403252"/>
              <a:gd name="connsiteX9" fmla="*/ 2882129 w 6311723"/>
              <a:gd name="connsiteY9" fmla="*/ 1143968 h 1403252"/>
              <a:gd name="connsiteX10" fmla="*/ 1888593 w 6311723"/>
              <a:gd name="connsiteY10" fmla="*/ 894806 h 1403252"/>
              <a:gd name="connsiteX11" fmla="*/ 1454757 w 6311723"/>
              <a:gd name="connsiteY11" fmla="*/ 880010 h 1403252"/>
              <a:gd name="connsiteX12" fmla="*/ 1032576 w 6311723"/>
              <a:gd name="connsiteY12" fmla="*/ 919079 h 1403252"/>
              <a:gd name="connsiteX13" fmla="*/ 37705 w 6311723"/>
              <a:gd name="connsiteY13" fmla="*/ 712189 h 1403252"/>
              <a:gd name="connsiteX0" fmla="*/ 37705 w 6311723"/>
              <a:gd name="connsiteY0" fmla="*/ 548883 h 1239946"/>
              <a:gd name="connsiteX1" fmla="*/ 284295 w 6311723"/>
              <a:gd name="connsiteY1" fmla="*/ 328805 h 1239946"/>
              <a:gd name="connsiteX2" fmla="*/ 827422 w 6311723"/>
              <a:gd name="connsiteY2" fmla="*/ 492867 h 1239946"/>
              <a:gd name="connsiteX3" fmla="*/ 1566677 w 6311723"/>
              <a:gd name="connsiteY3" fmla="*/ 377243 h 1239946"/>
              <a:gd name="connsiteX4" fmla="*/ 2884514 w 6311723"/>
              <a:gd name="connsiteY4" fmla="*/ 45052 h 1239946"/>
              <a:gd name="connsiteX5" fmla="*/ 4140345 w 6311723"/>
              <a:gd name="connsiteY5" fmla="*/ 17476 h 1239946"/>
              <a:gd name="connsiteX6" fmla="*/ 5993793 w 6311723"/>
              <a:gd name="connsiteY6" fmla="*/ 362237 h 1239946"/>
              <a:gd name="connsiteX7" fmla="*/ 6256117 w 6311723"/>
              <a:gd name="connsiteY7" fmla="*/ 861977 h 1239946"/>
              <a:gd name="connsiteX8" fmla="*/ 4906003 w 6311723"/>
              <a:gd name="connsiteY8" fmla="*/ 1196101 h 1239946"/>
              <a:gd name="connsiteX9" fmla="*/ 2882129 w 6311723"/>
              <a:gd name="connsiteY9" fmla="*/ 980662 h 1239946"/>
              <a:gd name="connsiteX10" fmla="*/ 1888593 w 6311723"/>
              <a:gd name="connsiteY10" fmla="*/ 731500 h 1239946"/>
              <a:gd name="connsiteX11" fmla="*/ 1454757 w 6311723"/>
              <a:gd name="connsiteY11" fmla="*/ 716704 h 1239946"/>
              <a:gd name="connsiteX12" fmla="*/ 1032576 w 6311723"/>
              <a:gd name="connsiteY12" fmla="*/ 755773 h 1239946"/>
              <a:gd name="connsiteX13" fmla="*/ 37705 w 6311723"/>
              <a:gd name="connsiteY13" fmla="*/ 548883 h 1239946"/>
              <a:gd name="connsiteX0" fmla="*/ 37705 w 6100746"/>
              <a:gd name="connsiteY0" fmla="*/ 548883 h 1196985"/>
              <a:gd name="connsiteX1" fmla="*/ 284295 w 6100746"/>
              <a:gd name="connsiteY1" fmla="*/ 328805 h 1196985"/>
              <a:gd name="connsiteX2" fmla="*/ 827422 w 6100746"/>
              <a:gd name="connsiteY2" fmla="*/ 492867 h 1196985"/>
              <a:gd name="connsiteX3" fmla="*/ 1566677 w 6100746"/>
              <a:gd name="connsiteY3" fmla="*/ 377243 h 1196985"/>
              <a:gd name="connsiteX4" fmla="*/ 2884514 w 6100746"/>
              <a:gd name="connsiteY4" fmla="*/ 45052 h 1196985"/>
              <a:gd name="connsiteX5" fmla="*/ 4140345 w 6100746"/>
              <a:gd name="connsiteY5" fmla="*/ 17476 h 1196985"/>
              <a:gd name="connsiteX6" fmla="*/ 5993793 w 6100746"/>
              <a:gd name="connsiteY6" fmla="*/ 362237 h 1196985"/>
              <a:gd name="connsiteX7" fmla="*/ 5835532 w 6100746"/>
              <a:gd name="connsiteY7" fmla="*/ 909141 h 1196985"/>
              <a:gd name="connsiteX8" fmla="*/ 4906003 w 6100746"/>
              <a:gd name="connsiteY8" fmla="*/ 1196101 h 1196985"/>
              <a:gd name="connsiteX9" fmla="*/ 2882129 w 6100746"/>
              <a:gd name="connsiteY9" fmla="*/ 980662 h 1196985"/>
              <a:gd name="connsiteX10" fmla="*/ 1888593 w 6100746"/>
              <a:gd name="connsiteY10" fmla="*/ 731500 h 1196985"/>
              <a:gd name="connsiteX11" fmla="*/ 1454757 w 6100746"/>
              <a:gd name="connsiteY11" fmla="*/ 716704 h 1196985"/>
              <a:gd name="connsiteX12" fmla="*/ 1032576 w 6100746"/>
              <a:gd name="connsiteY12" fmla="*/ 755773 h 1196985"/>
              <a:gd name="connsiteX13" fmla="*/ 37705 w 6100746"/>
              <a:gd name="connsiteY13" fmla="*/ 548883 h 1196985"/>
              <a:gd name="connsiteX0" fmla="*/ 37705 w 5922555"/>
              <a:gd name="connsiteY0" fmla="*/ 570854 h 1218956"/>
              <a:gd name="connsiteX1" fmla="*/ 284295 w 5922555"/>
              <a:gd name="connsiteY1" fmla="*/ 350776 h 1218956"/>
              <a:gd name="connsiteX2" fmla="*/ 827422 w 5922555"/>
              <a:gd name="connsiteY2" fmla="*/ 514838 h 1218956"/>
              <a:gd name="connsiteX3" fmla="*/ 1566677 w 5922555"/>
              <a:gd name="connsiteY3" fmla="*/ 399214 h 1218956"/>
              <a:gd name="connsiteX4" fmla="*/ 2884514 w 5922555"/>
              <a:gd name="connsiteY4" fmla="*/ 67023 h 1218956"/>
              <a:gd name="connsiteX5" fmla="*/ 4140345 w 5922555"/>
              <a:gd name="connsiteY5" fmla="*/ 39447 h 1218956"/>
              <a:gd name="connsiteX6" fmla="*/ 5690770 w 5922555"/>
              <a:gd name="connsiteY6" fmla="*/ 352229 h 1218956"/>
              <a:gd name="connsiteX7" fmla="*/ 5835532 w 5922555"/>
              <a:gd name="connsiteY7" fmla="*/ 931112 h 1218956"/>
              <a:gd name="connsiteX8" fmla="*/ 4906003 w 5922555"/>
              <a:gd name="connsiteY8" fmla="*/ 1218072 h 1218956"/>
              <a:gd name="connsiteX9" fmla="*/ 2882129 w 5922555"/>
              <a:gd name="connsiteY9" fmla="*/ 1002633 h 1218956"/>
              <a:gd name="connsiteX10" fmla="*/ 1888593 w 5922555"/>
              <a:gd name="connsiteY10" fmla="*/ 753471 h 1218956"/>
              <a:gd name="connsiteX11" fmla="*/ 1454757 w 5922555"/>
              <a:gd name="connsiteY11" fmla="*/ 738675 h 1218956"/>
              <a:gd name="connsiteX12" fmla="*/ 1032576 w 5922555"/>
              <a:gd name="connsiteY12" fmla="*/ 777744 h 1218956"/>
              <a:gd name="connsiteX13" fmla="*/ 37705 w 5922555"/>
              <a:gd name="connsiteY13" fmla="*/ 570854 h 1218956"/>
              <a:gd name="connsiteX0" fmla="*/ 37705 w 5950945"/>
              <a:gd name="connsiteY0" fmla="*/ 579730 h 1227832"/>
              <a:gd name="connsiteX1" fmla="*/ 284295 w 5950945"/>
              <a:gd name="connsiteY1" fmla="*/ 359652 h 1227832"/>
              <a:gd name="connsiteX2" fmla="*/ 827422 w 5950945"/>
              <a:gd name="connsiteY2" fmla="*/ 523714 h 1227832"/>
              <a:gd name="connsiteX3" fmla="*/ 1566677 w 5950945"/>
              <a:gd name="connsiteY3" fmla="*/ 408090 h 1227832"/>
              <a:gd name="connsiteX4" fmla="*/ 2884514 w 5950945"/>
              <a:gd name="connsiteY4" fmla="*/ 75899 h 1227832"/>
              <a:gd name="connsiteX5" fmla="*/ 3623720 w 5950945"/>
              <a:gd name="connsiteY5" fmla="*/ 21404 h 1227832"/>
              <a:gd name="connsiteX6" fmla="*/ 5690770 w 5950945"/>
              <a:gd name="connsiteY6" fmla="*/ 361105 h 1227832"/>
              <a:gd name="connsiteX7" fmla="*/ 5835532 w 5950945"/>
              <a:gd name="connsiteY7" fmla="*/ 939988 h 1227832"/>
              <a:gd name="connsiteX8" fmla="*/ 4906003 w 5950945"/>
              <a:gd name="connsiteY8" fmla="*/ 1226948 h 1227832"/>
              <a:gd name="connsiteX9" fmla="*/ 2882129 w 5950945"/>
              <a:gd name="connsiteY9" fmla="*/ 1011509 h 1227832"/>
              <a:gd name="connsiteX10" fmla="*/ 1888593 w 5950945"/>
              <a:gd name="connsiteY10" fmla="*/ 762347 h 1227832"/>
              <a:gd name="connsiteX11" fmla="*/ 1454757 w 5950945"/>
              <a:gd name="connsiteY11" fmla="*/ 747551 h 1227832"/>
              <a:gd name="connsiteX12" fmla="*/ 1032576 w 5950945"/>
              <a:gd name="connsiteY12" fmla="*/ 786620 h 1227832"/>
              <a:gd name="connsiteX13" fmla="*/ 37705 w 5950945"/>
              <a:gd name="connsiteY13" fmla="*/ 579730 h 1227832"/>
              <a:gd name="connsiteX0" fmla="*/ 37705 w 5950945"/>
              <a:gd name="connsiteY0" fmla="*/ 573964 h 1222066"/>
              <a:gd name="connsiteX1" fmla="*/ 284295 w 5950945"/>
              <a:gd name="connsiteY1" fmla="*/ 353886 h 1222066"/>
              <a:gd name="connsiteX2" fmla="*/ 827422 w 5950945"/>
              <a:gd name="connsiteY2" fmla="*/ 517948 h 1222066"/>
              <a:gd name="connsiteX3" fmla="*/ 1566677 w 5950945"/>
              <a:gd name="connsiteY3" fmla="*/ 402324 h 1222066"/>
              <a:gd name="connsiteX4" fmla="*/ 2372856 w 5950945"/>
              <a:gd name="connsiteY4" fmla="*/ 92045 h 1222066"/>
              <a:gd name="connsiteX5" fmla="*/ 3623720 w 5950945"/>
              <a:gd name="connsiteY5" fmla="*/ 15638 h 1222066"/>
              <a:gd name="connsiteX6" fmla="*/ 5690770 w 5950945"/>
              <a:gd name="connsiteY6" fmla="*/ 355339 h 1222066"/>
              <a:gd name="connsiteX7" fmla="*/ 5835532 w 5950945"/>
              <a:gd name="connsiteY7" fmla="*/ 934222 h 1222066"/>
              <a:gd name="connsiteX8" fmla="*/ 4906003 w 5950945"/>
              <a:gd name="connsiteY8" fmla="*/ 1221182 h 1222066"/>
              <a:gd name="connsiteX9" fmla="*/ 2882129 w 5950945"/>
              <a:gd name="connsiteY9" fmla="*/ 1005743 h 1222066"/>
              <a:gd name="connsiteX10" fmla="*/ 1888593 w 5950945"/>
              <a:gd name="connsiteY10" fmla="*/ 756581 h 1222066"/>
              <a:gd name="connsiteX11" fmla="*/ 1454757 w 5950945"/>
              <a:gd name="connsiteY11" fmla="*/ 741785 h 1222066"/>
              <a:gd name="connsiteX12" fmla="*/ 1032576 w 5950945"/>
              <a:gd name="connsiteY12" fmla="*/ 780854 h 1222066"/>
              <a:gd name="connsiteX13" fmla="*/ 37705 w 5950945"/>
              <a:gd name="connsiteY13" fmla="*/ 573964 h 1222066"/>
              <a:gd name="connsiteX0" fmla="*/ 37705 w 5950945"/>
              <a:gd name="connsiteY0" fmla="*/ 573106 h 1221208"/>
              <a:gd name="connsiteX1" fmla="*/ 284295 w 5950945"/>
              <a:gd name="connsiteY1" fmla="*/ 353028 h 1221208"/>
              <a:gd name="connsiteX2" fmla="*/ 827422 w 5950945"/>
              <a:gd name="connsiteY2" fmla="*/ 517090 h 1221208"/>
              <a:gd name="connsiteX3" fmla="*/ 1548461 w 5950945"/>
              <a:gd name="connsiteY3" fmla="*/ 362739 h 1221208"/>
              <a:gd name="connsiteX4" fmla="*/ 2372856 w 5950945"/>
              <a:gd name="connsiteY4" fmla="*/ 91187 h 1221208"/>
              <a:gd name="connsiteX5" fmla="*/ 3623720 w 5950945"/>
              <a:gd name="connsiteY5" fmla="*/ 14780 h 1221208"/>
              <a:gd name="connsiteX6" fmla="*/ 5690770 w 5950945"/>
              <a:gd name="connsiteY6" fmla="*/ 354481 h 1221208"/>
              <a:gd name="connsiteX7" fmla="*/ 5835532 w 5950945"/>
              <a:gd name="connsiteY7" fmla="*/ 933364 h 1221208"/>
              <a:gd name="connsiteX8" fmla="*/ 4906003 w 5950945"/>
              <a:gd name="connsiteY8" fmla="*/ 1220324 h 1221208"/>
              <a:gd name="connsiteX9" fmla="*/ 2882129 w 5950945"/>
              <a:gd name="connsiteY9" fmla="*/ 1004885 h 1221208"/>
              <a:gd name="connsiteX10" fmla="*/ 1888593 w 5950945"/>
              <a:gd name="connsiteY10" fmla="*/ 755723 h 1221208"/>
              <a:gd name="connsiteX11" fmla="*/ 1454757 w 5950945"/>
              <a:gd name="connsiteY11" fmla="*/ 740927 h 1221208"/>
              <a:gd name="connsiteX12" fmla="*/ 1032576 w 5950945"/>
              <a:gd name="connsiteY12" fmla="*/ 779996 h 1221208"/>
              <a:gd name="connsiteX13" fmla="*/ 37705 w 5950945"/>
              <a:gd name="connsiteY13" fmla="*/ 573106 h 1221208"/>
              <a:gd name="connsiteX0" fmla="*/ 38308 w 5951548"/>
              <a:gd name="connsiteY0" fmla="*/ 573106 h 1221208"/>
              <a:gd name="connsiteX1" fmla="*/ 281588 w 5951548"/>
              <a:gd name="connsiteY1" fmla="*/ 376599 h 1221208"/>
              <a:gd name="connsiteX2" fmla="*/ 828025 w 5951548"/>
              <a:gd name="connsiteY2" fmla="*/ 517090 h 1221208"/>
              <a:gd name="connsiteX3" fmla="*/ 1549064 w 5951548"/>
              <a:gd name="connsiteY3" fmla="*/ 362739 h 1221208"/>
              <a:gd name="connsiteX4" fmla="*/ 2373459 w 5951548"/>
              <a:gd name="connsiteY4" fmla="*/ 91187 h 1221208"/>
              <a:gd name="connsiteX5" fmla="*/ 3624323 w 5951548"/>
              <a:gd name="connsiteY5" fmla="*/ 14780 h 1221208"/>
              <a:gd name="connsiteX6" fmla="*/ 5691373 w 5951548"/>
              <a:gd name="connsiteY6" fmla="*/ 354481 h 1221208"/>
              <a:gd name="connsiteX7" fmla="*/ 5836135 w 5951548"/>
              <a:gd name="connsiteY7" fmla="*/ 933364 h 1221208"/>
              <a:gd name="connsiteX8" fmla="*/ 4906606 w 5951548"/>
              <a:gd name="connsiteY8" fmla="*/ 1220324 h 1221208"/>
              <a:gd name="connsiteX9" fmla="*/ 2882732 w 5951548"/>
              <a:gd name="connsiteY9" fmla="*/ 1004885 h 1221208"/>
              <a:gd name="connsiteX10" fmla="*/ 1889196 w 5951548"/>
              <a:gd name="connsiteY10" fmla="*/ 755723 h 1221208"/>
              <a:gd name="connsiteX11" fmla="*/ 1455360 w 5951548"/>
              <a:gd name="connsiteY11" fmla="*/ 740927 h 1221208"/>
              <a:gd name="connsiteX12" fmla="*/ 1033179 w 5951548"/>
              <a:gd name="connsiteY12" fmla="*/ 779996 h 1221208"/>
              <a:gd name="connsiteX13" fmla="*/ 38308 w 5951548"/>
              <a:gd name="connsiteY13" fmla="*/ 573106 h 1221208"/>
              <a:gd name="connsiteX0" fmla="*/ 35102 w 5948342"/>
              <a:gd name="connsiteY0" fmla="*/ 573106 h 1221208"/>
              <a:gd name="connsiteX1" fmla="*/ 278382 w 5948342"/>
              <a:gd name="connsiteY1" fmla="*/ 376599 h 1221208"/>
              <a:gd name="connsiteX2" fmla="*/ 803296 w 5948342"/>
              <a:gd name="connsiteY2" fmla="*/ 586128 h 1221208"/>
              <a:gd name="connsiteX3" fmla="*/ 1545858 w 5948342"/>
              <a:gd name="connsiteY3" fmla="*/ 362739 h 1221208"/>
              <a:gd name="connsiteX4" fmla="*/ 2370253 w 5948342"/>
              <a:gd name="connsiteY4" fmla="*/ 91187 h 1221208"/>
              <a:gd name="connsiteX5" fmla="*/ 3621117 w 5948342"/>
              <a:gd name="connsiteY5" fmla="*/ 14780 h 1221208"/>
              <a:gd name="connsiteX6" fmla="*/ 5688167 w 5948342"/>
              <a:gd name="connsiteY6" fmla="*/ 354481 h 1221208"/>
              <a:gd name="connsiteX7" fmla="*/ 5832929 w 5948342"/>
              <a:gd name="connsiteY7" fmla="*/ 933364 h 1221208"/>
              <a:gd name="connsiteX8" fmla="*/ 4903400 w 5948342"/>
              <a:gd name="connsiteY8" fmla="*/ 1220324 h 1221208"/>
              <a:gd name="connsiteX9" fmla="*/ 2879526 w 5948342"/>
              <a:gd name="connsiteY9" fmla="*/ 1004885 h 1221208"/>
              <a:gd name="connsiteX10" fmla="*/ 1885990 w 5948342"/>
              <a:gd name="connsiteY10" fmla="*/ 755723 h 1221208"/>
              <a:gd name="connsiteX11" fmla="*/ 1452154 w 5948342"/>
              <a:gd name="connsiteY11" fmla="*/ 740927 h 1221208"/>
              <a:gd name="connsiteX12" fmla="*/ 1029973 w 5948342"/>
              <a:gd name="connsiteY12" fmla="*/ 779996 h 1221208"/>
              <a:gd name="connsiteX13" fmla="*/ 35102 w 5948342"/>
              <a:gd name="connsiteY13" fmla="*/ 573106 h 1221208"/>
              <a:gd name="connsiteX0" fmla="*/ 27268 w 5940508"/>
              <a:gd name="connsiteY0" fmla="*/ 573106 h 1221208"/>
              <a:gd name="connsiteX1" fmla="*/ 270548 w 5940508"/>
              <a:gd name="connsiteY1" fmla="*/ 376599 h 1221208"/>
              <a:gd name="connsiteX2" fmla="*/ 795462 w 5940508"/>
              <a:gd name="connsiteY2" fmla="*/ 586128 h 1221208"/>
              <a:gd name="connsiteX3" fmla="*/ 1538024 w 5940508"/>
              <a:gd name="connsiteY3" fmla="*/ 362739 h 1221208"/>
              <a:gd name="connsiteX4" fmla="*/ 2362419 w 5940508"/>
              <a:gd name="connsiteY4" fmla="*/ 91187 h 1221208"/>
              <a:gd name="connsiteX5" fmla="*/ 3613283 w 5940508"/>
              <a:gd name="connsiteY5" fmla="*/ 14780 h 1221208"/>
              <a:gd name="connsiteX6" fmla="*/ 5680333 w 5940508"/>
              <a:gd name="connsiteY6" fmla="*/ 354481 h 1221208"/>
              <a:gd name="connsiteX7" fmla="*/ 5825095 w 5940508"/>
              <a:gd name="connsiteY7" fmla="*/ 933364 h 1221208"/>
              <a:gd name="connsiteX8" fmla="*/ 4895566 w 5940508"/>
              <a:gd name="connsiteY8" fmla="*/ 1220324 h 1221208"/>
              <a:gd name="connsiteX9" fmla="*/ 2871692 w 5940508"/>
              <a:gd name="connsiteY9" fmla="*/ 1004885 h 1221208"/>
              <a:gd name="connsiteX10" fmla="*/ 1878156 w 5940508"/>
              <a:gd name="connsiteY10" fmla="*/ 755723 h 1221208"/>
              <a:gd name="connsiteX11" fmla="*/ 1444320 w 5940508"/>
              <a:gd name="connsiteY11" fmla="*/ 740927 h 1221208"/>
              <a:gd name="connsiteX12" fmla="*/ 896293 w 5940508"/>
              <a:gd name="connsiteY12" fmla="*/ 749692 h 1221208"/>
              <a:gd name="connsiteX13" fmla="*/ 27268 w 5940508"/>
              <a:gd name="connsiteY13" fmla="*/ 573106 h 1221208"/>
              <a:gd name="connsiteX0" fmla="*/ 27268 w 5940508"/>
              <a:gd name="connsiteY0" fmla="*/ 573106 h 1220958"/>
              <a:gd name="connsiteX1" fmla="*/ 270548 w 5940508"/>
              <a:gd name="connsiteY1" fmla="*/ 376599 h 1220958"/>
              <a:gd name="connsiteX2" fmla="*/ 795462 w 5940508"/>
              <a:gd name="connsiteY2" fmla="*/ 586128 h 1220958"/>
              <a:gd name="connsiteX3" fmla="*/ 1538024 w 5940508"/>
              <a:gd name="connsiteY3" fmla="*/ 362739 h 1220958"/>
              <a:gd name="connsiteX4" fmla="*/ 2362419 w 5940508"/>
              <a:gd name="connsiteY4" fmla="*/ 91187 h 1220958"/>
              <a:gd name="connsiteX5" fmla="*/ 3613283 w 5940508"/>
              <a:gd name="connsiteY5" fmla="*/ 14780 h 1220958"/>
              <a:gd name="connsiteX6" fmla="*/ 5680333 w 5940508"/>
              <a:gd name="connsiteY6" fmla="*/ 354481 h 1220958"/>
              <a:gd name="connsiteX7" fmla="*/ 5825095 w 5940508"/>
              <a:gd name="connsiteY7" fmla="*/ 933364 h 1220958"/>
              <a:gd name="connsiteX8" fmla="*/ 4895566 w 5940508"/>
              <a:gd name="connsiteY8" fmla="*/ 1220324 h 1220958"/>
              <a:gd name="connsiteX9" fmla="*/ 2871692 w 5940508"/>
              <a:gd name="connsiteY9" fmla="*/ 1004885 h 1220958"/>
              <a:gd name="connsiteX10" fmla="*/ 1943177 w 5940508"/>
              <a:gd name="connsiteY10" fmla="*/ 810320 h 1220958"/>
              <a:gd name="connsiteX11" fmla="*/ 1878156 w 5940508"/>
              <a:gd name="connsiteY11" fmla="*/ 755723 h 1220958"/>
              <a:gd name="connsiteX12" fmla="*/ 1444320 w 5940508"/>
              <a:gd name="connsiteY12" fmla="*/ 740927 h 1220958"/>
              <a:gd name="connsiteX13" fmla="*/ 896293 w 5940508"/>
              <a:gd name="connsiteY13" fmla="*/ 749692 h 1220958"/>
              <a:gd name="connsiteX14" fmla="*/ 27268 w 5940508"/>
              <a:gd name="connsiteY14" fmla="*/ 573106 h 1220958"/>
              <a:gd name="connsiteX0" fmla="*/ 27268 w 5940508"/>
              <a:gd name="connsiteY0" fmla="*/ 573106 h 1220958"/>
              <a:gd name="connsiteX1" fmla="*/ 270548 w 5940508"/>
              <a:gd name="connsiteY1" fmla="*/ 376599 h 1220958"/>
              <a:gd name="connsiteX2" fmla="*/ 795462 w 5940508"/>
              <a:gd name="connsiteY2" fmla="*/ 586128 h 1220958"/>
              <a:gd name="connsiteX3" fmla="*/ 1538024 w 5940508"/>
              <a:gd name="connsiteY3" fmla="*/ 362739 h 1220958"/>
              <a:gd name="connsiteX4" fmla="*/ 2362419 w 5940508"/>
              <a:gd name="connsiteY4" fmla="*/ 91187 h 1220958"/>
              <a:gd name="connsiteX5" fmla="*/ 3613283 w 5940508"/>
              <a:gd name="connsiteY5" fmla="*/ 14780 h 1220958"/>
              <a:gd name="connsiteX6" fmla="*/ 5680333 w 5940508"/>
              <a:gd name="connsiteY6" fmla="*/ 354481 h 1220958"/>
              <a:gd name="connsiteX7" fmla="*/ 5825095 w 5940508"/>
              <a:gd name="connsiteY7" fmla="*/ 933364 h 1220958"/>
              <a:gd name="connsiteX8" fmla="*/ 4895566 w 5940508"/>
              <a:gd name="connsiteY8" fmla="*/ 1220324 h 1220958"/>
              <a:gd name="connsiteX9" fmla="*/ 2871692 w 5940508"/>
              <a:gd name="connsiteY9" fmla="*/ 1004885 h 1220958"/>
              <a:gd name="connsiteX10" fmla="*/ 1943177 w 5940508"/>
              <a:gd name="connsiteY10" fmla="*/ 810320 h 1220958"/>
              <a:gd name="connsiteX11" fmla="*/ 1444320 w 5940508"/>
              <a:gd name="connsiteY11" fmla="*/ 740927 h 1220958"/>
              <a:gd name="connsiteX12" fmla="*/ 896293 w 5940508"/>
              <a:gd name="connsiteY12" fmla="*/ 749692 h 1220958"/>
              <a:gd name="connsiteX13" fmla="*/ 27268 w 5940508"/>
              <a:gd name="connsiteY13" fmla="*/ 573106 h 1220958"/>
              <a:gd name="connsiteX0" fmla="*/ 27268 w 5940508"/>
              <a:gd name="connsiteY0" fmla="*/ 573106 h 1220905"/>
              <a:gd name="connsiteX1" fmla="*/ 270548 w 5940508"/>
              <a:gd name="connsiteY1" fmla="*/ 376599 h 1220905"/>
              <a:gd name="connsiteX2" fmla="*/ 795462 w 5940508"/>
              <a:gd name="connsiteY2" fmla="*/ 586128 h 1220905"/>
              <a:gd name="connsiteX3" fmla="*/ 1538024 w 5940508"/>
              <a:gd name="connsiteY3" fmla="*/ 362739 h 1220905"/>
              <a:gd name="connsiteX4" fmla="*/ 2362419 w 5940508"/>
              <a:gd name="connsiteY4" fmla="*/ 91187 h 1220905"/>
              <a:gd name="connsiteX5" fmla="*/ 3613283 w 5940508"/>
              <a:gd name="connsiteY5" fmla="*/ 14780 h 1220905"/>
              <a:gd name="connsiteX6" fmla="*/ 5680333 w 5940508"/>
              <a:gd name="connsiteY6" fmla="*/ 354481 h 1220905"/>
              <a:gd name="connsiteX7" fmla="*/ 5825095 w 5940508"/>
              <a:gd name="connsiteY7" fmla="*/ 933364 h 1220905"/>
              <a:gd name="connsiteX8" fmla="*/ 4895566 w 5940508"/>
              <a:gd name="connsiteY8" fmla="*/ 1220324 h 1220905"/>
              <a:gd name="connsiteX9" fmla="*/ 2871692 w 5940508"/>
              <a:gd name="connsiteY9" fmla="*/ 1004885 h 1220905"/>
              <a:gd name="connsiteX10" fmla="*/ 2261106 w 5940508"/>
              <a:gd name="connsiteY10" fmla="*/ 904600 h 1220905"/>
              <a:gd name="connsiteX11" fmla="*/ 1444320 w 5940508"/>
              <a:gd name="connsiteY11" fmla="*/ 740927 h 1220905"/>
              <a:gd name="connsiteX12" fmla="*/ 896293 w 5940508"/>
              <a:gd name="connsiteY12" fmla="*/ 749692 h 1220905"/>
              <a:gd name="connsiteX13" fmla="*/ 27268 w 5940508"/>
              <a:gd name="connsiteY13" fmla="*/ 573106 h 1220905"/>
              <a:gd name="connsiteX0" fmla="*/ 27268 w 5940508"/>
              <a:gd name="connsiteY0" fmla="*/ 573106 h 1220437"/>
              <a:gd name="connsiteX1" fmla="*/ 270548 w 5940508"/>
              <a:gd name="connsiteY1" fmla="*/ 376599 h 1220437"/>
              <a:gd name="connsiteX2" fmla="*/ 795462 w 5940508"/>
              <a:gd name="connsiteY2" fmla="*/ 586128 h 1220437"/>
              <a:gd name="connsiteX3" fmla="*/ 1538024 w 5940508"/>
              <a:gd name="connsiteY3" fmla="*/ 362739 h 1220437"/>
              <a:gd name="connsiteX4" fmla="*/ 2362419 w 5940508"/>
              <a:gd name="connsiteY4" fmla="*/ 91187 h 1220437"/>
              <a:gd name="connsiteX5" fmla="*/ 3613283 w 5940508"/>
              <a:gd name="connsiteY5" fmla="*/ 14780 h 1220437"/>
              <a:gd name="connsiteX6" fmla="*/ 5680333 w 5940508"/>
              <a:gd name="connsiteY6" fmla="*/ 354481 h 1220437"/>
              <a:gd name="connsiteX7" fmla="*/ 5825095 w 5940508"/>
              <a:gd name="connsiteY7" fmla="*/ 933364 h 1220437"/>
              <a:gd name="connsiteX8" fmla="*/ 4895566 w 5940508"/>
              <a:gd name="connsiteY8" fmla="*/ 1220324 h 1220437"/>
              <a:gd name="connsiteX9" fmla="*/ 2261106 w 5940508"/>
              <a:gd name="connsiteY9" fmla="*/ 904600 h 1220437"/>
              <a:gd name="connsiteX10" fmla="*/ 1444320 w 5940508"/>
              <a:gd name="connsiteY10" fmla="*/ 740927 h 1220437"/>
              <a:gd name="connsiteX11" fmla="*/ 896293 w 5940508"/>
              <a:gd name="connsiteY11" fmla="*/ 749692 h 1220437"/>
              <a:gd name="connsiteX12" fmla="*/ 27268 w 5940508"/>
              <a:gd name="connsiteY12" fmla="*/ 573106 h 1220437"/>
              <a:gd name="connsiteX0" fmla="*/ 27268 w 5968308"/>
              <a:gd name="connsiteY0" fmla="*/ 573106 h 963464"/>
              <a:gd name="connsiteX1" fmla="*/ 270548 w 5968308"/>
              <a:gd name="connsiteY1" fmla="*/ 376599 h 963464"/>
              <a:gd name="connsiteX2" fmla="*/ 795462 w 5968308"/>
              <a:gd name="connsiteY2" fmla="*/ 586128 h 963464"/>
              <a:gd name="connsiteX3" fmla="*/ 1538024 w 5968308"/>
              <a:gd name="connsiteY3" fmla="*/ 362739 h 963464"/>
              <a:gd name="connsiteX4" fmla="*/ 2362419 w 5968308"/>
              <a:gd name="connsiteY4" fmla="*/ 91187 h 963464"/>
              <a:gd name="connsiteX5" fmla="*/ 3613283 w 5968308"/>
              <a:gd name="connsiteY5" fmla="*/ 14780 h 963464"/>
              <a:gd name="connsiteX6" fmla="*/ 5680333 w 5968308"/>
              <a:gd name="connsiteY6" fmla="*/ 354481 h 963464"/>
              <a:gd name="connsiteX7" fmla="*/ 5825095 w 5968308"/>
              <a:gd name="connsiteY7" fmla="*/ 933364 h 963464"/>
              <a:gd name="connsiteX8" fmla="*/ 4481591 w 5968308"/>
              <a:gd name="connsiteY8" fmla="*/ 883581 h 963464"/>
              <a:gd name="connsiteX9" fmla="*/ 2261106 w 5968308"/>
              <a:gd name="connsiteY9" fmla="*/ 904600 h 963464"/>
              <a:gd name="connsiteX10" fmla="*/ 1444320 w 5968308"/>
              <a:gd name="connsiteY10" fmla="*/ 740927 h 963464"/>
              <a:gd name="connsiteX11" fmla="*/ 896293 w 5968308"/>
              <a:gd name="connsiteY11" fmla="*/ 749692 h 963464"/>
              <a:gd name="connsiteX12" fmla="*/ 27268 w 5968308"/>
              <a:gd name="connsiteY12" fmla="*/ 573106 h 963464"/>
              <a:gd name="connsiteX0" fmla="*/ 27268 w 5968308"/>
              <a:gd name="connsiteY0" fmla="*/ 593055 h 983413"/>
              <a:gd name="connsiteX1" fmla="*/ 270548 w 5968308"/>
              <a:gd name="connsiteY1" fmla="*/ 396548 h 983413"/>
              <a:gd name="connsiteX2" fmla="*/ 795462 w 5968308"/>
              <a:gd name="connsiteY2" fmla="*/ 606077 h 983413"/>
              <a:gd name="connsiteX3" fmla="*/ 1538024 w 5968308"/>
              <a:gd name="connsiteY3" fmla="*/ 382688 h 983413"/>
              <a:gd name="connsiteX4" fmla="*/ 2441897 w 5968308"/>
              <a:gd name="connsiteY4" fmla="*/ 50517 h 983413"/>
              <a:gd name="connsiteX5" fmla="*/ 3613283 w 5968308"/>
              <a:gd name="connsiteY5" fmla="*/ 34729 h 983413"/>
              <a:gd name="connsiteX6" fmla="*/ 5680333 w 5968308"/>
              <a:gd name="connsiteY6" fmla="*/ 374430 h 983413"/>
              <a:gd name="connsiteX7" fmla="*/ 5825095 w 5968308"/>
              <a:gd name="connsiteY7" fmla="*/ 953313 h 983413"/>
              <a:gd name="connsiteX8" fmla="*/ 4481591 w 5968308"/>
              <a:gd name="connsiteY8" fmla="*/ 903530 h 983413"/>
              <a:gd name="connsiteX9" fmla="*/ 2261106 w 5968308"/>
              <a:gd name="connsiteY9" fmla="*/ 924549 h 983413"/>
              <a:gd name="connsiteX10" fmla="*/ 1444320 w 5968308"/>
              <a:gd name="connsiteY10" fmla="*/ 760876 h 983413"/>
              <a:gd name="connsiteX11" fmla="*/ 896293 w 5968308"/>
              <a:gd name="connsiteY11" fmla="*/ 769641 h 983413"/>
              <a:gd name="connsiteX12" fmla="*/ 27268 w 5968308"/>
              <a:gd name="connsiteY12" fmla="*/ 593055 h 983413"/>
              <a:gd name="connsiteX0" fmla="*/ 27268 w 5968308"/>
              <a:gd name="connsiteY0" fmla="*/ 716757 h 1107115"/>
              <a:gd name="connsiteX1" fmla="*/ 270548 w 5968308"/>
              <a:gd name="connsiteY1" fmla="*/ 520250 h 1107115"/>
              <a:gd name="connsiteX2" fmla="*/ 795462 w 5968308"/>
              <a:gd name="connsiteY2" fmla="*/ 729779 h 1107115"/>
              <a:gd name="connsiteX3" fmla="*/ 1538024 w 5968308"/>
              <a:gd name="connsiteY3" fmla="*/ 506390 h 1107115"/>
              <a:gd name="connsiteX4" fmla="*/ 2441897 w 5968308"/>
              <a:gd name="connsiteY4" fmla="*/ 174219 h 1107115"/>
              <a:gd name="connsiteX5" fmla="*/ 3613283 w 5968308"/>
              <a:gd name="connsiteY5" fmla="*/ 158431 h 1107115"/>
              <a:gd name="connsiteX6" fmla="*/ 5680333 w 5968308"/>
              <a:gd name="connsiteY6" fmla="*/ 498132 h 1107115"/>
              <a:gd name="connsiteX7" fmla="*/ 5825095 w 5968308"/>
              <a:gd name="connsiteY7" fmla="*/ 1077015 h 1107115"/>
              <a:gd name="connsiteX8" fmla="*/ 4481591 w 5968308"/>
              <a:gd name="connsiteY8" fmla="*/ 1027232 h 1107115"/>
              <a:gd name="connsiteX9" fmla="*/ 2261106 w 5968308"/>
              <a:gd name="connsiteY9" fmla="*/ 1048251 h 1107115"/>
              <a:gd name="connsiteX10" fmla="*/ 1444320 w 5968308"/>
              <a:gd name="connsiteY10" fmla="*/ 884578 h 1107115"/>
              <a:gd name="connsiteX11" fmla="*/ 896293 w 5968308"/>
              <a:gd name="connsiteY11" fmla="*/ 893343 h 1107115"/>
              <a:gd name="connsiteX12" fmla="*/ 27268 w 5968308"/>
              <a:gd name="connsiteY12" fmla="*/ 716757 h 1107115"/>
              <a:gd name="connsiteX0" fmla="*/ 27268 w 5968856"/>
              <a:gd name="connsiteY0" fmla="*/ 561298 h 951656"/>
              <a:gd name="connsiteX1" fmla="*/ 270548 w 5968856"/>
              <a:gd name="connsiteY1" fmla="*/ 364791 h 951656"/>
              <a:gd name="connsiteX2" fmla="*/ 795462 w 5968856"/>
              <a:gd name="connsiteY2" fmla="*/ 574320 h 951656"/>
              <a:gd name="connsiteX3" fmla="*/ 1538024 w 5968856"/>
              <a:gd name="connsiteY3" fmla="*/ 350931 h 951656"/>
              <a:gd name="connsiteX4" fmla="*/ 2441897 w 5968856"/>
              <a:gd name="connsiteY4" fmla="*/ 18760 h 951656"/>
              <a:gd name="connsiteX5" fmla="*/ 3603352 w 5968856"/>
              <a:gd name="connsiteY5" fmla="*/ 73693 h 951656"/>
              <a:gd name="connsiteX6" fmla="*/ 5680333 w 5968856"/>
              <a:gd name="connsiteY6" fmla="*/ 342673 h 951656"/>
              <a:gd name="connsiteX7" fmla="*/ 5825095 w 5968856"/>
              <a:gd name="connsiteY7" fmla="*/ 921556 h 951656"/>
              <a:gd name="connsiteX8" fmla="*/ 4481591 w 5968856"/>
              <a:gd name="connsiteY8" fmla="*/ 871773 h 951656"/>
              <a:gd name="connsiteX9" fmla="*/ 2261106 w 5968856"/>
              <a:gd name="connsiteY9" fmla="*/ 892792 h 951656"/>
              <a:gd name="connsiteX10" fmla="*/ 1444320 w 5968856"/>
              <a:gd name="connsiteY10" fmla="*/ 729119 h 951656"/>
              <a:gd name="connsiteX11" fmla="*/ 896293 w 5968856"/>
              <a:gd name="connsiteY11" fmla="*/ 737884 h 951656"/>
              <a:gd name="connsiteX12" fmla="*/ 27268 w 5968856"/>
              <a:gd name="connsiteY12" fmla="*/ 561298 h 95165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</a:cxnLst>
            <a:rect l="l" t="t" r="r" b="b"/>
            <a:pathLst>
              <a:path w="5968856" h="951656">
                <a:moveTo>
                  <a:pt x="27268" y="561298"/>
                </a:moveTo>
                <a:cubicBezTo>
                  <a:pt x="-77023" y="499116"/>
                  <a:pt x="142516" y="362621"/>
                  <a:pt x="270548" y="364791"/>
                </a:cubicBezTo>
                <a:cubicBezTo>
                  <a:pt x="398580" y="366961"/>
                  <a:pt x="584216" y="576630"/>
                  <a:pt x="795462" y="574320"/>
                </a:cubicBezTo>
                <a:cubicBezTo>
                  <a:pt x="1006708" y="572010"/>
                  <a:pt x="1263618" y="443524"/>
                  <a:pt x="1538024" y="350931"/>
                </a:cubicBezTo>
                <a:cubicBezTo>
                  <a:pt x="1812430" y="258338"/>
                  <a:pt x="2097676" y="64966"/>
                  <a:pt x="2441897" y="18760"/>
                </a:cubicBezTo>
                <a:cubicBezTo>
                  <a:pt x="2786118" y="-27446"/>
                  <a:pt x="3063613" y="19708"/>
                  <a:pt x="3603352" y="73693"/>
                </a:cubicBezTo>
                <a:cubicBezTo>
                  <a:pt x="4143091" y="127678"/>
                  <a:pt x="5310043" y="201363"/>
                  <a:pt x="5680333" y="342673"/>
                </a:cubicBezTo>
                <a:cubicBezTo>
                  <a:pt x="6050623" y="483983"/>
                  <a:pt x="6024885" y="833373"/>
                  <a:pt x="5825095" y="921556"/>
                </a:cubicBezTo>
                <a:cubicBezTo>
                  <a:pt x="5625305" y="1009739"/>
                  <a:pt x="5075589" y="876567"/>
                  <a:pt x="4481591" y="871773"/>
                </a:cubicBezTo>
                <a:cubicBezTo>
                  <a:pt x="3887593" y="866979"/>
                  <a:pt x="2836314" y="972691"/>
                  <a:pt x="2261106" y="892792"/>
                </a:cubicBezTo>
                <a:cubicBezTo>
                  <a:pt x="2023211" y="848799"/>
                  <a:pt x="1618801" y="739224"/>
                  <a:pt x="1444320" y="729119"/>
                </a:cubicBezTo>
                <a:cubicBezTo>
                  <a:pt x="1269839" y="719014"/>
                  <a:pt x="1132468" y="765854"/>
                  <a:pt x="896293" y="737884"/>
                </a:cubicBezTo>
                <a:cubicBezTo>
                  <a:pt x="660118" y="709914"/>
                  <a:pt x="131559" y="623480"/>
                  <a:pt x="27268" y="561298"/>
                </a:cubicBezTo>
                <a:close/>
              </a:path>
            </a:pathLst>
          </a:custGeom>
          <a:noFill/>
          <a:ln w="6350">
            <a:solidFill>
              <a:srgbClr val="339966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3" name="吹き出し: 線 (枠なし) 2">
            <a:extLst>
              <a:ext uri="{FF2B5EF4-FFF2-40B4-BE49-F238E27FC236}">
                <a16:creationId xmlns:a16="http://schemas.microsoft.com/office/drawing/2014/main" id="{BB23B2EC-BB2C-0A1B-D040-4953A58E75AA}"/>
              </a:ext>
            </a:extLst>
          </p:cNvPr>
          <p:cNvSpPr/>
          <p:nvPr/>
        </p:nvSpPr>
        <p:spPr>
          <a:xfrm>
            <a:off x="7442694" y="3106029"/>
            <a:ext cx="914386" cy="246215"/>
          </a:xfrm>
          <a:prstGeom prst="callout1">
            <a:avLst>
              <a:gd name="adj1" fmla="val 99265"/>
              <a:gd name="adj2" fmla="val 54167"/>
              <a:gd name="adj3" fmla="val 182783"/>
              <a:gd name="adj4" fmla="val 32500"/>
            </a:avLst>
          </a:prstGeom>
          <a:noFill/>
          <a:ln w="635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dirty="0">
                <a:solidFill>
                  <a:srgbClr val="339966"/>
                </a:solidFill>
              </a:rPr>
              <a:t>Actinomyces</a:t>
            </a:r>
            <a:endParaRPr lang="ja-JP" dirty="0">
              <a:solidFill>
                <a:srgbClr val="339966"/>
              </a:solidFill>
            </a:endParaRPr>
          </a:p>
        </p:txBody>
      </p:sp>
      <p:sp>
        <p:nvSpPr>
          <p:cNvPr id="4" name="吹き出し: 線 (枠なし) 3">
            <a:extLst>
              <a:ext uri="{FF2B5EF4-FFF2-40B4-BE49-F238E27FC236}">
                <a16:creationId xmlns:a16="http://schemas.microsoft.com/office/drawing/2014/main" id="{82AC57D2-6D92-ACA5-9B9B-31A4EB481D56}"/>
              </a:ext>
            </a:extLst>
          </p:cNvPr>
          <p:cNvSpPr/>
          <p:nvPr/>
        </p:nvSpPr>
        <p:spPr>
          <a:xfrm>
            <a:off x="5564052" y="2837231"/>
            <a:ext cx="2312851" cy="293087"/>
          </a:xfrm>
          <a:prstGeom prst="callout1">
            <a:avLst>
              <a:gd name="adj1" fmla="val 60581"/>
              <a:gd name="adj2" fmla="val 2075"/>
              <a:gd name="adj3" fmla="val 109281"/>
              <a:gd name="adj4" fmla="val -11250"/>
            </a:avLst>
          </a:prstGeom>
          <a:noFill/>
          <a:ln w="635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dirty="0" err="1">
                <a:solidFill>
                  <a:srgbClr val="00CC99"/>
                </a:solidFill>
              </a:rPr>
              <a:t>Rothia</a:t>
            </a:r>
            <a:r>
              <a:rPr lang="ja-JP" altLang="en-US" dirty="0">
                <a:solidFill>
                  <a:srgbClr val="00CC99"/>
                </a:solidFill>
              </a:rPr>
              <a:t>　</a:t>
            </a:r>
            <a:endParaRPr lang="en-US" altLang="ja-JP" dirty="0">
              <a:solidFill>
                <a:srgbClr val="00CC99"/>
              </a:solidFill>
            </a:endParaRPr>
          </a:p>
        </p:txBody>
      </p:sp>
      <p:sp>
        <p:nvSpPr>
          <p:cNvPr id="5" name="吹き出し: 線 (枠なし) 4">
            <a:extLst>
              <a:ext uri="{FF2B5EF4-FFF2-40B4-BE49-F238E27FC236}">
                <a16:creationId xmlns:a16="http://schemas.microsoft.com/office/drawing/2014/main" id="{82AC57D2-6D92-ACA5-9B9B-31A4EB481D56}"/>
              </a:ext>
            </a:extLst>
          </p:cNvPr>
          <p:cNvSpPr/>
          <p:nvPr/>
        </p:nvSpPr>
        <p:spPr>
          <a:xfrm>
            <a:off x="3739232" y="3693938"/>
            <a:ext cx="914386" cy="246215"/>
          </a:xfrm>
          <a:prstGeom prst="callout1">
            <a:avLst>
              <a:gd name="adj1" fmla="val 60581"/>
              <a:gd name="adj2" fmla="val 7292"/>
              <a:gd name="adj3" fmla="val 126162"/>
              <a:gd name="adj4" fmla="val -7841"/>
            </a:avLst>
          </a:prstGeom>
          <a:noFill/>
          <a:ln w="635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dirty="0" err="1">
                <a:solidFill>
                  <a:srgbClr val="00CC99"/>
                </a:solidFill>
              </a:rPr>
              <a:t>Rothia</a:t>
            </a:r>
            <a:endParaRPr lang="en-US" altLang="ja-JP" dirty="0">
              <a:solidFill>
                <a:srgbClr val="00CC99"/>
              </a:solidFill>
            </a:endParaRPr>
          </a:p>
        </p:txBody>
      </p:sp>
      <p:sp>
        <p:nvSpPr>
          <p:cNvPr id="15" name="吹き出し: 線 (枠なし) 14">
            <a:extLst>
              <a:ext uri="{FF2B5EF4-FFF2-40B4-BE49-F238E27FC236}">
                <a16:creationId xmlns:a16="http://schemas.microsoft.com/office/drawing/2014/main" id="{8F288AF0-DE78-C5B6-AA39-6EF08EE56766}"/>
              </a:ext>
            </a:extLst>
          </p:cNvPr>
          <p:cNvSpPr/>
          <p:nvPr/>
        </p:nvSpPr>
        <p:spPr>
          <a:xfrm>
            <a:off x="5037314" y="4242702"/>
            <a:ext cx="1246459" cy="246215"/>
          </a:xfrm>
          <a:prstGeom prst="callout1">
            <a:avLst>
              <a:gd name="adj1" fmla="val 58117"/>
              <a:gd name="adj2" fmla="val 2830"/>
              <a:gd name="adj3" fmla="val 39998"/>
              <a:gd name="adj4" fmla="val -21617"/>
            </a:avLst>
          </a:prstGeom>
          <a:noFill/>
          <a:ln w="635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dirty="0" err="1">
                <a:solidFill>
                  <a:schemeClr val="bg1">
                    <a:lumMod val="50000"/>
                  </a:schemeClr>
                </a:solidFill>
              </a:rPr>
              <a:t>Lachnospiraceae</a:t>
            </a:r>
            <a:endParaRPr lang="ja-JP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18" name="楕円 17">
            <a:extLst>
              <a:ext uri="{FF2B5EF4-FFF2-40B4-BE49-F238E27FC236}">
                <a16:creationId xmlns:a16="http://schemas.microsoft.com/office/drawing/2014/main" id="{63288FAB-F6F6-4AEC-B47D-B00A9B5BD0BF}"/>
              </a:ext>
            </a:extLst>
          </p:cNvPr>
          <p:cNvSpPr/>
          <p:nvPr/>
        </p:nvSpPr>
        <p:spPr>
          <a:xfrm rot="20887001">
            <a:off x="4396347" y="1204394"/>
            <a:ext cx="980668" cy="736524"/>
          </a:xfrm>
          <a:prstGeom prst="ellipse">
            <a:avLst/>
          </a:prstGeom>
          <a:noFill/>
          <a:ln w="6350">
            <a:solidFill>
              <a:srgbClr val="00CC00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" name="吹き出し: 線 (枠なし) 18">
            <a:extLst>
              <a:ext uri="{FF2B5EF4-FFF2-40B4-BE49-F238E27FC236}">
                <a16:creationId xmlns:a16="http://schemas.microsoft.com/office/drawing/2014/main" id="{C076FA23-0204-D510-97AF-F6A1B46178B7}"/>
              </a:ext>
            </a:extLst>
          </p:cNvPr>
          <p:cNvSpPr/>
          <p:nvPr/>
        </p:nvSpPr>
        <p:spPr>
          <a:xfrm>
            <a:off x="4509218" y="904609"/>
            <a:ext cx="1094809" cy="246215"/>
          </a:xfrm>
          <a:prstGeom prst="callout1">
            <a:avLst>
              <a:gd name="adj1" fmla="val 89492"/>
              <a:gd name="adj2" fmla="val 47573"/>
              <a:gd name="adj3" fmla="val 182783"/>
              <a:gd name="adj4" fmla="val 32500"/>
            </a:avLst>
          </a:prstGeom>
          <a:noFill/>
          <a:ln w="635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dirty="0">
                <a:solidFill>
                  <a:srgbClr val="00CC00"/>
                </a:solidFill>
              </a:rPr>
              <a:t>Streptococcus</a:t>
            </a:r>
            <a:endParaRPr lang="ja-JP" dirty="0">
              <a:solidFill>
                <a:srgbClr val="00CC00"/>
              </a:solidFill>
            </a:endParaRPr>
          </a:p>
        </p:txBody>
      </p:sp>
      <p:sp>
        <p:nvSpPr>
          <p:cNvPr id="20" name="楕円 19">
            <a:extLst>
              <a:ext uri="{FF2B5EF4-FFF2-40B4-BE49-F238E27FC236}">
                <a16:creationId xmlns:a16="http://schemas.microsoft.com/office/drawing/2014/main" id="{B8CE28DB-8E8C-672A-BC87-2BCDD5760AF4}"/>
              </a:ext>
            </a:extLst>
          </p:cNvPr>
          <p:cNvSpPr/>
          <p:nvPr/>
        </p:nvSpPr>
        <p:spPr>
          <a:xfrm rot="19606141">
            <a:off x="2794049" y="2661439"/>
            <a:ext cx="833013" cy="516075"/>
          </a:xfrm>
          <a:prstGeom prst="ellipse">
            <a:avLst/>
          </a:prstGeom>
          <a:noFill/>
          <a:ln w="6350">
            <a:solidFill>
              <a:srgbClr val="43682B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" name="吹き出し: 線 (枠なし) 20">
            <a:extLst>
              <a:ext uri="{FF2B5EF4-FFF2-40B4-BE49-F238E27FC236}">
                <a16:creationId xmlns:a16="http://schemas.microsoft.com/office/drawing/2014/main" id="{4EC8BC66-3697-C367-D40D-EA8C1594ED5A}"/>
              </a:ext>
            </a:extLst>
          </p:cNvPr>
          <p:cNvSpPr/>
          <p:nvPr/>
        </p:nvSpPr>
        <p:spPr>
          <a:xfrm>
            <a:off x="2933880" y="2281882"/>
            <a:ext cx="1135572" cy="246216"/>
          </a:xfrm>
          <a:prstGeom prst="callout1">
            <a:avLst>
              <a:gd name="adj1" fmla="val 99265"/>
              <a:gd name="adj2" fmla="val 39334"/>
              <a:gd name="adj3" fmla="val 182783"/>
              <a:gd name="adj4" fmla="val 32500"/>
            </a:avLst>
          </a:prstGeom>
          <a:noFill/>
          <a:ln w="635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dirty="0" err="1">
                <a:solidFill>
                  <a:srgbClr val="43682B"/>
                </a:solidFill>
              </a:rPr>
              <a:t>Prevotella</a:t>
            </a:r>
            <a:endParaRPr lang="ja-JP" dirty="0">
              <a:solidFill>
                <a:srgbClr val="43682B"/>
              </a:solidFill>
            </a:endParaRPr>
          </a:p>
        </p:txBody>
      </p:sp>
      <p:sp>
        <p:nvSpPr>
          <p:cNvPr id="22" name="吹き出し: 線 (枠なし) 21">
            <a:extLst>
              <a:ext uri="{FF2B5EF4-FFF2-40B4-BE49-F238E27FC236}">
                <a16:creationId xmlns:a16="http://schemas.microsoft.com/office/drawing/2014/main" id="{A21BA464-827C-5756-400D-FB5970D3DDA8}"/>
              </a:ext>
            </a:extLst>
          </p:cNvPr>
          <p:cNvSpPr/>
          <p:nvPr/>
        </p:nvSpPr>
        <p:spPr>
          <a:xfrm>
            <a:off x="1924786" y="2806741"/>
            <a:ext cx="1094896" cy="246216"/>
          </a:xfrm>
          <a:prstGeom prst="callout1">
            <a:avLst>
              <a:gd name="adj1" fmla="val 88389"/>
              <a:gd name="adj2" fmla="val 59875"/>
              <a:gd name="adj3" fmla="val 179323"/>
              <a:gd name="adj4" fmla="val 69289"/>
            </a:avLst>
          </a:prstGeom>
          <a:noFill/>
          <a:ln w="635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dirty="0">
                <a:solidFill>
                  <a:srgbClr val="00CC00"/>
                </a:solidFill>
              </a:rPr>
              <a:t>Streptococcus</a:t>
            </a:r>
            <a:endParaRPr lang="ja-JP" dirty="0">
              <a:solidFill>
                <a:srgbClr val="00CC00"/>
              </a:solidFill>
            </a:endParaRPr>
          </a:p>
        </p:txBody>
      </p:sp>
      <p:cxnSp>
        <p:nvCxnSpPr>
          <p:cNvPr id="23" name="直線コネクタ 22">
            <a:extLst>
              <a:ext uri="{FF2B5EF4-FFF2-40B4-BE49-F238E27FC236}">
                <a16:creationId xmlns:a16="http://schemas.microsoft.com/office/drawing/2014/main" id="{C44A093A-35B5-E0E2-2AE9-C672FF2FCE75}"/>
              </a:ext>
            </a:extLst>
          </p:cNvPr>
          <p:cNvCxnSpPr>
            <a:cxnSpLocks/>
          </p:cNvCxnSpPr>
          <p:nvPr/>
        </p:nvCxnSpPr>
        <p:spPr>
          <a:xfrm flipH="1" flipV="1">
            <a:off x="2277301" y="3258118"/>
            <a:ext cx="253917" cy="246064"/>
          </a:xfrm>
          <a:prstGeom prst="line">
            <a:avLst/>
          </a:prstGeom>
          <a:ln w="63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吹き出し: 線 (枠なし) 23">
            <a:extLst>
              <a:ext uri="{FF2B5EF4-FFF2-40B4-BE49-F238E27FC236}">
                <a16:creationId xmlns:a16="http://schemas.microsoft.com/office/drawing/2014/main" id="{E54AE5C7-32F5-97FE-CA13-71675D49057E}"/>
              </a:ext>
            </a:extLst>
          </p:cNvPr>
          <p:cNvSpPr/>
          <p:nvPr/>
        </p:nvSpPr>
        <p:spPr>
          <a:xfrm>
            <a:off x="1898501" y="3050728"/>
            <a:ext cx="1010070" cy="246216"/>
          </a:xfrm>
          <a:prstGeom prst="callout1">
            <a:avLst>
              <a:gd name="adj1" fmla="val 99265"/>
              <a:gd name="adj2" fmla="val 54167"/>
              <a:gd name="adj3" fmla="val 139527"/>
              <a:gd name="adj4" fmla="val 74496"/>
            </a:avLst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dirty="0" err="1">
                <a:solidFill>
                  <a:srgbClr val="43682B"/>
                </a:solidFill>
              </a:rPr>
              <a:t>Prevotella</a:t>
            </a:r>
            <a:endParaRPr lang="ja-JP" dirty="0">
              <a:solidFill>
                <a:srgbClr val="43682B"/>
              </a:solidFill>
            </a:endParaRPr>
          </a:p>
        </p:txBody>
      </p:sp>
      <p:sp>
        <p:nvSpPr>
          <p:cNvPr id="27" name="吹き出し: 線 (枠なし) 26">
            <a:extLst>
              <a:ext uri="{FF2B5EF4-FFF2-40B4-BE49-F238E27FC236}">
                <a16:creationId xmlns:a16="http://schemas.microsoft.com/office/drawing/2014/main" id="{69044884-3A17-DDE4-4D48-E47E825C9205}"/>
              </a:ext>
            </a:extLst>
          </p:cNvPr>
          <p:cNvSpPr/>
          <p:nvPr/>
        </p:nvSpPr>
        <p:spPr>
          <a:xfrm>
            <a:off x="2709349" y="3286552"/>
            <a:ext cx="914387" cy="246216"/>
          </a:xfrm>
          <a:prstGeom prst="callout1">
            <a:avLst>
              <a:gd name="adj1" fmla="val 74427"/>
              <a:gd name="adj2" fmla="val 4935"/>
              <a:gd name="adj3" fmla="val 96250"/>
              <a:gd name="adj4" fmla="val -15855"/>
            </a:avLst>
          </a:prstGeom>
          <a:noFill/>
          <a:ln w="635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dirty="0" err="1">
                <a:solidFill>
                  <a:srgbClr val="00CC99"/>
                </a:solidFill>
              </a:rPr>
              <a:t>Rothia</a:t>
            </a:r>
            <a:endParaRPr lang="ja-JP" dirty="0">
              <a:solidFill>
                <a:srgbClr val="00CC99"/>
              </a:solidFill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47751140-143A-46E8-B7DD-B39E0484CF7F}"/>
              </a:ext>
            </a:extLst>
          </p:cNvPr>
          <p:cNvSpPr txBox="1"/>
          <p:nvPr/>
        </p:nvSpPr>
        <p:spPr bwMode="auto">
          <a:xfrm rot="16200000">
            <a:off x="1234697" y="68484"/>
            <a:ext cx="401587" cy="3119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Arial" pitchFamily="34" charset="0"/>
                <a:cs typeface="Arial" pitchFamily="34" charset="0"/>
              </a:rPr>
              <a:t>%</a:t>
            </a:r>
            <a:endParaRPr kumimoji="1" lang="ja-JP" altLang="en-US" sz="1600" dirty="0" err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057DA354-EF05-72F8-1B53-95CE71EBF67F}"/>
              </a:ext>
            </a:extLst>
          </p:cNvPr>
          <p:cNvSpPr txBox="1"/>
          <p:nvPr/>
        </p:nvSpPr>
        <p:spPr bwMode="auto">
          <a:xfrm>
            <a:off x="8659312" y="4535408"/>
            <a:ext cx="398144" cy="31468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Arial" pitchFamily="34" charset="0"/>
                <a:cs typeface="Arial" pitchFamily="34" charset="0"/>
              </a:rPr>
              <a:t>%</a:t>
            </a:r>
            <a:endParaRPr kumimoji="1" lang="ja-JP" altLang="en-US" sz="1600" dirty="0" err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3E4ABD9D-7331-7431-7E3E-9ED1E11F9C0A}"/>
              </a:ext>
            </a:extLst>
          </p:cNvPr>
          <p:cNvSpPr txBox="1"/>
          <p:nvPr/>
        </p:nvSpPr>
        <p:spPr bwMode="auto">
          <a:xfrm>
            <a:off x="4405566" y="4895448"/>
            <a:ext cx="2250086" cy="3432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itchFamily="34" charset="0"/>
                <a:cs typeface="Arial" pitchFamily="34" charset="0"/>
              </a:rPr>
              <a:t>taxonomic abundance</a:t>
            </a:r>
            <a:endParaRPr kumimoji="1" lang="ja-JP" altLang="en-US" dirty="0" err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2CB19C6C-CA85-B1B4-99F4-A229623C13CA}"/>
              </a:ext>
            </a:extLst>
          </p:cNvPr>
          <p:cNvSpPr txBox="1"/>
          <p:nvPr/>
        </p:nvSpPr>
        <p:spPr bwMode="auto">
          <a:xfrm rot="16200000">
            <a:off x="-236231" y="2340371"/>
            <a:ext cx="2221868" cy="34034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rtlCol="0">
            <a:spAutoFit/>
          </a:bodyPr>
          <a:lstStyle/>
          <a:p>
            <a:r>
              <a:rPr lang="en-US" altLang="ja-JP" dirty="0">
                <a:cs typeface="Arial" pitchFamily="34" charset="0"/>
              </a:rPr>
              <a:t>sequence</a:t>
            </a:r>
            <a:r>
              <a:rPr kumimoji="1" lang="en-US" altLang="ja-JP" dirty="0">
                <a:latin typeface="Arial" pitchFamily="34" charset="0"/>
                <a:cs typeface="Arial" pitchFamily="34" charset="0"/>
              </a:rPr>
              <a:t> abundance</a:t>
            </a:r>
            <a:endParaRPr kumimoji="1" lang="ja-JP" altLang="en-US" dirty="0" err="1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17681466-925F-E95F-DA85-3F2978916429}"/>
              </a:ext>
            </a:extLst>
          </p:cNvPr>
          <p:cNvCxnSpPr>
            <a:cxnSpLocks/>
          </p:cNvCxnSpPr>
          <p:nvPr/>
        </p:nvCxnSpPr>
        <p:spPr>
          <a:xfrm flipH="1" flipV="1">
            <a:off x="2277301" y="3258118"/>
            <a:ext cx="265320" cy="133099"/>
          </a:xfrm>
          <a:prstGeom prst="line">
            <a:avLst/>
          </a:prstGeom>
          <a:ln w="63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フリーフォーム: 図形 11">
            <a:extLst>
              <a:ext uri="{FF2B5EF4-FFF2-40B4-BE49-F238E27FC236}">
                <a16:creationId xmlns:a16="http://schemas.microsoft.com/office/drawing/2014/main" id="{AE77D740-879F-533C-6EFC-E2B1DDF37212}"/>
              </a:ext>
            </a:extLst>
          </p:cNvPr>
          <p:cNvSpPr/>
          <p:nvPr/>
        </p:nvSpPr>
        <p:spPr>
          <a:xfrm>
            <a:off x="1866902" y="2945656"/>
            <a:ext cx="647700" cy="577850"/>
          </a:xfrm>
          <a:custGeom>
            <a:avLst/>
            <a:gdLst>
              <a:gd name="connsiteX0" fmla="*/ 127000 w 647700"/>
              <a:gd name="connsiteY0" fmla="*/ 0 h 577850"/>
              <a:gd name="connsiteX1" fmla="*/ 0 w 647700"/>
              <a:gd name="connsiteY1" fmla="*/ 0 h 577850"/>
              <a:gd name="connsiteX2" fmla="*/ 0 w 647700"/>
              <a:gd name="connsiteY2" fmla="*/ 577850 h 577850"/>
              <a:gd name="connsiteX3" fmla="*/ 647700 w 647700"/>
              <a:gd name="connsiteY3" fmla="*/ 577850 h 5778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647700" h="577850">
                <a:moveTo>
                  <a:pt x="127000" y="0"/>
                </a:moveTo>
                <a:lnTo>
                  <a:pt x="0" y="0"/>
                </a:lnTo>
                <a:lnTo>
                  <a:pt x="0" y="577850"/>
                </a:lnTo>
                <a:lnTo>
                  <a:pt x="647700" y="577850"/>
                </a:lnTo>
              </a:path>
            </a:pathLst>
          </a:cu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" name="吹き出し: 線 (枠なし) 5">
            <a:extLst>
              <a:ext uri="{FF2B5EF4-FFF2-40B4-BE49-F238E27FC236}">
                <a16:creationId xmlns:a16="http://schemas.microsoft.com/office/drawing/2014/main" id="{D1E4DF05-2178-AA33-BEB1-4C5F74348177}"/>
              </a:ext>
            </a:extLst>
          </p:cNvPr>
          <p:cNvSpPr/>
          <p:nvPr/>
        </p:nvSpPr>
        <p:spPr>
          <a:xfrm>
            <a:off x="2461098" y="4284190"/>
            <a:ext cx="914386" cy="246215"/>
          </a:xfrm>
          <a:prstGeom prst="callout1">
            <a:avLst>
              <a:gd name="adj1" fmla="val 99265"/>
              <a:gd name="adj2" fmla="val 54167"/>
              <a:gd name="adj3" fmla="val 182783"/>
              <a:gd name="adj4" fmla="val 32500"/>
            </a:avLst>
          </a:prstGeom>
          <a:noFill/>
          <a:ln w="6350"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dirty="0">
                <a:solidFill>
                  <a:srgbClr val="339966"/>
                </a:solidFill>
              </a:rPr>
              <a:t>Actinomyces</a:t>
            </a:r>
            <a:endParaRPr lang="ja-JP" dirty="0">
              <a:solidFill>
                <a:srgbClr val="339966"/>
              </a:solidFill>
            </a:endParaRPr>
          </a:p>
        </p:txBody>
      </p: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EDC5ADEC-E664-53B6-BD5F-5CCD4BD3071D}"/>
              </a:ext>
            </a:extLst>
          </p:cNvPr>
          <p:cNvCxnSpPr>
            <a:cxnSpLocks/>
          </p:cNvCxnSpPr>
          <p:nvPr/>
        </p:nvCxnSpPr>
        <p:spPr>
          <a:xfrm flipV="1">
            <a:off x="2955302" y="4167253"/>
            <a:ext cx="160140" cy="210211"/>
          </a:xfrm>
          <a:prstGeom prst="line">
            <a:avLst/>
          </a:prstGeom>
          <a:ln w="63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0062973B-ECC8-DEBB-6184-2812B9E598A4}"/>
              </a:ext>
            </a:extLst>
          </p:cNvPr>
          <p:cNvSpPr txBox="1"/>
          <p:nvPr/>
        </p:nvSpPr>
        <p:spPr bwMode="auto">
          <a:xfrm>
            <a:off x="1576002" y="6076251"/>
            <a:ext cx="7111883" cy="86177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 Fig. </a:t>
            </a:r>
            <a:r>
              <a:rPr lang="en-US" altLang="ja-JP" sz="18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omparison between the taxonomic and sequence abundance. </a:t>
            </a:r>
          </a:p>
          <a:p>
            <a:r>
              <a:rPr lang="en-US" altLang="ja-JP" sz="18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Genera</a:t>
            </a:r>
            <a:r>
              <a:rPr lang="en-US" altLang="ja-JP" sz="18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howing a difference of more than 10% are highlighted in this plot.</a:t>
            </a:r>
            <a:endParaRPr lang="ja-JP" altLang="ja-JP" sz="1800" dirty="0">
              <a:effectLst/>
              <a:latin typeface="Calibri" panose="020F0502020204030204" pitchFamily="34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endParaRPr kumimoji="1" lang="ja-JP" altLang="en-US" sz="1400" dirty="0" err="1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133295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 bwMode="auto">
        <a:noFill/>
        <a:ln w="9525">
          <a:noFill/>
          <a:miter lim="800000"/>
          <a:headEnd/>
          <a:tailEnd/>
        </a:ln>
      </a:spPr>
      <a:bodyPr wrap="none" rtlCol="0">
        <a:spAutoFit/>
      </a:bodyPr>
      <a:lstStyle>
        <a:defPPr>
          <a:defRPr kumimoji="1" sz="1400" dirty="0" err="1" smtClean="0">
            <a:latin typeface="Arial" pitchFamily="34" charset="0"/>
            <a:cs typeface="Arial" pitchFamily="34" charset="0"/>
          </a:defRPr>
        </a:defPPr>
      </a:lstStyle>
    </a:tx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57</TotalTime>
  <Words>302</Words>
  <Application>Microsoft Office PowerPoint</Application>
  <PresentationFormat>A4 210 x 297 mm</PresentationFormat>
  <Paragraphs>63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K-Yahara</dc:creator>
  <cp:lastModifiedBy>Koji Yahara</cp:lastModifiedBy>
  <cp:revision>80</cp:revision>
  <dcterms:created xsi:type="dcterms:W3CDTF">2010-05-22T07:34:34Z</dcterms:created>
  <dcterms:modified xsi:type="dcterms:W3CDTF">2024-04-17T01:33:06Z</dcterms:modified>
</cp:coreProperties>
</file>